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vml" ContentType="application/vnd.openxmlformats-officedocument.vmlDrawing"/>
  <Default Extension="wdp" ContentType="image/vnd.ms-photo"/>
  <Default Extension="bin" ContentType="application/vnd.openxmlformats-officedocument.oleObject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57" r:id="rId4"/>
    <p:sldId id="258" r:id="rId5"/>
  </p:sldIdLst>
  <p:sldSz cx="9144000" cy="6858000" type="screen4x3"/>
  <p:notesSz cx="6954838" cy="92408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48">
          <p15:clr>
            <a:srgbClr val="A4A3A4"/>
          </p15:clr>
        </p15:guide>
        <p15:guide id="2" pos="230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17"/>
    <p:restoredTop sz="94660"/>
  </p:normalViewPr>
  <p:slideViewPr>
    <p:cSldViewPr showGuides="1">
      <p:cViewPr>
        <p:scale>
          <a:sx n="95" d="100"/>
          <a:sy n="95" d="100"/>
        </p:scale>
        <p:origin x="3720" y="72"/>
      </p:cViewPr>
      <p:guideLst>
        <p:guide orient="horz" pos="2448"/>
        <p:guide pos="230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3086-8B6B-4434-8E32-82F3F8EA621B}" type="datetimeFigureOut">
              <a:rPr lang="en-US" smtClean="0"/>
              <a:t>5/2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B7796-2E0C-46DF-98BF-535132409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519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3086-8B6B-4434-8E32-82F3F8EA621B}" type="datetimeFigureOut">
              <a:rPr lang="en-US" smtClean="0"/>
              <a:t>5/2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B7796-2E0C-46DF-98BF-535132409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744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3086-8B6B-4434-8E32-82F3F8EA621B}" type="datetimeFigureOut">
              <a:rPr lang="en-US" smtClean="0"/>
              <a:t>5/2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B7796-2E0C-46DF-98BF-535132409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491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3086-8B6B-4434-8E32-82F3F8EA621B}" type="datetimeFigureOut">
              <a:rPr lang="en-US" smtClean="0"/>
              <a:t>5/2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B7796-2E0C-46DF-98BF-535132409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661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3086-8B6B-4434-8E32-82F3F8EA621B}" type="datetimeFigureOut">
              <a:rPr lang="en-US" smtClean="0"/>
              <a:t>5/2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B7796-2E0C-46DF-98BF-535132409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374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3086-8B6B-4434-8E32-82F3F8EA621B}" type="datetimeFigureOut">
              <a:rPr lang="en-US" smtClean="0"/>
              <a:t>5/2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B7796-2E0C-46DF-98BF-535132409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590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3086-8B6B-4434-8E32-82F3F8EA621B}" type="datetimeFigureOut">
              <a:rPr lang="en-US" smtClean="0"/>
              <a:t>5/22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B7796-2E0C-46DF-98BF-535132409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908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3086-8B6B-4434-8E32-82F3F8EA621B}" type="datetimeFigureOut">
              <a:rPr lang="en-US" smtClean="0"/>
              <a:t>5/22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B7796-2E0C-46DF-98BF-535132409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997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3086-8B6B-4434-8E32-82F3F8EA621B}" type="datetimeFigureOut">
              <a:rPr lang="en-US" smtClean="0"/>
              <a:t>5/22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B7796-2E0C-46DF-98BF-535132409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244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3086-8B6B-4434-8E32-82F3F8EA621B}" type="datetimeFigureOut">
              <a:rPr lang="en-US" smtClean="0"/>
              <a:t>5/2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B7796-2E0C-46DF-98BF-535132409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223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33086-8B6B-4434-8E32-82F3F8EA621B}" type="datetimeFigureOut">
              <a:rPr lang="en-US" smtClean="0"/>
              <a:t>5/2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B7796-2E0C-46DF-98BF-535132409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841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33086-8B6B-4434-8E32-82F3F8EA621B}" type="datetimeFigureOut">
              <a:rPr lang="en-US" smtClean="0"/>
              <a:t>5/2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7B7796-2E0C-46DF-98BF-535132409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446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oleObject" Target="../embeddings/oleObject1.bin"/><Relationship Id="rId5" Type="http://schemas.openxmlformats.org/officeDocument/2006/relationships/image" Target="../media/image1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4" Type="http://schemas.openxmlformats.org/officeDocument/2006/relationships/image" Target="../media/image5.emf"/><Relationship Id="rId5" Type="http://schemas.openxmlformats.org/officeDocument/2006/relationships/image" Target="../media/image6.emf"/><Relationship Id="rId6" Type="http://schemas.openxmlformats.org/officeDocument/2006/relationships/image" Target="../media/image7.emf"/><Relationship Id="rId7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jpeg"/><Relationship Id="rId3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6889" y="88900"/>
            <a:ext cx="5539712" cy="39669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-58616" y="6320135"/>
            <a:ext cx="9181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urity and integrity of the synthesized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elgi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(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 NMR spectrum of synthetic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elg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Chemical shifts (in ppm) were assigned according to th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ignal of the internal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andar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D</a:t>
            </a:r>
            <a:r>
              <a:rPr lang="en-US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D (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3.31 ppm)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PLC-ESI-TOF MS analysis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elgi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243336" y="889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243336" y="40386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Line 7"/>
          <p:cNvSpPr>
            <a:spLocks noChangeShapeType="1"/>
          </p:cNvSpPr>
          <p:nvPr/>
        </p:nvSpPr>
        <p:spPr bwMode="auto">
          <a:xfrm flipV="1">
            <a:off x="1898650" y="4357688"/>
            <a:ext cx="0" cy="1563688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13" name="Rectangle 9"/>
          <p:cNvSpPr>
            <a:spLocks noChangeArrowheads="1"/>
          </p:cNvSpPr>
          <p:nvPr/>
        </p:nvSpPr>
        <p:spPr bwMode="auto">
          <a:xfrm>
            <a:off x="1676304" y="4179791"/>
            <a:ext cx="20037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x10</a:t>
            </a:r>
            <a:r>
              <a:rPr kumimoji="0" lang="en-US" altLang="en-US" sz="8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6</a:t>
            </a:r>
            <a:endParaRPr kumimoji="0" lang="en-US" altLang="en-US" sz="800" b="0" i="0" u="none" strike="noStrike" cap="none" normalizeH="0" baseline="30000" dirty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14" name="Line 10"/>
          <p:cNvSpPr>
            <a:spLocks noChangeShapeType="1"/>
          </p:cNvSpPr>
          <p:nvPr/>
        </p:nvSpPr>
        <p:spPr bwMode="auto">
          <a:xfrm flipH="1">
            <a:off x="1876425" y="5921375"/>
            <a:ext cx="22225" cy="0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15" name="Rectangle 11"/>
          <p:cNvSpPr>
            <a:spLocks noChangeArrowheads="1"/>
          </p:cNvSpPr>
          <p:nvPr/>
        </p:nvSpPr>
        <p:spPr bwMode="auto">
          <a:xfrm>
            <a:off x="1766459" y="5861168"/>
            <a:ext cx="561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0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16" name="Line 12"/>
          <p:cNvSpPr>
            <a:spLocks noChangeShapeType="1"/>
          </p:cNvSpPr>
          <p:nvPr/>
        </p:nvSpPr>
        <p:spPr bwMode="auto">
          <a:xfrm flipH="1">
            <a:off x="1876425" y="5751513"/>
            <a:ext cx="22225" cy="0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17" name="Rectangle 13"/>
          <p:cNvSpPr>
            <a:spLocks noChangeArrowheads="1"/>
          </p:cNvSpPr>
          <p:nvPr/>
        </p:nvSpPr>
        <p:spPr bwMode="auto">
          <a:xfrm>
            <a:off x="1715659" y="5691306"/>
            <a:ext cx="13305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0.2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18" name="Line 14"/>
          <p:cNvSpPr>
            <a:spLocks noChangeShapeType="1"/>
          </p:cNvSpPr>
          <p:nvPr/>
        </p:nvSpPr>
        <p:spPr bwMode="auto">
          <a:xfrm flipH="1">
            <a:off x="1876425" y="5589588"/>
            <a:ext cx="22225" cy="0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19" name="Rectangle 15"/>
          <p:cNvSpPr>
            <a:spLocks noChangeArrowheads="1"/>
          </p:cNvSpPr>
          <p:nvPr/>
        </p:nvSpPr>
        <p:spPr bwMode="auto">
          <a:xfrm>
            <a:off x="1715659" y="5530968"/>
            <a:ext cx="13305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0.4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20" name="Line 16"/>
          <p:cNvSpPr>
            <a:spLocks noChangeShapeType="1"/>
          </p:cNvSpPr>
          <p:nvPr/>
        </p:nvSpPr>
        <p:spPr bwMode="auto">
          <a:xfrm flipH="1">
            <a:off x="1876425" y="5419725"/>
            <a:ext cx="22225" cy="0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21" name="Rectangle 17"/>
          <p:cNvSpPr>
            <a:spLocks noChangeArrowheads="1"/>
          </p:cNvSpPr>
          <p:nvPr/>
        </p:nvSpPr>
        <p:spPr bwMode="auto">
          <a:xfrm>
            <a:off x="1715659" y="5358387"/>
            <a:ext cx="13305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0.6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22" name="Line 18"/>
          <p:cNvSpPr>
            <a:spLocks noChangeShapeType="1"/>
          </p:cNvSpPr>
          <p:nvPr/>
        </p:nvSpPr>
        <p:spPr bwMode="auto">
          <a:xfrm flipH="1">
            <a:off x="1876425" y="5251450"/>
            <a:ext cx="22225" cy="0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23" name="Rectangle 19"/>
          <p:cNvSpPr>
            <a:spLocks noChangeArrowheads="1"/>
          </p:cNvSpPr>
          <p:nvPr/>
        </p:nvSpPr>
        <p:spPr bwMode="auto">
          <a:xfrm>
            <a:off x="1715659" y="5191243"/>
            <a:ext cx="13305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0.8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24" name="Line 20"/>
          <p:cNvSpPr>
            <a:spLocks noChangeShapeType="1"/>
          </p:cNvSpPr>
          <p:nvPr/>
        </p:nvSpPr>
        <p:spPr bwMode="auto">
          <a:xfrm flipH="1">
            <a:off x="1876425" y="5081588"/>
            <a:ext cx="22225" cy="0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25" name="Rectangle 21"/>
          <p:cNvSpPr>
            <a:spLocks noChangeArrowheads="1"/>
          </p:cNvSpPr>
          <p:nvPr/>
        </p:nvSpPr>
        <p:spPr bwMode="auto">
          <a:xfrm>
            <a:off x="1766459" y="5021381"/>
            <a:ext cx="561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1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26" name="Line 22"/>
          <p:cNvSpPr>
            <a:spLocks noChangeShapeType="1"/>
          </p:cNvSpPr>
          <p:nvPr/>
        </p:nvSpPr>
        <p:spPr bwMode="auto">
          <a:xfrm flipH="1">
            <a:off x="1876425" y="4919663"/>
            <a:ext cx="22225" cy="0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27" name="Rectangle 23"/>
          <p:cNvSpPr>
            <a:spLocks noChangeArrowheads="1"/>
          </p:cNvSpPr>
          <p:nvPr/>
        </p:nvSpPr>
        <p:spPr bwMode="auto">
          <a:xfrm>
            <a:off x="1715659" y="4861043"/>
            <a:ext cx="13305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1.2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28" name="Line 24"/>
          <p:cNvSpPr>
            <a:spLocks noChangeShapeType="1"/>
          </p:cNvSpPr>
          <p:nvPr/>
        </p:nvSpPr>
        <p:spPr bwMode="auto">
          <a:xfrm flipH="1">
            <a:off x="1876425" y="4751388"/>
            <a:ext cx="22225" cy="0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29" name="Rectangle 25"/>
          <p:cNvSpPr>
            <a:spLocks noChangeArrowheads="1"/>
          </p:cNvSpPr>
          <p:nvPr/>
        </p:nvSpPr>
        <p:spPr bwMode="auto">
          <a:xfrm>
            <a:off x="1715659" y="4691181"/>
            <a:ext cx="13305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1.4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30" name="Line 26"/>
          <p:cNvSpPr>
            <a:spLocks noChangeShapeType="1"/>
          </p:cNvSpPr>
          <p:nvPr/>
        </p:nvSpPr>
        <p:spPr bwMode="auto">
          <a:xfrm flipH="1">
            <a:off x="1876425" y="4581525"/>
            <a:ext cx="22225" cy="0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31" name="Rectangle 27"/>
          <p:cNvSpPr>
            <a:spLocks noChangeArrowheads="1"/>
          </p:cNvSpPr>
          <p:nvPr/>
        </p:nvSpPr>
        <p:spPr bwMode="auto">
          <a:xfrm>
            <a:off x="1715659" y="4521318"/>
            <a:ext cx="13305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1.6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32" name="Line 28"/>
          <p:cNvSpPr>
            <a:spLocks noChangeShapeType="1"/>
          </p:cNvSpPr>
          <p:nvPr/>
        </p:nvSpPr>
        <p:spPr bwMode="auto">
          <a:xfrm flipH="1">
            <a:off x="1876425" y="4411663"/>
            <a:ext cx="22225" cy="0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33" name="Rectangle 29"/>
          <p:cNvSpPr>
            <a:spLocks noChangeArrowheads="1"/>
          </p:cNvSpPr>
          <p:nvPr/>
        </p:nvSpPr>
        <p:spPr bwMode="auto">
          <a:xfrm>
            <a:off x="1715659" y="4353043"/>
            <a:ext cx="13305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1.8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34" name="Rectangle 30"/>
          <p:cNvSpPr>
            <a:spLocks noChangeArrowheads="1"/>
          </p:cNvSpPr>
          <p:nvPr/>
        </p:nvSpPr>
        <p:spPr bwMode="auto">
          <a:xfrm>
            <a:off x="3514661" y="6091356"/>
            <a:ext cx="4953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Time (min)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36" name="Line 32"/>
          <p:cNvSpPr>
            <a:spLocks noChangeShapeType="1"/>
          </p:cNvSpPr>
          <p:nvPr/>
        </p:nvSpPr>
        <p:spPr bwMode="auto">
          <a:xfrm>
            <a:off x="2147888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37" name="Rectangle 33"/>
          <p:cNvSpPr>
            <a:spLocks noChangeArrowheads="1"/>
          </p:cNvSpPr>
          <p:nvPr/>
        </p:nvSpPr>
        <p:spPr bwMode="auto">
          <a:xfrm>
            <a:off x="2132013" y="5997575"/>
            <a:ext cx="561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1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38" name="Line 34"/>
          <p:cNvSpPr>
            <a:spLocks noChangeShapeType="1"/>
          </p:cNvSpPr>
          <p:nvPr/>
        </p:nvSpPr>
        <p:spPr bwMode="auto">
          <a:xfrm>
            <a:off x="2397125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39" name="Rectangle 35"/>
          <p:cNvSpPr>
            <a:spLocks noChangeArrowheads="1"/>
          </p:cNvSpPr>
          <p:nvPr/>
        </p:nvSpPr>
        <p:spPr bwMode="auto">
          <a:xfrm>
            <a:off x="2381250" y="5997575"/>
            <a:ext cx="561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2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40" name="Line 36"/>
          <p:cNvSpPr>
            <a:spLocks noChangeShapeType="1"/>
          </p:cNvSpPr>
          <p:nvPr/>
        </p:nvSpPr>
        <p:spPr bwMode="auto">
          <a:xfrm>
            <a:off x="2646363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41" name="Rectangle 37"/>
          <p:cNvSpPr>
            <a:spLocks noChangeArrowheads="1"/>
          </p:cNvSpPr>
          <p:nvPr/>
        </p:nvSpPr>
        <p:spPr bwMode="auto">
          <a:xfrm>
            <a:off x="2630488" y="5997575"/>
            <a:ext cx="561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3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42" name="Line 38"/>
          <p:cNvSpPr>
            <a:spLocks noChangeShapeType="1"/>
          </p:cNvSpPr>
          <p:nvPr/>
        </p:nvSpPr>
        <p:spPr bwMode="auto">
          <a:xfrm>
            <a:off x="2890838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43" name="Rectangle 39"/>
          <p:cNvSpPr>
            <a:spLocks noChangeArrowheads="1"/>
          </p:cNvSpPr>
          <p:nvPr/>
        </p:nvSpPr>
        <p:spPr bwMode="auto">
          <a:xfrm>
            <a:off x="2873375" y="5997575"/>
            <a:ext cx="561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4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44" name="Line 40"/>
          <p:cNvSpPr>
            <a:spLocks noChangeShapeType="1"/>
          </p:cNvSpPr>
          <p:nvPr/>
        </p:nvSpPr>
        <p:spPr bwMode="auto">
          <a:xfrm>
            <a:off x="3140075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45" name="Rectangle 41"/>
          <p:cNvSpPr>
            <a:spLocks noChangeArrowheads="1"/>
          </p:cNvSpPr>
          <p:nvPr/>
        </p:nvSpPr>
        <p:spPr bwMode="auto">
          <a:xfrm>
            <a:off x="3122613" y="5997575"/>
            <a:ext cx="561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5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46" name="Line 42"/>
          <p:cNvSpPr>
            <a:spLocks noChangeShapeType="1"/>
          </p:cNvSpPr>
          <p:nvPr/>
        </p:nvSpPr>
        <p:spPr bwMode="auto">
          <a:xfrm>
            <a:off x="3382963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47" name="Rectangle 43"/>
          <p:cNvSpPr>
            <a:spLocks noChangeArrowheads="1"/>
          </p:cNvSpPr>
          <p:nvPr/>
        </p:nvSpPr>
        <p:spPr bwMode="auto">
          <a:xfrm>
            <a:off x="3367088" y="5997575"/>
            <a:ext cx="561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6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48" name="Line 44"/>
          <p:cNvSpPr>
            <a:spLocks noChangeShapeType="1"/>
          </p:cNvSpPr>
          <p:nvPr/>
        </p:nvSpPr>
        <p:spPr bwMode="auto">
          <a:xfrm>
            <a:off x="3632200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49" name="Rectangle 45"/>
          <p:cNvSpPr>
            <a:spLocks noChangeArrowheads="1"/>
          </p:cNvSpPr>
          <p:nvPr/>
        </p:nvSpPr>
        <p:spPr bwMode="auto">
          <a:xfrm>
            <a:off x="3616325" y="5997575"/>
            <a:ext cx="561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7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50" name="Line 46"/>
          <p:cNvSpPr>
            <a:spLocks noChangeShapeType="1"/>
          </p:cNvSpPr>
          <p:nvPr/>
        </p:nvSpPr>
        <p:spPr bwMode="auto">
          <a:xfrm>
            <a:off x="3876675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51" name="Rectangle 47"/>
          <p:cNvSpPr>
            <a:spLocks noChangeArrowheads="1"/>
          </p:cNvSpPr>
          <p:nvPr/>
        </p:nvSpPr>
        <p:spPr bwMode="auto">
          <a:xfrm>
            <a:off x="3859213" y="5997575"/>
            <a:ext cx="561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8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52" name="Line 48"/>
          <p:cNvSpPr>
            <a:spLocks noChangeShapeType="1"/>
          </p:cNvSpPr>
          <p:nvPr/>
        </p:nvSpPr>
        <p:spPr bwMode="auto">
          <a:xfrm>
            <a:off x="4125913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53" name="Rectangle 49"/>
          <p:cNvSpPr>
            <a:spLocks noChangeArrowheads="1"/>
          </p:cNvSpPr>
          <p:nvPr/>
        </p:nvSpPr>
        <p:spPr bwMode="auto">
          <a:xfrm>
            <a:off x="4108450" y="5997575"/>
            <a:ext cx="561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9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54" name="Line 50"/>
          <p:cNvSpPr>
            <a:spLocks noChangeShapeType="1"/>
          </p:cNvSpPr>
          <p:nvPr/>
        </p:nvSpPr>
        <p:spPr bwMode="auto">
          <a:xfrm>
            <a:off x="4368800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55" name="Rectangle 51"/>
          <p:cNvSpPr>
            <a:spLocks noChangeArrowheads="1"/>
          </p:cNvSpPr>
          <p:nvPr/>
        </p:nvSpPr>
        <p:spPr bwMode="auto">
          <a:xfrm>
            <a:off x="4335463" y="5997575"/>
            <a:ext cx="11221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1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56" name="Line 52"/>
          <p:cNvSpPr>
            <a:spLocks noChangeShapeType="1"/>
          </p:cNvSpPr>
          <p:nvPr/>
        </p:nvSpPr>
        <p:spPr bwMode="auto">
          <a:xfrm>
            <a:off x="4618038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57" name="Rectangle 53"/>
          <p:cNvSpPr>
            <a:spLocks noChangeArrowheads="1"/>
          </p:cNvSpPr>
          <p:nvPr/>
        </p:nvSpPr>
        <p:spPr bwMode="auto">
          <a:xfrm>
            <a:off x="4584700" y="5997575"/>
            <a:ext cx="11221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11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58" name="Line 54"/>
          <p:cNvSpPr>
            <a:spLocks noChangeShapeType="1"/>
          </p:cNvSpPr>
          <p:nvPr/>
        </p:nvSpPr>
        <p:spPr bwMode="auto">
          <a:xfrm>
            <a:off x="4867275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59" name="Rectangle 55"/>
          <p:cNvSpPr>
            <a:spLocks noChangeArrowheads="1"/>
          </p:cNvSpPr>
          <p:nvPr/>
        </p:nvSpPr>
        <p:spPr bwMode="auto">
          <a:xfrm>
            <a:off x="4833938" y="5997575"/>
            <a:ext cx="11221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12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60" name="Line 56"/>
          <p:cNvSpPr>
            <a:spLocks noChangeShapeType="1"/>
          </p:cNvSpPr>
          <p:nvPr/>
        </p:nvSpPr>
        <p:spPr bwMode="auto">
          <a:xfrm>
            <a:off x="5111750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61" name="Rectangle 57"/>
          <p:cNvSpPr>
            <a:spLocks noChangeArrowheads="1"/>
          </p:cNvSpPr>
          <p:nvPr/>
        </p:nvSpPr>
        <p:spPr bwMode="auto">
          <a:xfrm>
            <a:off x="5078413" y="5997575"/>
            <a:ext cx="11221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13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62" name="Line 58"/>
          <p:cNvSpPr>
            <a:spLocks noChangeShapeType="1"/>
          </p:cNvSpPr>
          <p:nvPr/>
        </p:nvSpPr>
        <p:spPr bwMode="auto">
          <a:xfrm>
            <a:off x="5360988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63" name="Rectangle 59"/>
          <p:cNvSpPr>
            <a:spLocks noChangeArrowheads="1"/>
          </p:cNvSpPr>
          <p:nvPr/>
        </p:nvSpPr>
        <p:spPr bwMode="auto">
          <a:xfrm>
            <a:off x="5327650" y="5997575"/>
            <a:ext cx="11221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14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2048" name="Line 60"/>
          <p:cNvSpPr>
            <a:spLocks noChangeShapeType="1"/>
          </p:cNvSpPr>
          <p:nvPr/>
        </p:nvSpPr>
        <p:spPr bwMode="auto">
          <a:xfrm>
            <a:off x="5603875" y="5959475"/>
            <a:ext cx="0" cy="30163"/>
          </a:xfrm>
          <a:prstGeom prst="line">
            <a:avLst/>
          </a:prstGeom>
          <a:noFill/>
          <a:ln w="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2049" name="Rectangle 61"/>
          <p:cNvSpPr>
            <a:spLocks noChangeArrowheads="1"/>
          </p:cNvSpPr>
          <p:nvPr/>
        </p:nvSpPr>
        <p:spPr bwMode="auto">
          <a:xfrm>
            <a:off x="5570538" y="5997575"/>
            <a:ext cx="11221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15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2058" name="Freeform 69"/>
          <p:cNvSpPr>
            <a:spLocks/>
          </p:cNvSpPr>
          <p:nvPr/>
        </p:nvSpPr>
        <p:spPr bwMode="auto">
          <a:xfrm>
            <a:off x="1905000" y="4497388"/>
            <a:ext cx="3798888" cy="1423988"/>
          </a:xfrm>
          <a:custGeom>
            <a:avLst/>
            <a:gdLst>
              <a:gd name="T0" fmla="*/ 38 w 2393"/>
              <a:gd name="T1" fmla="*/ 897 h 897"/>
              <a:gd name="T2" fmla="*/ 80 w 2393"/>
              <a:gd name="T3" fmla="*/ 897 h 897"/>
              <a:gd name="T4" fmla="*/ 122 w 2393"/>
              <a:gd name="T5" fmla="*/ 897 h 897"/>
              <a:gd name="T6" fmla="*/ 164 w 2393"/>
              <a:gd name="T7" fmla="*/ 897 h 897"/>
              <a:gd name="T8" fmla="*/ 206 w 2393"/>
              <a:gd name="T9" fmla="*/ 897 h 897"/>
              <a:gd name="T10" fmla="*/ 248 w 2393"/>
              <a:gd name="T11" fmla="*/ 897 h 897"/>
              <a:gd name="T12" fmla="*/ 289 w 2393"/>
              <a:gd name="T13" fmla="*/ 897 h 897"/>
              <a:gd name="T14" fmla="*/ 331 w 2393"/>
              <a:gd name="T15" fmla="*/ 897 h 897"/>
              <a:gd name="T16" fmla="*/ 373 w 2393"/>
              <a:gd name="T17" fmla="*/ 897 h 897"/>
              <a:gd name="T18" fmla="*/ 415 w 2393"/>
              <a:gd name="T19" fmla="*/ 897 h 897"/>
              <a:gd name="T20" fmla="*/ 457 w 2393"/>
              <a:gd name="T21" fmla="*/ 897 h 897"/>
              <a:gd name="T22" fmla="*/ 499 w 2393"/>
              <a:gd name="T23" fmla="*/ 897 h 897"/>
              <a:gd name="T24" fmla="*/ 541 w 2393"/>
              <a:gd name="T25" fmla="*/ 897 h 897"/>
              <a:gd name="T26" fmla="*/ 582 w 2393"/>
              <a:gd name="T27" fmla="*/ 897 h 897"/>
              <a:gd name="T28" fmla="*/ 624 w 2393"/>
              <a:gd name="T29" fmla="*/ 897 h 897"/>
              <a:gd name="T30" fmla="*/ 666 w 2393"/>
              <a:gd name="T31" fmla="*/ 897 h 897"/>
              <a:gd name="T32" fmla="*/ 708 w 2393"/>
              <a:gd name="T33" fmla="*/ 897 h 897"/>
              <a:gd name="T34" fmla="*/ 750 w 2393"/>
              <a:gd name="T35" fmla="*/ 897 h 897"/>
              <a:gd name="T36" fmla="*/ 792 w 2393"/>
              <a:gd name="T37" fmla="*/ 897 h 897"/>
              <a:gd name="T38" fmla="*/ 834 w 2393"/>
              <a:gd name="T39" fmla="*/ 897 h 897"/>
              <a:gd name="T40" fmla="*/ 876 w 2393"/>
              <a:gd name="T41" fmla="*/ 897 h 897"/>
              <a:gd name="T42" fmla="*/ 917 w 2393"/>
              <a:gd name="T43" fmla="*/ 897 h 897"/>
              <a:gd name="T44" fmla="*/ 959 w 2393"/>
              <a:gd name="T45" fmla="*/ 897 h 897"/>
              <a:gd name="T46" fmla="*/ 1001 w 2393"/>
              <a:gd name="T47" fmla="*/ 897 h 897"/>
              <a:gd name="T48" fmla="*/ 1043 w 2393"/>
              <a:gd name="T49" fmla="*/ 897 h 897"/>
              <a:gd name="T50" fmla="*/ 1085 w 2393"/>
              <a:gd name="T51" fmla="*/ 897 h 897"/>
              <a:gd name="T52" fmla="*/ 1127 w 2393"/>
              <a:gd name="T53" fmla="*/ 897 h 897"/>
              <a:gd name="T54" fmla="*/ 1169 w 2393"/>
              <a:gd name="T55" fmla="*/ 897 h 897"/>
              <a:gd name="T56" fmla="*/ 1210 w 2393"/>
              <a:gd name="T57" fmla="*/ 897 h 897"/>
              <a:gd name="T58" fmla="*/ 1252 w 2393"/>
              <a:gd name="T59" fmla="*/ 897 h 897"/>
              <a:gd name="T60" fmla="*/ 1294 w 2393"/>
              <a:gd name="T61" fmla="*/ 897 h 897"/>
              <a:gd name="T62" fmla="*/ 1336 w 2393"/>
              <a:gd name="T63" fmla="*/ 897 h 897"/>
              <a:gd name="T64" fmla="*/ 1378 w 2393"/>
              <a:gd name="T65" fmla="*/ 897 h 897"/>
              <a:gd name="T66" fmla="*/ 1420 w 2393"/>
              <a:gd name="T67" fmla="*/ 897 h 897"/>
              <a:gd name="T68" fmla="*/ 1462 w 2393"/>
              <a:gd name="T69" fmla="*/ 897 h 897"/>
              <a:gd name="T70" fmla="*/ 1503 w 2393"/>
              <a:gd name="T71" fmla="*/ 897 h 897"/>
              <a:gd name="T72" fmla="*/ 1545 w 2393"/>
              <a:gd name="T73" fmla="*/ 897 h 897"/>
              <a:gd name="T74" fmla="*/ 1587 w 2393"/>
              <a:gd name="T75" fmla="*/ 897 h 897"/>
              <a:gd name="T76" fmla="*/ 1629 w 2393"/>
              <a:gd name="T77" fmla="*/ 897 h 897"/>
              <a:gd name="T78" fmla="*/ 1671 w 2393"/>
              <a:gd name="T79" fmla="*/ 897 h 897"/>
              <a:gd name="T80" fmla="*/ 1713 w 2393"/>
              <a:gd name="T81" fmla="*/ 897 h 897"/>
              <a:gd name="T82" fmla="*/ 1755 w 2393"/>
              <a:gd name="T83" fmla="*/ 897 h 897"/>
              <a:gd name="T84" fmla="*/ 1797 w 2393"/>
              <a:gd name="T85" fmla="*/ 897 h 897"/>
              <a:gd name="T86" fmla="*/ 1838 w 2393"/>
              <a:gd name="T87" fmla="*/ 897 h 897"/>
              <a:gd name="T88" fmla="*/ 1880 w 2393"/>
              <a:gd name="T89" fmla="*/ 863 h 897"/>
              <a:gd name="T90" fmla="*/ 1901 w 2393"/>
              <a:gd name="T91" fmla="*/ 0 h 897"/>
              <a:gd name="T92" fmla="*/ 1940 w 2393"/>
              <a:gd name="T93" fmla="*/ 824 h 897"/>
              <a:gd name="T94" fmla="*/ 1974 w 2393"/>
              <a:gd name="T95" fmla="*/ 877 h 897"/>
              <a:gd name="T96" fmla="*/ 2013 w 2393"/>
              <a:gd name="T97" fmla="*/ 887 h 897"/>
              <a:gd name="T98" fmla="*/ 2044 w 2393"/>
              <a:gd name="T99" fmla="*/ 892 h 897"/>
              <a:gd name="T100" fmla="*/ 2086 w 2393"/>
              <a:gd name="T101" fmla="*/ 892 h 897"/>
              <a:gd name="T102" fmla="*/ 2128 w 2393"/>
              <a:gd name="T103" fmla="*/ 892 h 897"/>
              <a:gd name="T104" fmla="*/ 2170 w 2393"/>
              <a:gd name="T105" fmla="*/ 892 h 897"/>
              <a:gd name="T106" fmla="*/ 2212 w 2393"/>
              <a:gd name="T107" fmla="*/ 892 h 897"/>
              <a:gd name="T108" fmla="*/ 2254 w 2393"/>
              <a:gd name="T109" fmla="*/ 892 h 897"/>
              <a:gd name="T110" fmla="*/ 2285 w 2393"/>
              <a:gd name="T111" fmla="*/ 897 h 897"/>
              <a:gd name="T112" fmla="*/ 2323 w 2393"/>
              <a:gd name="T113" fmla="*/ 897 h 897"/>
              <a:gd name="T114" fmla="*/ 2365 w 2393"/>
              <a:gd name="T115" fmla="*/ 897 h 8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2393" h="897">
                <a:moveTo>
                  <a:pt x="0" y="897"/>
                </a:moveTo>
                <a:lnTo>
                  <a:pt x="3" y="897"/>
                </a:lnTo>
                <a:lnTo>
                  <a:pt x="7" y="897"/>
                </a:lnTo>
                <a:lnTo>
                  <a:pt x="10" y="897"/>
                </a:lnTo>
                <a:lnTo>
                  <a:pt x="14" y="897"/>
                </a:lnTo>
                <a:lnTo>
                  <a:pt x="17" y="897"/>
                </a:lnTo>
                <a:lnTo>
                  <a:pt x="21" y="897"/>
                </a:lnTo>
                <a:lnTo>
                  <a:pt x="24" y="897"/>
                </a:lnTo>
                <a:lnTo>
                  <a:pt x="28" y="897"/>
                </a:lnTo>
                <a:lnTo>
                  <a:pt x="31" y="897"/>
                </a:lnTo>
                <a:lnTo>
                  <a:pt x="35" y="897"/>
                </a:lnTo>
                <a:lnTo>
                  <a:pt x="38" y="897"/>
                </a:lnTo>
                <a:lnTo>
                  <a:pt x="42" y="897"/>
                </a:lnTo>
                <a:lnTo>
                  <a:pt x="45" y="897"/>
                </a:lnTo>
                <a:lnTo>
                  <a:pt x="49" y="897"/>
                </a:lnTo>
                <a:lnTo>
                  <a:pt x="52" y="897"/>
                </a:lnTo>
                <a:lnTo>
                  <a:pt x="56" y="897"/>
                </a:lnTo>
                <a:lnTo>
                  <a:pt x="59" y="897"/>
                </a:lnTo>
                <a:lnTo>
                  <a:pt x="63" y="897"/>
                </a:lnTo>
                <a:lnTo>
                  <a:pt x="66" y="897"/>
                </a:lnTo>
                <a:lnTo>
                  <a:pt x="70" y="897"/>
                </a:lnTo>
                <a:lnTo>
                  <a:pt x="73" y="897"/>
                </a:lnTo>
                <a:lnTo>
                  <a:pt x="77" y="897"/>
                </a:lnTo>
                <a:lnTo>
                  <a:pt x="80" y="897"/>
                </a:lnTo>
                <a:lnTo>
                  <a:pt x="84" y="897"/>
                </a:lnTo>
                <a:lnTo>
                  <a:pt x="87" y="897"/>
                </a:lnTo>
                <a:lnTo>
                  <a:pt x="91" y="897"/>
                </a:lnTo>
                <a:lnTo>
                  <a:pt x="94" y="897"/>
                </a:lnTo>
                <a:lnTo>
                  <a:pt x="98" y="897"/>
                </a:lnTo>
                <a:lnTo>
                  <a:pt x="101" y="897"/>
                </a:lnTo>
                <a:lnTo>
                  <a:pt x="105" y="897"/>
                </a:lnTo>
                <a:lnTo>
                  <a:pt x="108" y="897"/>
                </a:lnTo>
                <a:lnTo>
                  <a:pt x="112" y="897"/>
                </a:lnTo>
                <a:lnTo>
                  <a:pt x="115" y="897"/>
                </a:lnTo>
                <a:lnTo>
                  <a:pt x="119" y="897"/>
                </a:lnTo>
                <a:lnTo>
                  <a:pt x="122" y="897"/>
                </a:lnTo>
                <a:lnTo>
                  <a:pt x="125" y="897"/>
                </a:lnTo>
                <a:lnTo>
                  <a:pt x="129" y="897"/>
                </a:lnTo>
                <a:lnTo>
                  <a:pt x="132" y="897"/>
                </a:lnTo>
                <a:lnTo>
                  <a:pt x="136" y="897"/>
                </a:lnTo>
                <a:lnTo>
                  <a:pt x="139" y="897"/>
                </a:lnTo>
                <a:lnTo>
                  <a:pt x="143" y="897"/>
                </a:lnTo>
                <a:lnTo>
                  <a:pt x="146" y="897"/>
                </a:lnTo>
                <a:lnTo>
                  <a:pt x="150" y="897"/>
                </a:lnTo>
                <a:lnTo>
                  <a:pt x="153" y="897"/>
                </a:lnTo>
                <a:lnTo>
                  <a:pt x="157" y="897"/>
                </a:lnTo>
                <a:lnTo>
                  <a:pt x="160" y="897"/>
                </a:lnTo>
                <a:lnTo>
                  <a:pt x="164" y="897"/>
                </a:lnTo>
                <a:lnTo>
                  <a:pt x="167" y="897"/>
                </a:lnTo>
                <a:lnTo>
                  <a:pt x="171" y="897"/>
                </a:lnTo>
                <a:lnTo>
                  <a:pt x="174" y="897"/>
                </a:lnTo>
                <a:lnTo>
                  <a:pt x="178" y="897"/>
                </a:lnTo>
                <a:lnTo>
                  <a:pt x="181" y="897"/>
                </a:lnTo>
                <a:lnTo>
                  <a:pt x="185" y="897"/>
                </a:lnTo>
                <a:lnTo>
                  <a:pt x="188" y="897"/>
                </a:lnTo>
                <a:lnTo>
                  <a:pt x="192" y="897"/>
                </a:lnTo>
                <a:lnTo>
                  <a:pt x="195" y="897"/>
                </a:lnTo>
                <a:lnTo>
                  <a:pt x="199" y="897"/>
                </a:lnTo>
                <a:lnTo>
                  <a:pt x="202" y="897"/>
                </a:lnTo>
                <a:lnTo>
                  <a:pt x="206" y="897"/>
                </a:lnTo>
                <a:lnTo>
                  <a:pt x="209" y="897"/>
                </a:lnTo>
                <a:lnTo>
                  <a:pt x="213" y="897"/>
                </a:lnTo>
                <a:lnTo>
                  <a:pt x="216" y="897"/>
                </a:lnTo>
                <a:lnTo>
                  <a:pt x="220" y="897"/>
                </a:lnTo>
                <a:lnTo>
                  <a:pt x="223" y="897"/>
                </a:lnTo>
                <a:lnTo>
                  <a:pt x="227" y="897"/>
                </a:lnTo>
                <a:lnTo>
                  <a:pt x="230" y="897"/>
                </a:lnTo>
                <a:lnTo>
                  <a:pt x="234" y="897"/>
                </a:lnTo>
                <a:lnTo>
                  <a:pt x="237" y="897"/>
                </a:lnTo>
                <a:lnTo>
                  <a:pt x="241" y="897"/>
                </a:lnTo>
                <a:lnTo>
                  <a:pt x="244" y="897"/>
                </a:lnTo>
                <a:lnTo>
                  <a:pt x="248" y="897"/>
                </a:lnTo>
                <a:lnTo>
                  <a:pt x="251" y="897"/>
                </a:lnTo>
                <a:lnTo>
                  <a:pt x="255" y="897"/>
                </a:lnTo>
                <a:lnTo>
                  <a:pt x="258" y="897"/>
                </a:lnTo>
                <a:lnTo>
                  <a:pt x="262" y="897"/>
                </a:lnTo>
                <a:lnTo>
                  <a:pt x="265" y="897"/>
                </a:lnTo>
                <a:lnTo>
                  <a:pt x="269" y="897"/>
                </a:lnTo>
                <a:lnTo>
                  <a:pt x="272" y="897"/>
                </a:lnTo>
                <a:lnTo>
                  <a:pt x="276" y="897"/>
                </a:lnTo>
                <a:lnTo>
                  <a:pt x="279" y="897"/>
                </a:lnTo>
                <a:lnTo>
                  <a:pt x="282" y="897"/>
                </a:lnTo>
                <a:lnTo>
                  <a:pt x="286" y="897"/>
                </a:lnTo>
                <a:lnTo>
                  <a:pt x="289" y="897"/>
                </a:lnTo>
                <a:lnTo>
                  <a:pt x="293" y="897"/>
                </a:lnTo>
                <a:lnTo>
                  <a:pt x="296" y="897"/>
                </a:lnTo>
                <a:lnTo>
                  <a:pt x="300" y="897"/>
                </a:lnTo>
                <a:lnTo>
                  <a:pt x="303" y="897"/>
                </a:lnTo>
                <a:lnTo>
                  <a:pt x="307" y="897"/>
                </a:lnTo>
                <a:lnTo>
                  <a:pt x="310" y="897"/>
                </a:lnTo>
                <a:lnTo>
                  <a:pt x="314" y="897"/>
                </a:lnTo>
                <a:lnTo>
                  <a:pt x="317" y="897"/>
                </a:lnTo>
                <a:lnTo>
                  <a:pt x="321" y="897"/>
                </a:lnTo>
                <a:lnTo>
                  <a:pt x="324" y="897"/>
                </a:lnTo>
                <a:lnTo>
                  <a:pt x="328" y="897"/>
                </a:lnTo>
                <a:lnTo>
                  <a:pt x="331" y="897"/>
                </a:lnTo>
                <a:lnTo>
                  <a:pt x="335" y="897"/>
                </a:lnTo>
                <a:lnTo>
                  <a:pt x="338" y="897"/>
                </a:lnTo>
                <a:lnTo>
                  <a:pt x="342" y="897"/>
                </a:lnTo>
                <a:lnTo>
                  <a:pt x="345" y="897"/>
                </a:lnTo>
                <a:lnTo>
                  <a:pt x="349" y="897"/>
                </a:lnTo>
                <a:lnTo>
                  <a:pt x="352" y="897"/>
                </a:lnTo>
                <a:lnTo>
                  <a:pt x="356" y="897"/>
                </a:lnTo>
                <a:lnTo>
                  <a:pt x="359" y="897"/>
                </a:lnTo>
                <a:lnTo>
                  <a:pt x="363" y="897"/>
                </a:lnTo>
                <a:lnTo>
                  <a:pt x="366" y="897"/>
                </a:lnTo>
                <a:lnTo>
                  <a:pt x="370" y="897"/>
                </a:lnTo>
                <a:lnTo>
                  <a:pt x="373" y="897"/>
                </a:lnTo>
                <a:lnTo>
                  <a:pt x="377" y="897"/>
                </a:lnTo>
                <a:lnTo>
                  <a:pt x="380" y="897"/>
                </a:lnTo>
                <a:lnTo>
                  <a:pt x="384" y="897"/>
                </a:lnTo>
                <a:lnTo>
                  <a:pt x="387" y="897"/>
                </a:lnTo>
                <a:lnTo>
                  <a:pt x="391" y="897"/>
                </a:lnTo>
                <a:lnTo>
                  <a:pt x="394" y="897"/>
                </a:lnTo>
                <a:lnTo>
                  <a:pt x="398" y="897"/>
                </a:lnTo>
                <a:lnTo>
                  <a:pt x="401" y="897"/>
                </a:lnTo>
                <a:lnTo>
                  <a:pt x="405" y="897"/>
                </a:lnTo>
                <a:lnTo>
                  <a:pt x="408" y="897"/>
                </a:lnTo>
                <a:lnTo>
                  <a:pt x="412" y="897"/>
                </a:lnTo>
                <a:lnTo>
                  <a:pt x="415" y="897"/>
                </a:lnTo>
                <a:lnTo>
                  <a:pt x="419" y="897"/>
                </a:lnTo>
                <a:lnTo>
                  <a:pt x="422" y="897"/>
                </a:lnTo>
                <a:lnTo>
                  <a:pt x="426" y="897"/>
                </a:lnTo>
                <a:lnTo>
                  <a:pt x="429" y="897"/>
                </a:lnTo>
                <a:lnTo>
                  <a:pt x="432" y="897"/>
                </a:lnTo>
                <a:lnTo>
                  <a:pt x="436" y="897"/>
                </a:lnTo>
                <a:lnTo>
                  <a:pt x="439" y="897"/>
                </a:lnTo>
                <a:lnTo>
                  <a:pt x="443" y="897"/>
                </a:lnTo>
                <a:lnTo>
                  <a:pt x="446" y="897"/>
                </a:lnTo>
                <a:lnTo>
                  <a:pt x="450" y="897"/>
                </a:lnTo>
                <a:lnTo>
                  <a:pt x="453" y="897"/>
                </a:lnTo>
                <a:lnTo>
                  <a:pt x="457" y="897"/>
                </a:lnTo>
                <a:lnTo>
                  <a:pt x="460" y="897"/>
                </a:lnTo>
                <a:lnTo>
                  <a:pt x="464" y="897"/>
                </a:lnTo>
                <a:lnTo>
                  <a:pt x="467" y="897"/>
                </a:lnTo>
                <a:lnTo>
                  <a:pt x="471" y="897"/>
                </a:lnTo>
                <a:lnTo>
                  <a:pt x="474" y="897"/>
                </a:lnTo>
                <a:lnTo>
                  <a:pt x="478" y="897"/>
                </a:lnTo>
                <a:lnTo>
                  <a:pt x="481" y="897"/>
                </a:lnTo>
                <a:lnTo>
                  <a:pt x="485" y="897"/>
                </a:lnTo>
                <a:lnTo>
                  <a:pt x="488" y="897"/>
                </a:lnTo>
                <a:lnTo>
                  <a:pt x="492" y="897"/>
                </a:lnTo>
                <a:lnTo>
                  <a:pt x="495" y="897"/>
                </a:lnTo>
                <a:lnTo>
                  <a:pt x="499" y="897"/>
                </a:lnTo>
                <a:lnTo>
                  <a:pt x="502" y="897"/>
                </a:lnTo>
                <a:lnTo>
                  <a:pt x="506" y="897"/>
                </a:lnTo>
                <a:lnTo>
                  <a:pt x="509" y="897"/>
                </a:lnTo>
                <a:lnTo>
                  <a:pt x="513" y="897"/>
                </a:lnTo>
                <a:lnTo>
                  <a:pt x="516" y="897"/>
                </a:lnTo>
                <a:lnTo>
                  <a:pt x="520" y="897"/>
                </a:lnTo>
                <a:lnTo>
                  <a:pt x="523" y="897"/>
                </a:lnTo>
                <a:lnTo>
                  <a:pt x="527" y="897"/>
                </a:lnTo>
                <a:lnTo>
                  <a:pt x="530" y="897"/>
                </a:lnTo>
                <a:lnTo>
                  <a:pt x="534" y="897"/>
                </a:lnTo>
                <a:lnTo>
                  <a:pt x="537" y="897"/>
                </a:lnTo>
                <a:lnTo>
                  <a:pt x="541" y="897"/>
                </a:lnTo>
                <a:lnTo>
                  <a:pt x="544" y="897"/>
                </a:lnTo>
                <a:lnTo>
                  <a:pt x="548" y="897"/>
                </a:lnTo>
                <a:lnTo>
                  <a:pt x="551" y="897"/>
                </a:lnTo>
                <a:lnTo>
                  <a:pt x="555" y="897"/>
                </a:lnTo>
                <a:lnTo>
                  <a:pt x="558" y="897"/>
                </a:lnTo>
                <a:lnTo>
                  <a:pt x="562" y="897"/>
                </a:lnTo>
                <a:lnTo>
                  <a:pt x="565" y="897"/>
                </a:lnTo>
                <a:lnTo>
                  <a:pt x="569" y="897"/>
                </a:lnTo>
                <a:lnTo>
                  <a:pt x="572" y="897"/>
                </a:lnTo>
                <a:lnTo>
                  <a:pt x="576" y="897"/>
                </a:lnTo>
                <a:lnTo>
                  <a:pt x="579" y="897"/>
                </a:lnTo>
                <a:lnTo>
                  <a:pt x="582" y="897"/>
                </a:lnTo>
                <a:lnTo>
                  <a:pt x="586" y="897"/>
                </a:lnTo>
                <a:lnTo>
                  <a:pt x="589" y="897"/>
                </a:lnTo>
                <a:lnTo>
                  <a:pt x="593" y="897"/>
                </a:lnTo>
                <a:lnTo>
                  <a:pt x="596" y="897"/>
                </a:lnTo>
                <a:lnTo>
                  <a:pt x="600" y="897"/>
                </a:lnTo>
                <a:lnTo>
                  <a:pt x="603" y="897"/>
                </a:lnTo>
                <a:lnTo>
                  <a:pt x="607" y="897"/>
                </a:lnTo>
                <a:lnTo>
                  <a:pt x="610" y="897"/>
                </a:lnTo>
                <a:lnTo>
                  <a:pt x="614" y="897"/>
                </a:lnTo>
                <a:lnTo>
                  <a:pt x="617" y="897"/>
                </a:lnTo>
                <a:lnTo>
                  <a:pt x="621" y="897"/>
                </a:lnTo>
                <a:lnTo>
                  <a:pt x="624" y="897"/>
                </a:lnTo>
                <a:lnTo>
                  <a:pt x="628" y="897"/>
                </a:lnTo>
                <a:lnTo>
                  <a:pt x="631" y="897"/>
                </a:lnTo>
                <a:lnTo>
                  <a:pt x="635" y="897"/>
                </a:lnTo>
                <a:lnTo>
                  <a:pt x="638" y="897"/>
                </a:lnTo>
                <a:lnTo>
                  <a:pt x="642" y="897"/>
                </a:lnTo>
                <a:lnTo>
                  <a:pt x="645" y="897"/>
                </a:lnTo>
                <a:lnTo>
                  <a:pt x="649" y="897"/>
                </a:lnTo>
                <a:lnTo>
                  <a:pt x="652" y="897"/>
                </a:lnTo>
                <a:lnTo>
                  <a:pt x="656" y="897"/>
                </a:lnTo>
                <a:lnTo>
                  <a:pt x="659" y="897"/>
                </a:lnTo>
                <a:lnTo>
                  <a:pt x="663" y="897"/>
                </a:lnTo>
                <a:lnTo>
                  <a:pt x="666" y="897"/>
                </a:lnTo>
                <a:lnTo>
                  <a:pt x="670" y="897"/>
                </a:lnTo>
                <a:lnTo>
                  <a:pt x="673" y="897"/>
                </a:lnTo>
                <a:lnTo>
                  <a:pt x="677" y="897"/>
                </a:lnTo>
                <a:lnTo>
                  <a:pt x="680" y="897"/>
                </a:lnTo>
                <a:lnTo>
                  <a:pt x="684" y="897"/>
                </a:lnTo>
                <a:lnTo>
                  <a:pt x="687" y="897"/>
                </a:lnTo>
                <a:lnTo>
                  <a:pt x="691" y="897"/>
                </a:lnTo>
                <a:lnTo>
                  <a:pt x="694" y="897"/>
                </a:lnTo>
                <a:lnTo>
                  <a:pt x="698" y="897"/>
                </a:lnTo>
                <a:lnTo>
                  <a:pt x="701" y="897"/>
                </a:lnTo>
                <a:lnTo>
                  <a:pt x="705" y="897"/>
                </a:lnTo>
                <a:lnTo>
                  <a:pt x="708" y="897"/>
                </a:lnTo>
                <a:lnTo>
                  <a:pt x="712" y="897"/>
                </a:lnTo>
                <a:lnTo>
                  <a:pt x="715" y="897"/>
                </a:lnTo>
                <a:lnTo>
                  <a:pt x="719" y="897"/>
                </a:lnTo>
                <a:lnTo>
                  <a:pt x="722" y="897"/>
                </a:lnTo>
                <a:lnTo>
                  <a:pt x="726" y="897"/>
                </a:lnTo>
                <a:lnTo>
                  <a:pt x="729" y="897"/>
                </a:lnTo>
                <a:lnTo>
                  <a:pt x="733" y="897"/>
                </a:lnTo>
                <a:lnTo>
                  <a:pt x="736" y="897"/>
                </a:lnTo>
                <a:lnTo>
                  <a:pt x="739" y="897"/>
                </a:lnTo>
                <a:lnTo>
                  <a:pt x="743" y="897"/>
                </a:lnTo>
                <a:lnTo>
                  <a:pt x="746" y="897"/>
                </a:lnTo>
                <a:lnTo>
                  <a:pt x="750" y="897"/>
                </a:lnTo>
                <a:lnTo>
                  <a:pt x="753" y="897"/>
                </a:lnTo>
                <a:lnTo>
                  <a:pt x="757" y="897"/>
                </a:lnTo>
                <a:lnTo>
                  <a:pt x="760" y="897"/>
                </a:lnTo>
                <a:lnTo>
                  <a:pt x="764" y="897"/>
                </a:lnTo>
                <a:lnTo>
                  <a:pt x="767" y="897"/>
                </a:lnTo>
                <a:lnTo>
                  <a:pt x="771" y="897"/>
                </a:lnTo>
                <a:lnTo>
                  <a:pt x="774" y="897"/>
                </a:lnTo>
                <a:lnTo>
                  <a:pt x="778" y="897"/>
                </a:lnTo>
                <a:lnTo>
                  <a:pt x="781" y="897"/>
                </a:lnTo>
                <a:lnTo>
                  <a:pt x="785" y="897"/>
                </a:lnTo>
                <a:lnTo>
                  <a:pt x="788" y="897"/>
                </a:lnTo>
                <a:lnTo>
                  <a:pt x="792" y="897"/>
                </a:lnTo>
                <a:lnTo>
                  <a:pt x="795" y="897"/>
                </a:lnTo>
                <a:lnTo>
                  <a:pt x="799" y="897"/>
                </a:lnTo>
                <a:lnTo>
                  <a:pt x="802" y="897"/>
                </a:lnTo>
                <a:lnTo>
                  <a:pt x="806" y="897"/>
                </a:lnTo>
                <a:lnTo>
                  <a:pt x="809" y="897"/>
                </a:lnTo>
                <a:lnTo>
                  <a:pt x="813" y="897"/>
                </a:lnTo>
                <a:lnTo>
                  <a:pt x="816" y="897"/>
                </a:lnTo>
                <a:lnTo>
                  <a:pt x="820" y="897"/>
                </a:lnTo>
                <a:lnTo>
                  <a:pt x="823" y="897"/>
                </a:lnTo>
                <a:lnTo>
                  <a:pt x="827" y="897"/>
                </a:lnTo>
                <a:lnTo>
                  <a:pt x="830" y="897"/>
                </a:lnTo>
                <a:lnTo>
                  <a:pt x="834" y="897"/>
                </a:lnTo>
                <a:lnTo>
                  <a:pt x="837" y="897"/>
                </a:lnTo>
                <a:lnTo>
                  <a:pt x="841" y="897"/>
                </a:lnTo>
                <a:lnTo>
                  <a:pt x="844" y="897"/>
                </a:lnTo>
                <a:lnTo>
                  <a:pt x="848" y="897"/>
                </a:lnTo>
                <a:lnTo>
                  <a:pt x="851" y="897"/>
                </a:lnTo>
                <a:lnTo>
                  <a:pt x="855" y="897"/>
                </a:lnTo>
                <a:lnTo>
                  <a:pt x="858" y="897"/>
                </a:lnTo>
                <a:lnTo>
                  <a:pt x="862" y="897"/>
                </a:lnTo>
                <a:lnTo>
                  <a:pt x="865" y="897"/>
                </a:lnTo>
                <a:lnTo>
                  <a:pt x="869" y="897"/>
                </a:lnTo>
                <a:lnTo>
                  <a:pt x="872" y="897"/>
                </a:lnTo>
                <a:lnTo>
                  <a:pt x="876" y="897"/>
                </a:lnTo>
                <a:lnTo>
                  <a:pt x="879" y="897"/>
                </a:lnTo>
                <a:lnTo>
                  <a:pt x="883" y="897"/>
                </a:lnTo>
                <a:lnTo>
                  <a:pt x="886" y="897"/>
                </a:lnTo>
                <a:lnTo>
                  <a:pt x="889" y="897"/>
                </a:lnTo>
                <a:lnTo>
                  <a:pt x="893" y="897"/>
                </a:lnTo>
                <a:lnTo>
                  <a:pt x="896" y="897"/>
                </a:lnTo>
                <a:lnTo>
                  <a:pt x="900" y="897"/>
                </a:lnTo>
                <a:lnTo>
                  <a:pt x="903" y="897"/>
                </a:lnTo>
                <a:lnTo>
                  <a:pt x="907" y="897"/>
                </a:lnTo>
                <a:lnTo>
                  <a:pt x="910" y="897"/>
                </a:lnTo>
                <a:lnTo>
                  <a:pt x="914" y="897"/>
                </a:lnTo>
                <a:lnTo>
                  <a:pt x="917" y="897"/>
                </a:lnTo>
                <a:lnTo>
                  <a:pt x="921" y="897"/>
                </a:lnTo>
                <a:lnTo>
                  <a:pt x="924" y="897"/>
                </a:lnTo>
                <a:lnTo>
                  <a:pt x="928" y="897"/>
                </a:lnTo>
                <a:lnTo>
                  <a:pt x="931" y="897"/>
                </a:lnTo>
                <a:lnTo>
                  <a:pt x="935" y="897"/>
                </a:lnTo>
                <a:lnTo>
                  <a:pt x="938" y="897"/>
                </a:lnTo>
                <a:lnTo>
                  <a:pt x="942" y="897"/>
                </a:lnTo>
                <a:lnTo>
                  <a:pt x="945" y="897"/>
                </a:lnTo>
                <a:lnTo>
                  <a:pt x="949" y="897"/>
                </a:lnTo>
                <a:lnTo>
                  <a:pt x="952" y="897"/>
                </a:lnTo>
                <a:lnTo>
                  <a:pt x="956" y="897"/>
                </a:lnTo>
                <a:lnTo>
                  <a:pt x="959" y="897"/>
                </a:lnTo>
                <a:lnTo>
                  <a:pt x="963" y="897"/>
                </a:lnTo>
                <a:lnTo>
                  <a:pt x="966" y="897"/>
                </a:lnTo>
                <a:lnTo>
                  <a:pt x="970" y="897"/>
                </a:lnTo>
                <a:lnTo>
                  <a:pt x="973" y="897"/>
                </a:lnTo>
                <a:lnTo>
                  <a:pt x="977" y="897"/>
                </a:lnTo>
                <a:lnTo>
                  <a:pt x="980" y="897"/>
                </a:lnTo>
                <a:lnTo>
                  <a:pt x="984" y="897"/>
                </a:lnTo>
                <a:lnTo>
                  <a:pt x="987" y="897"/>
                </a:lnTo>
                <a:lnTo>
                  <a:pt x="991" y="897"/>
                </a:lnTo>
                <a:lnTo>
                  <a:pt x="994" y="897"/>
                </a:lnTo>
                <a:lnTo>
                  <a:pt x="998" y="897"/>
                </a:lnTo>
                <a:lnTo>
                  <a:pt x="1001" y="897"/>
                </a:lnTo>
                <a:lnTo>
                  <a:pt x="1005" y="897"/>
                </a:lnTo>
                <a:lnTo>
                  <a:pt x="1008" y="897"/>
                </a:lnTo>
                <a:lnTo>
                  <a:pt x="1012" y="897"/>
                </a:lnTo>
                <a:lnTo>
                  <a:pt x="1015" y="897"/>
                </a:lnTo>
                <a:lnTo>
                  <a:pt x="1019" y="897"/>
                </a:lnTo>
                <a:lnTo>
                  <a:pt x="1022" y="897"/>
                </a:lnTo>
                <a:lnTo>
                  <a:pt x="1026" y="897"/>
                </a:lnTo>
                <a:lnTo>
                  <a:pt x="1029" y="897"/>
                </a:lnTo>
                <a:lnTo>
                  <a:pt x="1033" y="897"/>
                </a:lnTo>
                <a:lnTo>
                  <a:pt x="1036" y="897"/>
                </a:lnTo>
                <a:lnTo>
                  <a:pt x="1039" y="897"/>
                </a:lnTo>
                <a:lnTo>
                  <a:pt x="1043" y="897"/>
                </a:lnTo>
                <a:lnTo>
                  <a:pt x="1046" y="897"/>
                </a:lnTo>
                <a:lnTo>
                  <a:pt x="1050" y="897"/>
                </a:lnTo>
                <a:lnTo>
                  <a:pt x="1053" y="897"/>
                </a:lnTo>
                <a:lnTo>
                  <a:pt x="1057" y="897"/>
                </a:lnTo>
                <a:lnTo>
                  <a:pt x="1060" y="897"/>
                </a:lnTo>
                <a:lnTo>
                  <a:pt x="1064" y="897"/>
                </a:lnTo>
                <a:lnTo>
                  <a:pt x="1067" y="897"/>
                </a:lnTo>
                <a:lnTo>
                  <a:pt x="1071" y="897"/>
                </a:lnTo>
                <a:lnTo>
                  <a:pt x="1074" y="897"/>
                </a:lnTo>
                <a:lnTo>
                  <a:pt x="1078" y="897"/>
                </a:lnTo>
                <a:lnTo>
                  <a:pt x="1081" y="897"/>
                </a:lnTo>
                <a:lnTo>
                  <a:pt x="1085" y="897"/>
                </a:lnTo>
                <a:lnTo>
                  <a:pt x="1088" y="897"/>
                </a:lnTo>
                <a:lnTo>
                  <a:pt x="1092" y="897"/>
                </a:lnTo>
                <a:lnTo>
                  <a:pt x="1095" y="897"/>
                </a:lnTo>
                <a:lnTo>
                  <a:pt x="1099" y="897"/>
                </a:lnTo>
                <a:lnTo>
                  <a:pt x="1102" y="897"/>
                </a:lnTo>
                <a:lnTo>
                  <a:pt x="1106" y="897"/>
                </a:lnTo>
                <a:lnTo>
                  <a:pt x="1109" y="897"/>
                </a:lnTo>
                <a:lnTo>
                  <a:pt x="1113" y="897"/>
                </a:lnTo>
                <a:lnTo>
                  <a:pt x="1116" y="897"/>
                </a:lnTo>
                <a:lnTo>
                  <a:pt x="1120" y="897"/>
                </a:lnTo>
                <a:lnTo>
                  <a:pt x="1123" y="897"/>
                </a:lnTo>
                <a:lnTo>
                  <a:pt x="1127" y="897"/>
                </a:lnTo>
                <a:lnTo>
                  <a:pt x="1130" y="897"/>
                </a:lnTo>
                <a:lnTo>
                  <a:pt x="1134" y="897"/>
                </a:lnTo>
                <a:lnTo>
                  <a:pt x="1137" y="897"/>
                </a:lnTo>
                <a:lnTo>
                  <a:pt x="1141" y="897"/>
                </a:lnTo>
                <a:lnTo>
                  <a:pt x="1144" y="897"/>
                </a:lnTo>
                <a:lnTo>
                  <a:pt x="1148" y="897"/>
                </a:lnTo>
                <a:lnTo>
                  <a:pt x="1151" y="897"/>
                </a:lnTo>
                <a:lnTo>
                  <a:pt x="1155" y="897"/>
                </a:lnTo>
                <a:lnTo>
                  <a:pt x="1158" y="897"/>
                </a:lnTo>
                <a:lnTo>
                  <a:pt x="1162" y="897"/>
                </a:lnTo>
                <a:lnTo>
                  <a:pt x="1165" y="897"/>
                </a:lnTo>
                <a:lnTo>
                  <a:pt x="1169" y="897"/>
                </a:lnTo>
                <a:lnTo>
                  <a:pt x="1172" y="897"/>
                </a:lnTo>
                <a:lnTo>
                  <a:pt x="1176" y="897"/>
                </a:lnTo>
                <a:lnTo>
                  <a:pt x="1179" y="897"/>
                </a:lnTo>
                <a:lnTo>
                  <a:pt x="1183" y="897"/>
                </a:lnTo>
                <a:lnTo>
                  <a:pt x="1186" y="897"/>
                </a:lnTo>
                <a:lnTo>
                  <a:pt x="1190" y="897"/>
                </a:lnTo>
                <a:lnTo>
                  <a:pt x="1193" y="897"/>
                </a:lnTo>
                <a:lnTo>
                  <a:pt x="1196" y="897"/>
                </a:lnTo>
                <a:lnTo>
                  <a:pt x="1200" y="897"/>
                </a:lnTo>
                <a:lnTo>
                  <a:pt x="1203" y="897"/>
                </a:lnTo>
                <a:lnTo>
                  <a:pt x="1207" y="897"/>
                </a:lnTo>
                <a:lnTo>
                  <a:pt x="1210" y="897"/>
                </a:lnTo>
                <a:lnTo>
                  <a:pt x="1214" y="897"/>
                </a:lnTo>
                <a:lnTo>
                  <a:pt x="1217" y="897"/>
                </a:lnTo>
                <a:lnTo>
                  <a:pt x="1221" y="897"/>
                </a:lnTo>
                <a:lnTo>
                  <a:pt x="1224" y="897"/>
                </a:lnTo>
                <a:lnTo>
                  <a:pt x="1228" y="897"/>
                </a:lnTo>
                <a:lnTo>
                  <a:pt x="1231" y="897"/>
                </a:lnTo>
                <a:lnTo>
                  <a:pt x="1235" y="897"/>
                </a:lnTo>
                <a:lnTo>
                  <a:pt x="1238" y="897"/>
                </a:lnTo>
                <a:lnTo>
                  <a:pt x="1242" y="897"/>
                </a:lnTo>
                <a:lnTo>
                  <a:pt x="1245" y="897"/>
                </a:lnTo>
                <a:lnTo>
                  <a:pt x="1249" y="897"/>
                </a:lnTo>
                <a:lnTo>
                  <a:pt x="1252" y="897"/>
                </a:lnTo>
                <a:lnTo>
                  <a:pt x="1256" y="897"/>
                </a:lnTo>
                <a:lnTo>
                  <a:pt x="1259" y="897"/>
                </a:lnTo>
                <a:lnTo>
                  <a:pt x="1263" y="897"/>
                </a:lnTo>
                <a:lnTo>
                  <a:pt x="1266" y="897"/>
                </a:lnTo>
                <a:lnTo>
                  <a:pt x="1270" y="897"/>
                </a:lnTo>
                <a:lnTo>
                  <a:pt x="1273" y="897"/>
                </a:lnTo>
                <a:lnTo>
                  <a:pt x="1277" y="897"/>
                </a:lnTo>
                <a:lnTo>
                  <a:pt x="1280" y="897"/>
                </a:lnTo>
                <a:lnTo>
                  <a:pt x="1284" y="897"/>
                </a:lnTo>
                <a:lnTo>
                  <a:pt x="1287" y="897"/>
                </a:lnTo>
                <a:lnTo>
                  <a:pt x="1291" y="897"/>
                </a:lnTo>
                <a:lnTo>
                  <a:pt x="1294" y="897"/>
                </a:lnTo>
                <a:lnTo>
                  <a:pt x="1298" y="897"/>
                </a:lnTo>
                <a:lnTo>
                  <a:pt x="1301" y="897"/>
                </a:lnTo>
                <a:lnTo>
                  <a:pt x="1305" y="897"/>
                </a:lnTo>
                <a:lnTo>
                  <a:pt x="1308" y="897"/>
                </a:lnTo>
                <a:lnTo>
                  <a:pt x="1312" y="897"/>
                </a:lnTo>
                <a:lnTo>
                  <a:pt x="1315" y="897"/>
                </a:lnTo>
                <a:lnTo>
                  <a:pt x="1319" y="897"/>
                </a:lnTo>
                <a:lnTo>
                  <a:pt x="1322" y="897"/>
                </a:lnTo>
                <a:lnTo>
                  <a:pt x="1326" y="897"/>
                </a:lnTo>
                <a:lnTo>
                  <a:pt x="1329" y="897"/>
                </a:lnTo>
                <a:lnTo>
                  <a:pt x="1333" y="897"/>
                </a:lnTo>
                <a:lnTo>
                  <a:pt x="1336" y="897"/>
                </a:lnTo>
                <a:lnTo>
                  <a:pt x="1340" y="897"/>
                </a:lnTo>
                <a:lnTo>
                  <a:pt x="1343" y="897"/>
                </a:lnTo>
                <a:lnTo>
                  <a:pt x="1346" y="897"/>
                </a:lnTo>
                <a:lnTo>
                  <a:pt x="1350" y="897"/>
                </a:lnTo>
                <a:lnTo>
                  <a:pt x="1353" y="897"/>
                </a:lnTo>
                <a:lnTo>
                  <a:pt x="1357" y="897"/>
                </a:lnTo>
                <a:lnTo>
                  <a:pt x="1360" y="897"/>
                </a:lnTo>
                <a:lnTo>
                  <a:pt x="1364" y="897"/>
                </a:lnTo>
                <a:lnTo>
                  <a:pt x="1367" y="897"/>
                </a:lnTo>
                <a:lnTo>
                  <a:pt x="1371" y="897"/>
                </a:lnTo>
                <a:lnTo>
                  <a:pt x="1374" y="897"/>
                </a:lnTo>
                <a:lnTo>
                  <a:pt x="1378" y="897"/>
                </a:lnTo>
                <a:lnTo>
                  <a:pt x="1381" y="897"/>
                </a:lnTo>
                <a:lnTo>
                  <a:pt x="1385" y="897"/>
                </a:lnTo>
                <a:lnTo>
                  <a:pt x="1388" y="897"/>
                </a:lnTo>
                <a:lnTo>
                  <a:pt x="1392" y="897"/>
                </a:lnTo>
                <a:lnTo>
                  <a:pt x="1395" y="897"/>
                </a:lnTo>
                <a:lnTo>
                  <a:pt x="1399" y="897"/>
                </a:lnTo>
                <a:lnTo>
                  <a:pt x="1402" y="897"/>
                </a:lnTo>
                <a:lnTo>
                  <a:pt x="1406" y="897"/>
                </a:lnTo>
                <a:lnTo>
                  <a:pt x="1409" y="897"/>
                </a:lnTo>
                <a:lnTo>
                  <a:pt x="1413" y="897"/>
                </a:lnTo>
                <a:lnTo>
                  <a:pt x="1416" y="897"/>
                </a:lnTo>
                <a:lnTo>
                  <a:pt x="1420" y="897"/>
                </a:lnTo>
                <a:lnTo>
                  <a:pt x="1423" y="897"/>
                </a:lnTo>
                <a:lnTo>
                  <a:pt x="1427" y="897"/>
                </a:lnTo>
                <a:lnTo>
                  <a:pt x="1430" y="897"/>
                </a:lnTo>
                <a:lnTo>
                  <a:pt x="1434" y="897"/>
                </a:lnTo>
                <a:lnTo>
                  <a:pt x="1437" y="897"/>
                </a:lnTo>
                <a:lnTo>
                  <a:pt x="1441" y="897"/>
                </a:lnTo>
                <a:lnTo>
                  <a:pt x="1444" y="897"/>
                </a:lnTo>
                <a:lnTo>
                  <a:pt x="1448" y="897"/>
                </a:lnTo>
                <a:lnTo>
                  <a:pt x="1451" y="897"/>
                </a:lnTo>
                <a:lnTo>
                  <a:pt x="1455" y="897"/>
                </a:lnTo>
                <a:lnTo>
                  <a:pt x="1458" y="897"/>
                </a:lnTo>
                <a:lnTo>
                  <a:pt x="1462" y="897"/>
                </a:lnTo>
                <a:lnTo>
                  <a:pt x="1465" y="897"/>
                </a:lnTo>
                <a:lnTo>
                  <a:pt x="1469" y="897"/>
                </a:lnTo>
                <a:lnTo>
                  <a:pt x="1472" y="897"/>
                </a:lnTo>
                <a:lnTo>
                  <a:pt x="1476" y="897"/>
                </a:lnTo>
                <a:lnTo>
                  <a:pt x="1479" y="897"/>
                </a:lnTo>
                <a:lnTo>
                  <a:pt x="1483" y="897"/>
                </a:lnTo>
                <a:lnTo>
                  <a:pt x="1486" y="897"/>
                </a:lnTo>
                <a:lnTo>
                  <a:pt x="1490" y="897"/>
                </a:lnTo>
                <a:lnTo>
                  <a:pt x="1493" y="897"/>
                </a:lnTo>
                <a:lnTo>
                  <a:pt x="1497" y="897"/>
                </a:lnTo>
                <a:lnTo>
                  <a:pt x="1500" y="897"/>
                </a:lnTo>
                <a:lnTo>
                  <a:pt x="1503" y="897"/>
                </a:lnTo>
                <a:lnTo>
                  <a:pt x="1507" y="897"/>
                </a:lnTo>
                <a:lnTo>
                  <a:pt x="1510" y="897"/>
                </a:lnTo>
                <a:lnTo>
                  <a:pt x="1514" y="897"/>
                </a:lnTo>
                <a:lnTo>
                  <a:pt x="1517" y="897"/>
                </a:lnTo>
                <a:lnTo>
                  <a:pt x="1521" y="897"/>
                </a:lnTo>
                <a:lnTo>
                  <a:pt x="1524" y="897"/>
                </a:lnTo>
                <a:lnTo>
                  <a:pt x="1528" y="897"/>
                </a:lnTo>
                <a:lnTo>
                  <a:pt x="1531" y="897"/>
                </a:lnTo>
                <a:lnTo>
                  <a:pt x="1535" y="897"/>
                </a:lnTo>
                <a:lnTo>
                  <a:pt x="1538" y="897"/>
                </a:lnTo>
                <a:lnTo>
                  <a:pt x="1542" y="897"/>
                </a:lnTo>
                <a:lnTo>
                  <a:pt x="1545" y="897"/>
                </a:lnTo>
                <a:lnTo>
                  <a:pt x="1549" y="897"/>
                </a:lnTo>
                <a:lnTo>
                  <a:pt x="1552" y="897"/>
                </a:lnTo>
                <a:lnTo>
                  <a:pt x="1556" y="897"/>
                </a:lnTo>
                <a:lnTo>
                  <a:pt x="1559" y="897"/>
                </a:lnTo>
                <a:lnTo>
                  <a:pt x="1563" y="897"/>
                </a:lnTo>
                <a:lnTo>
                  <a:pt x="1566" y="897"/>
                </a:lnTo>
                <a:lnTo>
                  <a:pt x="1570" y="897"/>
                </a:lnTo>
                <a:lnTo>
                  <a:pt x="1573" y="897"/>
                </a:lnTo>
                <a:lnTo>
                  <a:pt x="1577" y="897"/>
                </a:lnTo>
                <a:lnTo>
                  <a:pt x="1580" y="897"/>
                </a:lnTo>
                <a:lnTo>
                  <a:pt x="1584" y="897"/>
                </a:lnTo>
                <a:lnTo>
                  <a:pt x="1587" y="897"/>
                </a:lnTo>
                <a:lnTo>
                  <a:pt x="1591" y="897"/>
                </a:lnTo>
                <a:lnTo>
                  <a:pt x="1594" y="897"/>
                </a:lnTo>
                <a:lnTo>
                  <a:pt x="1598" y="897"/>
                </a:lnTo>
                <a:lnTo>
                  <a:pt x="1601" y="897"/>
                </a:lnTo>
                <a:lnTo>
                  <a:pt x="1605" y="897"/>
                </a:lnTo>
                <a:lnTo>
                  <a:pt x="1608" y="897"/>
                </a:lnTo>
                <a:lnTo>
                  <a:pt x="1612" y="897"/>
                </a:lnTo>
                <a:lnTo>
                  <a:pt x="1615" y="897"/>
                </a:lnTo>
                <a:lnTo>
                  <a:pt x="1619" y="897"/>
                </a:lnTo>
                <a:lnTo>
                  <a:pt x="1622" y="897"/>
                </a:lnTo>
                <a:lnTo>
                  <a:pt x="1626" y="897"/>
                </a:lnTo>
                <a:lnTo>
                  <a:pt x="1629" y="897"/>
                </a:lnTo>
                <a:lnTo>
                  <a:pt x="1633" y="897"/>
                </a:lnTo>
                <a:lnTo>
                  <a:pt x="1636" y="897"/>
                </a:lnTo>
                <a:lnTo>
                  <a:pt x="1640" y="897"/>
                </a:lnTo>
                <a:lnTo>
                  <a:pt x="1643" y="897"/>
                </a:lnTo>
                <a:lnTo>
                  <a:pt x="1647" y="897"/>
                </a:lnTo>
                <a:lnTo>
                  <a:pt x="1650" y="897"/>
                </a:lnTo>
                <a:lnTo>
                  <a:pt x="1653" y="897"/>
                </a:lnTo>
                <a:lnTo>
                  <a:pt x="1657" y="897"/>
                </a:lnTo>
                <a:lnTo>
                  <a:pt x="1660" y="897"/>
                </a:lnTo>
                <a:lnTo>
                  <a:pt x="1664" y="897"/>
                </a:lnTo>
                <a:lnTo>
                  <a:pt x="1667" y="897"/>
                </a:lnTo>
                <a:lnTo>
                  <a:pt x="1671" y="897"/>
                </a:lnTo>
                <a:lnTo>
                  <a:pt x="1674" y="897"/>
                </a:lnTo>
                <a:lnTo>
                  <a:pt x="1678" y="897"/>
                </a:lnTo>
                <a:lnTo>
                  <a:pt x="1681" y="897"/>
                </a:lnTo>
                <a:lnTo>
                  <a:pt x="1685" y="897"/>
                </a:lnTo>
                <a:lnTo>
                  <a:pt x="1688" y="897"/>
                </a:lnTo>
                <a:lnTo>
                  <a:pt x="1692" y="897"/>
                </a:lnTo>
                <a:lnTo>
                  <a:pt x="1695" y="897"/>
                </a:lnTo>
                <a:lnTo>
                  <a:pt x="1699" y="897"/>
                </a:lnTo>
                <a:lnTo>
                  <a:pt x="1702" y="897"/>
                </a:lnTo>
                <a:lnTo>
                  <a:pt x="1706" y="897"/>
                </a:lnTo>
                <a:lnTo>
                  <a:pt x="1709" y="897"/>
                </a:lnTo>
                <a:lnTo>
                  <a:pt x="1713" y="897"/>
                </a:lnTo>
                <a:lnTo>
                  <a:pt x="1716" y="897"/>
                </a:lnTo>
                <a:lnTo>
                  <a:pt x="1720" y="897"/>
                </a:lnTo>
                <a:lnTo>
                  <a:pt x="1723" y="897"/>
                </a:lnTo>
                <a:lnTo>
                  <a:pt x="1727" y="897"/>
                </a:lnTo>
                <a:lnTo>
                  <a:pt x="1730" y="897"/>
                </a:lnTo>
                <a:lnTo>
                  <a:pt x="1734" y="897"/>
                </a:lnTo>
                <a:lnTo>
                  <a:pt x="1737" y="897"/>
                </a:lnTo>
                <a:lnTo>
                  <a:pt x="1741" y="897"/>
                </a:lnTo>
                <a:lnTo>
                  <a:pt x="1744" y="897"/>
                </a:lnTo>
                <a:lnTo>
                  <a:pt x="1748" y="897"/>
                </a:lnTo>
                <a:lnTo>
                  <a:pt x="1751" y="897"/>
                </a:lnTo>
                <a:lnTo>
                  <a:pt x="1755" y="897"/>
                </a:lnTo>
                <a:lnTo>
                  <a:pt x="1758" y="897"/>
                </a:lnTo>
                <a:lnTo>
                  <a:pt x="1762" y="897"/>
                </a:lnTo>
                <a:lnTo>
                  <a:pt x="1765" y="897"/>
                </a:lnTo>
                <a:lnTo>
                  <a:pt x="1769" y="897"/>
                </a:lnTo>
                <a:lnTo>
                  <a:pt x="1772" y="897"/>
                </a:lnTo>
                <a:lnTo>
                  <a:pt x="1776" y="897"/>
                </a:lnTo>
                <a:lnTo>
                  <a:pt x="1779" y="897"/>
                </a:lnTo>
                <a:lnTo>
                  <a:pt x="1783" y="897"/>
                </a:lnTo>
                <a:lnTo>
                  <a:pt x="1786" y="897"/>
                </a:lnTo>
                <a:lnTo>
                  <a:pt x="1790" y="897"/>
                </a:lnTo>
                <a:lnTo>
                  <a:pt x="1793" y="897"/>
                </a:lnTo>
                <a:lnTo>
                  <a:pt x="1797" y="897"/>
                </a:lnTo>
                <a:lnTo>
                  <a:pt x="1800" y="897"/>
                </a:lnTo>
                <a:lnTo>
                  <a:pt x="1803" y="897"/>
                </a:lnTo>
                <a:lnTo>
                  <a:pt x="1807" y="897"/>
                </a:lnTo>
                <a:lnTo>
                  <a:pt x="1810" y="897"/>
                </a:lnTo>
                <a:lnTo>
                  <a:pt x="1814" y="897"/>
                </a:lnTo>
                <a:lnTo>
                  <a:pt x="1817" y="897"/>
                </a:lnTo>
                <a:lnTo>
                  <a:pt x="1821" y="897"/>
                </a:lnTo>
                <a:lnTo>
                  <a:pt x="1824" y="897"/>
                </a:lnTo>
                <a:lnTo>
                  <a:pt x="1828" y="897"/>
                </a:lnTo>
                <a:lnTo>
                  <a:pt x="1831" y="897"/>
                </a:lnTo>
                <a:lnTo>
                  <a:pt x="1835" y="897"/>
                </a:lnTo>
                <a:lnTo>
                  <a:pt x="1838" y="897"/>
                </a:lnTo>
                <a:lnTo>
                  <a:pt x="1842" y="897"/>
                </a:lnTo>
                <a:lnTo>
                  <a:pt x="1845" y="897"/>
                </a:lnTo>
                <a:lnTo>
                  <a:pt x="1849" y="897"/>
                </a:lnTo>
                <a:lnTo>
                  <a:pt x="1852" y="892"/>
                </a:lnTo>
                <a:lnTo>
                  <a:pt x="1856" y="892"/>
                </a:lnTo>
                <a:lnTo>
                  <a:pt x="1859" y="892"/>
                </a:lnTo>
                <a:lnTo>
                  <a:pt x="1863" y="892"/>
                </a:lnTo>
                <a:lnTo>
                  <a:pt x="1866" y="892"/>
                </a:lnTo>
                <a:lnTo>
                  <a:pt x="1870" y="892"/>
                </a:lnTo>
                <a:lnTo>
                  <a:pt x="1873" y="892"/>
                </a:lnTo>
                <a:lnTo>
                  <a:pt x="1877" y="887"/>
                </a:lnTo>
                <a:lnTo>
                  <a:pt x="1880" y="863"/>
                </a:lnTo>
                <a:lnTo>
                  <a:pt x="1880" y="804"/>
                </a:lnTo>
                <a:lnTo>
                  <a:pt x="1880" y="863"/>
                </a:lnTo>
                <a:lnTo>
                  <a:pt x="1880" y="804"/>
                </a:lnTo>
                <a:lnTo>
                  <a:pt x="1884" y="674"/>
                </a:lnTo>
                <a:lnTo>
                  <a:pt x="1887" y="494"/>
                </a:lnTo>
                <a:lnTo>
                  <a:pt x="1891" y="300"/>
                </a:lnTo>
                <a:lnTo>
                  <a:pt x="1894" y="160"/>
                </a:lnTo>
                <a:lnTo>
                  <a:pt x="1898" y="43"/>
                </a:lnTo>
                <a:lnTo>
                  <a:pt x="1901" y="33"/>
                </a:lnTo>
                <a:lnTo>
                  <a:pt x="1901" y="0"/>
                </a:lnTo>
                <a:lnTo>
                  <a:pt x="1901" y="33"/>
                </a:lnTo>
                <a:lnTo>
                  <a:pt x="1901" y="0"/>
                </a:lnTo>
                <a:lnTo>
                  <a:pt x="1905" y="92"/>
                </a:lnTo>
                <a:lnTo>
                  <a:pt x="1908" y="160"/>
                </a:lnTo>
                <a:lnTo>
                  <a:pt x="1912" y="310"/>
                </a:lnTo>
                <a:lnTo>
                  <a:pt x="1915" y="407"/>
                </a:lnTo>
                <a:lnTo>
                  <a:pt x="1919" y="528"/>
                </a:lnTo>
                <a:lnTo>
                  <a:pt x="1922" y="601"/>
                </a:lnTo>
                <a:lnTo>
                  <a:pt x="1922" y="693"/>
                </a:lnTo>
                <a:lnTo>
                  <a:pt x="1926" y="737"/>
                </a:lnTo>
                <a:lnTo>
                  <a:pt x="1929" y="775"/>
                </a:lnTo>
                <a:lnTo>
                  <a:pt x="1933" y="804"/>
                </a:lnTo>
                <a:lnTo>
                  <a:pt x="1936" y="819"/>
                </a:lnTo>
                <a:lnTo>
                  <a:pt x="1940" y="824"/>
                </a:lnTo>
                <a:lnTo>
                  <a:pt x="1943" y="838"/>
                </a:lnTo>
                <a:lnTo>
                  <a:pt x="1943" y="843"/>
                </a:lnTo>
                <a:lnTo>
                  <a:pt x="1947" y="853"/>
                </a:lnTo>
                <a:lnTo>
                  <a:pt x="1950" y="858"/>
                </a:lnTo>
                <a:lnTo>
                  <a:pt x="1954" y="863"/>
                </a:lnTo>
                <a:lnTo>
                  <a:pt x="1957" y="863"/>
                </a:lnTo>
                <a:lnTo>
                  <a:pt x="1960" y="868"/>
                </a:lnTo>
                <a:lnTo>
                  <a:pt x="1964" y="868"/>
                </a:lnTo>
                <a:lnTo>
                  <a:pt x="1964" y="872"/>
                </a:lnTo>
                <a:lnTo>
                  <a:pt x="1967" y="872"/>
                </a:lnTo>
                <a:lnTo>
                  <a:pt x="1971" y="877"/>
                </a:lnTo>
                <a:lnTo>
                  <a:pt x="1974" y="877"/>
                </a:lnTo>
                <a:lnTo>
                  <a:pt x="1978" y="877"/>
                </a:lnTo>
                <a:lnTo>
                  <a:pt x="1981" y="877"/>
                </a:lnTo>
                <a:lnTo>
                  <a:pt x="1985" y="882"/>
                </a:lnTo>
                <a:lnTo>
                  <a:pt x="1988" y="882"/>
                </a:lnTo>
                <a:lnTo>
                  <a:pt x="1992" y="882"/>
                </a:lnTo>
                <a:lnTo>
                  <a:pt x="1995" y="882"/>
                </a:lnTo>
                <a:lnTo>
                  <a:pt x="1999" y="882"/>
                </a:lnTo>
                <a:lnTo>
                  <a:pt x="2002" y="882"/>
                </a:lnTo>
                <a:lnTo>
                  <a:pt x="2006" y="882"/>
                </a:lnTo>
                <a:lnTo>
                  <a:pt x="2006" y="887"/>
                </a:lnTo>
                <a:lnTo>
                  <a:pt x="2009" y="887"/>
                </a:lnTo>
                <a:lnTo>
                  <a:pt x="2013" y="887"/>
                </a:lnTo>
                <a:lnTo>
                  <a:pt x="2016" y="887"/>
                </a:lnTo>
                <a:lnTo>
                  <a:pt x="2020" y="892"/>
                </a:lnTo>
                <a:lnTo>
                  <a:pt x="2023" y="887"/>
                </a:lnTo>
                <a:lnTo>
                  <a:pt x="2027" y="892"/>
                </a:lnTo>
                <a:lnTo>
                  <a:pt x="2027" y="887"/>
                </a:lnTo>
                <a:lnTo>
                  <a:pt x="2027" y="892"/>
                </a:lnTo>
                <a:lnTo>
                  <a:pt x="2027" y="887"/>
                </a:lnTo>
                <a:lnTo>
                  <a:pt x="2030" y="892"/>
                </a:lnTo>
                <a:lnTo>
                  <a:pt x="2034" y="887"/>
                </a:lnTo>
                <a:lnTo>
                  <a:pt x="2037" y="892"/>
                </a:lnTo>
                <a:lnTo>
                  <a:pt x="2041" y="892"/>
                </a:lnTo>
                <a:lnTo>
                  <a:pt x="2044" y="892"/>
                </a:lnTo>
                <a:lnTo>
                  <a:pt x="2048" y="892"/>
                </a:lnTo>
                <a:lnTo>
                  <a:pt x="2051" y="892"/>
                </a:lnTo>
                <a:lnTo>
                  <a:pt x="2055" y="892"/>
                </a:lnTo>
                <a:lnTo>
                  <a:pt x="2058" y="887"/>
                </a:lnTo>
                <a:lnTo>
                  <a:pt x="2062" y="892"/>
                </a:lnTo>
                <a:lnTo>
                  <a:pt x="2065" y="892"/>
                </a:lnTo>
                <a:lnTo>
                  <a:pt x="2069" y="892"/>
                </a:lnTo>
                <a:lnTo>
                  <a:pt x="2072" y="892"/>
                </a:lnTo>
                <a:lnTo>
                  <a:pt x="2076" y="892"/>
                </a:lnTo>
                <a:lnTo>
                  <a:pt x="2079" y="892"/>
                </a:lnTo>
                <a:lnTo>
                  <a:pt x="2083" y="892"/>
                </a:lnTo>
                <a:lnTo>
                  <a:pt x="2086" y="892"/>
                </a:lnTo>
                <a:lnTo>
                  <a:pt x="2090" y="892"/>
                </a:lnTo>
                <a:lnTo>
                  <a:pt x="2093" y="892"/>
                </a:lnTo>
                <a:lnTo>
                  <a:pt x="2097" y="892"/>
                </a:lnTo>
                <a:lnTo>
                  <a:pt x="2100" y="892"/>
                </a:lnTo>
                <a:lnTo>
                  <a:pt x="2104" y="892"/>
                </a:lnTo>
                <a:lnTo>
                  <a:pt x="2107" y="892"/>
                </a:lnTo>
                <a:lnTo>
                  <a:pt x="2110" y="892"/>
                </a:lnTo>
                <a:lnTo>
                  <a:pt x="2114" y="892"/>
                </a:lnTo>
                <a:lnTo>
                  <a:pt x="2117" y="892"/>
                </a:lnTo>
                <a:lnTo>
                  <a:pt x="2121" y="892"/>
                </a:lnTo>
                <a:lnTo>
                  <a:pt x="2124" y="892"/>
                </a:lnTo>
                <a:lnTo>
                  <a:pt x="2128" y="892"/>
                </a:lnTo>
                <a:lnTo>
                  <a:pt x="2131" y="892"/>
                </a:lnTo>
                <a:lnTo>
                  <a:pt x="2135" y="892"/>
                </a:lnTo>
                <a:lnTo>
                  <a:pt x="2138" y="892"/>
                </a:lnTo>
                <a:lnTo>
                  <a:pt x="2142" y="892"/>
                </a:lnTo>
                <a:lnTo>
                  <a:pt x="2145" y="892"/>
                </a:lnTo>
                <a:lnTo>
                  <a:pt x="2149" y="892"/>
                </a:lnTo>
                <a:lnTo>
                  <a:pt x="2152" y="892"/>
                </a:lnTo>
                <a:lnTo>
                  <a:pt x="2156" y="892"/>
                </a:lnTo>
                <a:lnTo>
                  <a:pt x="2159" y="892"/>
                </a:lnTo>
                <a:lnTo>
                  <a:pt x="2163" y="892"/>
                </a:lnTo>
                <a:lnTo>
                  <a:pt x="2166" y="892"/>
                </a:lnTo>
                <a:lnTo>
                  <a:pt x="2170" y="892"/>
                </a:lnTo>
                <a:lnTo>
                  <a:pt x="2173" y="892"/>
                </a:lnTo>
                <a:lnTo>
                  <a:pt x="2177" y="892"/>
                </a:lnTo>
                <a:lnTo>
                  <a:pt x="2180" y="892"/>
                </a:lnTo>
                <a:lnTo>
                  <a:pt x="2184" y="892"/>
                </a:lnTo>
                <a:lnTo>
                  <a:pt x="2187" y="892"/>
                </a:lnTo>
                <a:lnTo>
                  <a:pt x="2191" y="892"/>
                </a:lnTo>
                <a:lnTo>
                  <a:pt x="2194" y="892"/>
                </a:lnTo>
                <a:lnTo>
                  <a:pt x="2198" y="892"/>
                </a:lnTo>
                <a:lnTo>
                  <a:pt x="2201" y="892"/>
                </a:lnTo>
                <a:lnTo>
                  <a:pt x="2205" y="892"/>
                </a:lnTo>
                <a:lnTo>
                  <a:pt x="2208" y="892"/>
                </a:lnTo>
                <a:lnTo>
                  <a:pt x="2212" y="892"/>
                </a:lnTo>
                <a:lnTo>
                  <a:pt x="2215" y="892"/>
                </a:lnTo>
                <a:lnTo>
                  <a:pt x="2219" y="892"/>
                </a:lnTo>
                <a:lnTo>
                  <a:pt x="2222" y="892"/>
                </a:lnTo>
                <a:lnTo>
                  <a:pt x="2226" y="892"/>
                </a:lnTo>
                <a:lnTo>
                  <a:pt x="2229" y="892"/>
                </a:lnTo>
                <a:lnTo>
                  <a:pt x="2233" y="892"/>
                </a:lnTo>
                <a:lnTo>
                  <a:pt x="2236" y="892"/>
                </a:lnTo>
                <a:lnTo>
                  <a:pt x="2240" y="892"/>
                </a:lnTo>
                <a:lnTo>
                  <a:pt x="2243" y="892"/>
                </a:lnTo>
                <a:lnTo>
                  <a:pt x="2247" y="892"/>
                </a:lnTo>
                <a:lnTo>
                  <a:pt x="2250" y="892"/>
                </a:lnTo>
                <a:lnTo>
                  <a:pt x="2254" y="892"/>
                </a:lnTo>
                <a:lnTo>
                  <a:pt x="2257" y="892"/>
                </a:lnTo>
                <a:lnTo>
                  <a:pt x="2261" y="897"/>
                </a:lnTo>
                <a:lnTo>
                  <a:pt x="2264" y="892"/>
                </a:lnTo>
                <a:lnTo>
                  <a:pt x="2267" y="897"/>
                </a:lnTo>
                <a:lnTo>
                  <a:pt x="2271" y="892"/>
                </a:lnTo>
                <a:lnTo>
                  <a:pt x="2274" y="892"/>
                </a:lnTo>
                <a:lnTo>
                  <a:pt x="2278" y="897"/>
                </a:lnTo>
                <a:lnTo>
                  <a:pt x="2278" y="892"/>
                </a:lnTo>
                <a:lnTo>
                  <a:pt x="2278" y="897"/>
                </a:lnTo>
                <a:lnTo>
                  <a:pt x="2278" y="892"/>
                </a:lnTo>
                <a:lnTo>
                  <a:pt x="2281" y="892"/>
                </a:lnTo>
                <a:lnTo>
                  <a:pt x="2285" y="897"/>
                </a:lnTo>
                <a:lnTo>
                  <a:pt x="2288" y="897"/>
                </a:lnTo>
                <a:lnTo>
                  <a:pt x="2292" y="897"/>
                </a:lnTo>
                <a:lnTo>
                  <a:pt x="2295" y="897"/>
                </a:lnTo>
                <a:lnTo>
                  <a:pt x="2299" y="897"/>
                </a:lnTo>
                <a:lnTo>
                  <a:pt x="2302" y="892"/>
                </a:lnTo>
                <a:lnTo>
                  <a:pt x="2306" y="897"/>
                </a:lnTo>
                <a:lnTo>
                  <a:pt x="2309" y="897"/>
                </a:lnTo>
                <a:lnTo>
                  <a:pt x="2313" y="897"/>
                </a:lnTo>
                <a:lnTo>
                  <a:pt x="2316" y="897"/>
                </a:lnTo>
                <a:lnTo>
                  <a:pt x="2320" y="892"/>
                </a:lnTo>
                <a:lnTo>
                  <a:pt x="2320" y="897"/>
                </a:lnTo>
                <a:lnTo>
                  <a:pt x="2323" y="897"/>
                </a:lnTo>
                <a:lnTo>
                  <a:pt x="2327" y="897"/>
                </a:lnTo>
                <a:lnTo>
                  <a:pt x="2330" y="897"/>
                </a:lnTo>
                <a:lnTo>
                  <a:pt x="2334" y="897"/>
                </a:lnTo>
                <a:lnTo>
                  <a:pt x="2337" y="897"/>
                </a:lnTo>
                <a:lnTo>
                  <a:pt x="2341" y="897"/>
                </a:lnTo>
                <a:lnTo>
                  <a:pt x="2344" y="897"/>
                </a:lnTo>
                <a:lnTo>
                  <a:pt x="2348" y="897"/>
                </a:lnTo>
                <a:lnTo>
                  <a:pt x="2351" y="897"/>
                </a:lnTo>
                <a:lnTo>
                  <a:pt x="2355" y="897"/>
                </a:lnTo>
                <a:lnTo>
                  <a:pt x="2358" y="897"/>
                </a:lnTo>
                <a:lnTo>
                  <a:pt x="2362" y="897"/>
                </a:lnTo>
                <a:lnTo>
                  <a:pt x="2365" y="897"/>
                </a:lnTo>
                <a:lnTo>
                  <a:pt x="2369" y="897"/>
                </a:lnTo>
                <a:lnTo>
                  <a:pt x="2372" y="897"/>
                </a:lnTo>
                <a:lnTo>
                  <a:pt x="2376" y="897"/>
                </a:lnTo>
                <a:lnTo>
                  <a:pt x="2379" y="897"/>
                </a:lnTo>
                <a:lnTo>
                  <a:pt x="2383" y="897"/>
                </a:lnTo>
                <a:lnTo>
                  <a:pt x="2386" y="897"/>
                </a:lnTo>
                <a:lnTo>
                  <a:pt x="2390" y="897"/>
                </a:lnTo>
                <a:lnTo>
                  <a:pt x="2393" y="897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2059" name="Rectangle 70"/>
          <p:cNvSpPr>
            <a:spLocks noChangeArrowheads="1"/>
          </p:cNvSpPr>
          <p:nvPr/>
        </p:nvSpPr>
        <p:spPr bwMode="auto">
          <a:xfrm>
            <a:off x="4742375" y="4374013"/>
            <a:ext cx="43922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800" dirty="0" smtClean="0">
                <a:solidFill>
                  <a:srgbClr val="000000"/>
                </a:solidFill>
                <a:latin typeface="Cambria" panose="02040503050406030204" pitchFamily="18" charset="0"/>
              </a:rPr>
              <a:t>1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2.24 min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2061" name="Rectangle 72"/>
          <p:cNvSpPr>
            <a:spLocks noChangeArrowheads="1"/>
          </p:cNvSpPr>
          <p:nvPr/>
        </p:nvSpPr>
        <p:spPr bwMode="auto">
          <a:xfrm>
            <a:off x="1898650" y="4169794"/>
            <a:ext cx="3811588" cy="1785938"/>
          </a:xfrm>
          <a:prstGeom prst="rect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82" name="Rectangle 30"/>
          <p:cNvSpPr>
            <a:spLocks noChangeArrowheads="1"/>
          </p:cNvSpPr>
          <p:nvPr/>
        </p:nvSpPr>
        <p:spPr bwMode="auto">
          <a:xfrm rot="16200000">
            <a:off x="1422961" y="5012993"/>
            <a:ext cx="3943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</a:rPr>
              <a:t>Intensity</a:t>
            </a:r>
          </a:p>
        </p:txBody>
      </p:sp>
      <p:sp>
        <p:nvSpPr>
          <p:cNvPr id="81" name="Freeform 141"/>
          <p:cNvSpPr>
            <a:spLocks/>
          </p:cNvSpPr>
          <p:nvPr/>
        </p:nvSpPr>
        <p:spPr bwMode="auto">
          <a:xfrm>
            <a:off x="2106613" y="4522325"/>
            <a:ext cx="1566863" cy="926953"/>
          </a:xfrm>
          <a:custGeom>
            <a:avLst/>
            <a:gdLst>
              <a:gd name="T0" fmla="*/ 16 w 987"/>
              <a:gd name="T1" fmla="*/ 524 h 524"/>
              <a:gd name="T2" fmla="*/ 33 w 987"/>
              <a:gd name="T3" fmla="*/ 524 h 524"/>
              <a:gd name="T4" fmla="*/ 50 w 987"/>
              <a:gd name="T5" fmla="*/ 524 h 524"/>
              <a:gd name="T6" fmla="*/ 55 w 987"/>
              <a:gd name="T7" fmla="*/ 0 h 524"/>
              <a:gd name="T8" fmla="*/ 63 w 987"/>
              <a:gd name="T9" fmla="*/ 500 h 524"/>
              <a:gd name="T10" fmla="*/ 78 w 987"/>
              <a:gd name="T11" fmla="*/ 521 h 524"/>
              <a:gd name="T12" fmla="*/ 95 w 987"/>
              <a:gd name="T13" fmla="*/ 521 h 524"/>
              <a:gd name="T14" fmla="*/ 112 w 987"/>
              <a:gd name="T15" fmla="*/ 521 h 524"/>
              <a:gd name="T16" fmla="*/ 121 w 987"/>
              <a:gd name="T17" fmla="*/ 439 h 524"/>
              <a:gd name="T18" fmla="*/ 131 w 987"/>
              <a:gd name="T19" fmla="*/ 521 h 524"/>
              <a:gd name="T20" fmla="*/ 148 w 987"/>
              <a:gd name="T21" fmla="*/ 521 h 524"/>
              <a:gd name="T22" fmla="*/ 158 w 987"/>
              <a:gd name="T23" fmla="*/ 524 h 524"/>
              <a:gd name="T24" fmla="*/ 175 w 987"/>
              <a:gd name="T25" fmla="*/ 524 h 524"/>
              <a:gd name="T26" fmla="*/ 184 w 987"/>
              <a:gd name="T27" fmla="*/ 512 h 524"/>
              <a:gd name="T28" fmla="*/ 200 w 987"/>
              <a:gd name="T29" fmla="*/ 524 h 524"/>
              <a:gd name="T30" fmla="*/ 217 w 987"/>
              <a:gd name="T31" fmla="*/ 524 h 524"/>
              <a:gd name="T32" fmla="*/ 234 w 987"/>
              <a:gd name="T33" fmla="*/ 524 h 524"/>
              <a:gd name="T34" fmla="*/ 250 w 987"/>
              <a:gd name="T35" fmla="*/ 521 h 524"/>
              <a:gd name="T36" fmla="*/ 263 w 987"/>
              <a:gd name="T37" fmla="*/ 524 h 524"/>
              <a:gd name="T38" fmla="*/ 280 w 987"/>
              <a:gd name="T39" fmla="*/ 524 h 524"/>
              <a:gd name="T40" fmla="*/ 297 w 987"/>
              <a:gd name="T41" fmla="*/ 524 h 524"/>
              <a:gd name="T42" fmla="*/ 315 w 987"/>
              <a:gd name="T43" fmla="*/ 524 h 524"/>
              <a:gd name="T44" fmla="*/ 332 w 987"/>
              <a:gd name="T45" fmla="*/ 524 h 524"/>
              <a:gd name="T46" fmla="*/ 349 w 987"/>
              <a:gd name="T47" fmla="*/ 524 h 524"/>
              <a:gd name="T48" fmla="*/ 366 w 987"/>
              <a:gd name="T49" fmla="*/ 524 h 524"/>
              <a:gd name="T50" fmla="*/ 383 w 987"/>
              <a:gd name="T51" fmla="*/ 524 h 524"/>
              <a:gd name="T52" fmla="*/ 401 w 987"/>
              <a:gd name="T53" fmla="*/ 524 h 524"/>
              <a:gd name="T54" fmla="*/ 418 w 987"/>
              <a:gd name="T55" fmla="*/ 524 h 524"/>
              <a:gd name="T56" fmla="*/ 435 w 987"/>
              <a:gd name="T57" fmla="*/ 524 h 524"/>
              <a:gd name="T58" fmla="*/ 452 w 987"/>
              <a:gd name="T59" fmla="*/ 524 h 524"/>
              <a:gd name="T60" fmla="*/ 470 w 987"/>
              <a:gd name="T61" fmla="*/ 524 h 524"/>
              <a:gd name="T62" fmla="*/ 487 w 987"/>
              <a:gd name="T63" fmla="*/ 524 h 524"/>
              <a:gd name="T64" fmla="*/ 504 w 987"/>
              <a:gd name="T65" fmla="*/ 524 h 524"/>
              <a:gd name="T66" fmla="*/ 521 w 987"/>
              <a:gd name="T67" fmla="*/ 524 h 524"/>
              <a:gd name="T68" fmla="*/ 539 w 987"/>
              <a:gd name="T69" fmla="*/ 524 h 524"/>
              <a:gd name="T70" fmla="*/ 556 w 987"/>
              <a:gd name="T71" fmla="*/ 524 h 524"/>
              <a:gd name="T72" fmla="*/ 573 w 987"/>
              <a:gd name="T73" fmla="*/ 524 h 524"/>
              <a:gd name="T74" fmla="*/ 590 w 987"/>
              <a:gd name="T75" fmla="*/ 524 h 524"/>
              <a:gd name="T76" fmla="*/ 607 w 987"/>
              <a:gd name="T77" fmla="*/ 524 h 524"/>
              <a:gd name="T78" fmla="*/ 625 w 987"/>
              <a:gd name="T79" fmla="*/ 524 h 524"/>
              <a:gd name="T80" fmla="*/ 642 w 987"/>
              <a:gd name="T81" fmla="*/ 524 h 524"/>
              <a:gd name="T82" fmla="*/ 659 w 987"/>
              <a:gd name="T83" fmla="*/ 524 h 524"/>
              <a:gd name="T84" fmla="*/ 676 w 987"/>
              <a:gd name="T85" fmla="*/ 524 h 524"/>
              <a:gd name="T86" fmla="*/ 694 w 987"/>
              <a:gd name="T87" fmla="*/ 524 h 524"/>
              <a:gd name="T88" fmla="*/ 711 w 987"/>
              <a:gd name="T89" fmla="*/ 524 h 524"/>
              <a:gd name="T90" fmla="*/ 728 w 987"/>
              <a:gd name="T91" fmla="*/ 524 h 524"/>
              <a:gd name="T92" fmla="*/ 745 w 987"/>
              <a:gd name="T93" fmla="*/ 524 h 524"/>
              <a:gd name="T94" fmla="*/ 763 w 987"/>
              <a:gd name="T95" fmla="*/ 524 h 524"/>
              <a:gd name="T96" fmla="*/ 780 w 987"/>
              <a:gd name="T97" fmla="*/ 524 h 524"/>
              <a:gd name="T98" fmla="*/ 797 w 987"/>
              <a:gd name="T99" fmla="*/ 524 h 524"/>
              <a:gd name="T100" fmla="*/ 814 w 987"/>
              <a:gd name="T101" fmla="*/ 524 h 524"/>
              <a:gd name="T102" fmla="*/ 832 w 987"/>
              <a:gd name="T103" fmla="*/ 524 h 524"/>
              <a:gd name="T104" fmla="*/ 849 w 987"/>
              <a:gd name="T105" fmla="*/ 524 h 524"/>
              <a:gd name="T106" fmla="*/ 866 w 987"/>
              <a:gd name="T107" fmla="*/ 524 h 524"/>
              <a:gd name="T108" fmla="*/ 883 w 987"/>
              <a:gd name="T109" fmla="*/ 524 h 524"/>
              <a:gd name="T110" fmla="*/ 900 w 987"/>
              <a:gd name="T111" fmla="*/ 524 h 524"/>
              <a:gd name="T112" fmla="*/ 918 w 987"/>
              <a:gd name="T113" fmla="*/ 524 h 524"/>
              <a:gd name="T114" fmla="*/ 935 w 987"/>
              <a:gd name="T115" fmla="*/ 524 h 524"/>
              <a:gd name="T116" fmla="*/ 952 w 987"/>
              <a:gd name="T117" fmla="*/ 524 h 524"/>
              <a:gd name="T118" fmla="*/ 969 w 987"/>
              <a:gd name="T119" fmla="*/ 524 h 524"/>
              <a:gd name="T120" fmla="*/ 981 w 987"/>
              <a:gd name="T121" fmla="*/ 524 h 5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987" h="524">
                <a:moveTo>
                  <a:pt x="0" y="524"/>
                </a:moveTo>
                <a:lnTo>
                  <a:pt x="1" y="524"/>
                </a:lnTo>
                <a:lnTo>
                  <a:pt x="3" y="524"/>
                </a:lnTo>
                <a:lnTo>
                  <a:pt x="4" y="524"/>
                </a:lnTo>
                <a:lnTo>
                  <a:pt x="6" y="524"/>
                </a:lnTo>
                <a:lnTo>
                  <a:pt x="7" y="524"/>
                </a:lnTo>
                <a:lnTo>
                  <a:pt x="9" y="524"/>
                </a:lnTo>
                <a:lnTo>
                  <a:pt x="10" y="524"/>
                </a:lnTo>
                <a:lnTo>
                  <a:pt x="12" y="524"/>
                </a:lnTo>
                <a:lnTo>
                  <a:pt x="13" y="524"/>
                </a:lnTo>
                <a:lnTo>
                  <a:pt x="14" y="524"/>
                </a:lnTo>
                <a:lnTo>
                  <a:pt x="16" y="524"/>
                </a:lnTo>
                <a:lnTo>
                  <a:pt x="17" y="524"/>
                </a:lnTo>
                <a:lnTo>
                  <a:pt x="19" y="524"/>
                </a:lnTo>
                <a:lnTo>
                  <a:pt x="20" y="524"/>
                </a:lnTo>
                <a:lnTo>
                  <a:pt x="22" y="524"/>
                </a:lnTo>
                <a:lnTo>
                  <a:pt x="23" y="524"/>
                </a:lnTo>
                <a:lnTo>
                  <a:pt x="24" y="524"/>
                </a:lnTo>
                <a:lnTo>
                  <a:pt x="26" y="524"/>
                </a:lnTo>
                <a:lnTo>
                  <a:pt x="27" y="524"/>
                </a:lnTo>
                <a:lnTo>
                  <a:pt x="29" y="524"/>
                </a:lnTo>
                <a:lnTo>
                  <a:pt x="30" y="524"/>
                </a:lnTo>
                <a:lnTo>
                  <a:pt x="32" y="524"/>
                </a:lnTo>
                <a:lnTo>
                  <a:pt x="33" y="524"/>
                </a:lnTo>
                <a:lnTo>
                  <a:pt x="34" y="524"/>
                </a:lnTo>
                <a:lnTo>
                  <a:pt x="36" y="524"/>
                </a:lnTo>
                <a:lnTo>
                  <a:pt x="37" y="524"/>
                </a:lnTo>
                <a:lnTo>
                  <a:pt x="39" y="524"/>
                </a:lnTo>
                <a:lnTo>
                  <a:pt x="40" y="524"/>
                </a:lnTo>
                <a:lnTo>
                  <a:pt x="42" y="524"/>
                </a:lnTo>
                <a:lnTo>
                  <a:pt x="43" y="524"/>
                </a:lnTo>
                <a:lnTo>
                  <a:pt x="45" y="524"/>
                </a:lnTo>
                <a:lnTo>
                  <a:pt x="46" y="524"/>
                </a:lnTo>
                <a:lnTo>
                  <a:pt x="47" y="524"/>
                </a:lnTo>
                <a:lnTo>
                  <a:pt x="49" y="524"/>
                </a:lnTo>
                <a:lnTo>
                  <a:pt x="50" y="524"/>
                </a:lnTo>
                <a:lnTo>
                  <a:pt x="50" y="518"/>
                </a:lnTo>
                <a:lnTo>
                  <a:pt x="50" y="524"/>
                </a:lnTo>
                <a:lnTo>
                  <a:pt x="50" y="518"/>
                </a:lnTo>
                <a:lnTo>
                  <a:pt x="52" y="497"/>
                </a:lnTo>
                <a:lnTo>
                  <a:pt x="52" y="400"/>
                </a:lnTo>
                <a:lnTo>
                  <a:pt x="52" y="497"/>
                </a:lnTo>
                <a:lnTo>
                  <a:pt x="52" y="400"/>
                </a:lnTo>
                <a:lnTo>
                  <a:pt x="53" y="215"/>
                </a:lnTo>
                <a:lnTo>
                  <a:pt x="53" y="47"/>
                </a:lnTo>
                <a:lnTo>
                  <a:pt x="53" y="215"/>
                </a:lnTo>
                <a:lnTo>
                  <a:pt x="53" y="47"/>
                </a:lnTo>
                <a:lnTo>
                  <a:pt x="55" y="0"/>
                </a:lnTo>
                <a:lnTo>
                  <a:pt x="55" y="62"/>
                </a:lnTo>
                <a:lnTo>
                  <a:pt x="56" y="159"/>
                </a:lnTo>
                <a:lnTo>
                  <a:pt x="56" y="250"/>
                </a:lnTo>
                <a:lnTo>
                  <a:pt x="57" y="318"/>
                </a:lnTo>
                <a:lnTo>
                  <a:pt x="57" y="409"/>
                </a:lnTo>
                <a:lnTo>
                  <a:pt x="59" y="439"/>
                </a:lnTo>
                <a:lnTo>
                  <a:pt x="59" y="456"/>
                </a:lnTo>
                <a:lnTo>
                  <a:pt x="60" y="471"/>
                </a:lnTo>
                <a:lnTo>
                  <a:pt x="60" y="483"/>
                </a:lnTo>
                <a:lnTo>
                  <a:pt x="62" y="489"/>
                </a:lnTo>
                <a:lnTo>
                  <a:pt x="62" y="495"/>
                </a:lnTo>
                <a:lnTo>
                  <a:pt x="63" y="500"/>
                </a:lnTo>
                <a:lnTo>
                  <a:pt x="65" y="500"/>
                </a:lnTo>
                <a:lnTo>
                  <a:pt x="65" y="503"/>
                </a:lnTo>
                <a:lnTo>
                  <a:pt x="66" y="509"/>
                </a:lnTo>
                <a:lnTo>
                  <a:pt x="66" y="515"/>
                </a:lnTo>
                <a:lnTo>
                  <a:pt x="68" y="515"/>
                </a:lnTo>
                <a:lnTo>
                  <a:pt x="69" y="515"/>
                </a:lnTo>
                <a:lnTo>
                  <a:pt x="70" y="518"/>
                </a:lnTo>
                <a:lnTo>
                  <a:pt x="72" y="518"/>
                </a:lnTo>
                <a:lnTo>
                  <a:pt x="73" y="518"/>
                </a:lnTo>
                <a:lnTo>
                  <a:pt x="75" y="518"/>
                </a:lnTo>
                <a:lnTo>
                  <a:pt x="76" y="521"/>
                </a:lnTo>
                <a:lnTo>
                  <a:pt x="78" y="521"/>
                </a:lnTo>
                <a:lnTo>
                  <a:pt x="79" y="521"/>
                </a:lnTo>
                <a:lnTo>
                  <a:pt x="80" y="521"/>
                </a:lnTo>
                <a:lnTo>
                  <a:pt x="82" y="521"/>
                </a:lnTo>
                <a:lnTo>
                  <a:pt x="83" y="521"/>
                </a:lnTo>
                <a:lnTo>
                  <a:pt x="85" y="521"/>
                </a:lnTo>
                <a:lnTo>
                  <a:pt x="86" y="521"/>
                </a:lnTo>
                <a:lnTo>
                  <a:pt x="88" y="521"/>
                </a:lnTo>
                <a:lnTo>
                  <a:pt x="89" y="521"/>
                </a:lnTo>
                <a:lnTo>
                  <a:pt x="90" y="521"/>
                </a:lnTo>
                <a:lnTo>
                  <a:pt x="92" y="521"/>
                </a:lnTo>
                <a:lnTo>
                  <a:pt x="93" y="521"/>
                </a:lnTo>
                <a:lnTo>
                  <a:pt x="95" y="521"/>
                </a:lnTo>
                <a:lnTo>
                  <a:pt x="96" y="521"/>
                </a:lnTo>
                <a:lnTo>
                  <a:pt x="98" y="521"/>
                </a:lnTo>
                <a:lnTo>
                  <a:pt x="99" y="521"/>
                </a:lnTo>
                <a:lnTo>
                  <a:pt x="101" y="521"/>
                </a:lnTo>
                <a:lnTo>
                  <a:pt x="102" y="521"/>
                </a:lnTo>
                <a:lnTo>
                  <a:pt x="103" y="521"/>
                </a:lnTo>
                <a:lnTo>
                  <a:pt x="105" y="521"/>
                </a:lnTo>
                <a:lnTo>
                  <a:pt x="106" y="521"/>
                </a:lnTo>
                <a:lnTo>
                  <a:pt x="108" y="521"/>
                </a:lnTo>
                <a:lnTo>
                  <a:pt x="109" y="521"/>
                </a:lnTo>
                <a:lnTo>
                  <a:pt x="111" y="521"/>
                </a:lnTo>
                <a:lnTo>
                  <a:pt x="112" y="521"/>
                </a:lnTo>
                <a:lnTo>
                  <a:pt x="113" y="521"/>
                </a:lnTo>
                <a:lnTo>
                  <a:pt x="115" y="521"/>
                </a:lnTo>
                <a:lnTo>
                  <a:pt x="116" y="521"/>
                </a:lnTo>
                <a:lnTo>
                  <a:pt x="118" y="512"/>
                </a:lnTo>
                <a:lnTo>
                  <a:pt x="118" y="489"/>
                </a:lnTo>
                <a:lnTo>
                  <a:pt x="118" y="512"/>
                </a:lnTo>
                <a:lnTo>
                  <a:pt x="118" y="489"/>
                </a:lnTo>
                <a:lnTo>
                  <a:pt x="119" y="456"/>
                </a:lnTo>
                <a:lnTo>
                  <a:pt x="119" y="436"/>
                </a:lnTo>
                <a:lnTo>
                  <a:pt x="119" y="456"/>
                </a:lnTo>
                <a:lnTo>
                  <a:pt x="119" y="436"/>
                </a:lnTo>
                <a:lnTo>
                  <a:pt x="121" y="439"/>
                </a:lnTo>
                <a:lnTo>
                  <a:pt x="121" y="456"/>
                </a:lnTo>
                <a:lnTo>
                  <a:pt x="122" y="474"/>
                </a:lnTo>
                <a:lnTo>
                  <a:pt x="122" y="486"/>
                </a:lnTo>
                <a:lnTo>
                  <a:pt x="124" y="497"/>
                </a:lnTo>
                <a:lnTo>
                  <a:pt x="124" y="509"/>
                </a:lnTo>
                <a:lnTo>
                  <a:pt x="125" y="512"/>
                </a:lnTo>
                <a:lnTo>
                  <a:pt x="125" y="515"/>
                </a:lnTo>
                <a:lnTo>
                  <a:pt x="126" y="515"/>
                </a:lnTo>
                <a:lnTo>
                  <a:pt x="126" y="518"/>
                </a:lnTo>
                <a:lnTo>
                  <a:pt x="128" y="518"/>
                </a:lnTo>
                <a:lnTo>
                  <a:pt x="129" y="521"/>
                </a:lnTo>
                <a:lnTo>
                  <a:pt x="131" y="521"/>
                </a:lnTo>
                <a:lnTo>
                  <a:pt x="132" y="521"/>
                </a:lnTo>
                <a:lnTo>
                  <a:pt x="134" y="521"/>
                </a:lnTo>
                <a:lnTo>
                  <a:pt x="135" y="521"/>
                </a:lnTo>
                <a:lnTo>
                  <a:pt x="136" y="521"/>
                </a:lnTo>
                <a:lnTo>
                  <a:pt x="138" y="521"/>
                </a:lnTo>
                <a:lnTo>
                  <a:pt x="139" y="521"/>
                </a:lnTo>
                <a:lnTo>
                  <a:pt x="141" y="521"/>
                </a:lnTo>
                <a:lnTo>
                  <a:pt x="142" y="521"/>
                </a:lnTo>
                <a:lnTo>
                  <a:pt x="144" y="521"/>
                </a:lnTo>
                <a:lnTo>
                  <a:pt x="145" y="524"/>
                </a:lnTo>
                <a:lnTo>
                  <a:pt x="146" y="521"/>
                </a:lnTo>
                <a:lnTo>
                  <a:pt x="148" y="521"/>
                </a:lnTo>
                <a:lnTo>
                  <a:pt x="148" y="524"/>
                </a:lnTo>
                <a:lnTo>
                  <a:pt x="149" y="524"/>
                </a:lnTo>
                <a:lnTo>
                  <a:pt x="149" y="521"/>
                </a:lnTo>
                <a:lnTo>
                  <a:pt x="149" y="524"/>
                </a:lnTo>
                <a:lnTo>
                  <a:pt x="149" y="521"/>
                </a:lnTo>
                <a:lnTo>
                  <a:pt x="151" y="521"/>
                </a:lnTo>
                <a:lnTo>
                  <a:pt x="151" y="524"/>
                </a:lnTo>
                <a:lnTo>
                  <a:pt x="152" y="524"/>
                </a:lnTo>
                <a:lnTo>
                  <a:pt x="154" y="524"/>
                </a:lnTo>
                <a:lnTo>
                  <a:pt x="155" y="524"/>
                </a:lnTo>
                <a:lnTo>
                  <a:pt x="157" y="524"/>
                </a:lnTo>
                <a:lnTo>
                  <a:pt x="158" y="524"/>
                </a:lnTo>
                <a:lnTo>
                  <a:pt x="159" y="524"/>
                </a:lnTo>
                <a:lnTo>
                  <a:pt x="161" y="524"/>
                </a:lnTo>
                <a:lnTo>
                  <a:pt x="162" y="524"/>
                </a:lnTo>
                <a:lnTo>
                  <a:pt x="164" y="524"/>
                </a:lnTo>
                <a:lnTo>
                  <a:pt x="165" y="524"/>
                </a:lnTo>
                <a:lnTo>
                  <a:pt x="167" y="524"/>
                </a:lnTo>
                <a:lnTo>
                  <a:pt x="168" y="524"/>
                </a:lnTo>
                <a:lnTo>
                  <a:pt x="169" y="524"/>
                </a:lnTo>
                <a:lnTo>
                  <a:pt x="171" y="524"/>
                </a:lnTo>
                <a:lnTo>
                  <a:pt x="172" y="524"/>
                </a:lnTo>
                <a:lnTo>
                  <a:pt x="174" y="524"/>
                </a:lnTo>
                <a:lnTo>
                  <a:pt x="175" y="524"/>
                </a:lnTo>
                <a:lnTo>
                  <a:pt x="177" y="524"/>
                </a:lnTo>
                <a:lnTo>
                  <a:pt x="178" y="524"/>
                </a:lnTo>
                <a:lnTo>
                  <a:pt x="180" y="524"/>
                </a:lnTo>
                <a:lnTo>
                  <a:pt x="181" y="524"/>
                </a:lnTo>
                <a:lnTo>
                  <a:pt x="182" y="524"/>
                </a:lnTo>
                <a:lnTo>
                  <a:pt x="182" y="521"/>
                </a:lnTo>
                <a:lnTo>
                  <a:pt x="182" y="524"/>
                </a:lnTo>
                <a:lnTo>
                  <a:pt x="182" y="521"/>
                </a:lnTo>
                <a:lnTo>
                  <a:pt x="184" y="518"/>
                </a:lnTo>
                <a:lnTo>
                  <a:pt x="184" y="512"/>
                </a:lnTo>
                <a:lnTo>
                  <a:pt x="184" y="518"/>
                </a:lnTo>
                <a:lnTo>
                  <a:pt x="184" y="512"/>
                </a:lnTo>
                <a:lnTo>
                  <a:pt x="185" y="509"/>
                </a:lnTo>
                <a:lnTo>
                  <a:pt x="187" y="512"/>
                </a:lnTo>
                <a:lnTo>
                  <a:pt x="187" y="515"/>
                </a:lnTo>
                <a:lnTo>
                  <a:pt x="188" y="518"/>
                </a:lnTo>
                <a:lnTo>
                  <a:pt x="190" y="521"/>
                </a:lnTo>
                <a:lnTo>
                  <a:pt x="191" y="521"/>
                </a:lnTo>
                <a:lnTo>
                  <a:pt x="192" y="521"/>
                </a:lnTo>
                <a:lnTo>
                  <a:pt x="194" y="524"/>
                </a:lnTo>
                <a:lnTo>
                  <a:pt x="195" y="524"/>
                </a:lnTo>
                <a:lnTo>
                  <a:pt x="197" y="524"/>
                </a:lnTo>
                <a:lnTo>
                  <a:pt x="198" y="524"/>
                </a:lnTo>
                <a:lnTo>
                  <a:pt x="200" y="524"/>
                </a:lnTo>
                <a:lnTo>
                  <a:pt x="201" y="524"/>
                </a:lnTo>
                <a:lnTo>
                  <a:pt x="203" y="524"/>
                </a:lnTo>
                <a:lnTo>
                  <a:pt x="204" y="524"/>
                </a:lnTo>
                <a:lnTo>
                  <a:pt x="205" y="524"/>
                </a:lnTo>
                <a:lnTo>
                  <a:pt x="207" y="524"/>
                </a:lnTo>
                <a:lnTo>
                  <a:pt x="208" y="524"/>
                </a:lnTo>
                <a:lnTo>
                  <a:pt x="210" y="524"/>
                </a:lnTo>
                <a:lnTo>
                  <a:pt x="211" y="524"/>
                </a:lnTo>
                <a:lnTo>
                  <a:pt x="213" y="524"/>
                </a:lnTo>
                <a:lnTo>
                  <a:pt x="214" y="524"/>
                </a:lnTo>
                <a:lnTo>
                  <a:pt x="215" y="524"/>
                </a:lnTo>
                <a:lnTo>
                  <a:pt x="217" y="524"/>
                </a:lnTo>
                <a:lnTo>
                  <a:pt x="218" y="524"/>
                </a:lnTo>
                <a:lnTo>
                  <a:pt x="220" y="524"/>
                </a:lnTo>
                <a:lnTo>
                  <a:pt x="221" y="524"/>
                </a:lnTo>
                <a:lnTo>
                  <a:pt x="223" y="524"/>
                </a:lnTo>
                <a:lnTo>
                  <a:pt x="224" y="524"/>
                </a:lnTo>
                <a:lnTo>
                  <a:pt x="225" y="524"/>
                </a:lnTo>
                <a:lnTo>
                  <a:pt x="227" y="524"/>
                </a:lnTo>
                <a:lnTo>
                  <a:pt x="228" y="524"/>
                </a:lnTo>
                <a:lnTo>
                  <a:pt x="230" y="524"/>
                </a:lnTo>
                <a:lnTo>
                  <a:pt x="231" y="524"/>
                </a:lnTo>
                <a:lnTo>
                  <a:pt x="233" y="524"/>
                </a:lnTo>
                <a:lnTo>
                  <a:pt x="234" y="524"/>
                </a:lnTo>
                <a:lnTo>
                  <a:pt x="236" y="524"/>
                </a:lnTo>
                <a:lnTo>
                  <a:pt x="237" y="524"/>
                </a:lnTo>
                <a:lnTo>
                  <a:pt x="238" y="524"/>
                </a:lnTo>
                <a:lnTo>
                  <a:pt x="240" y="524"/>
                </a:lnTo>
                <a:lnTo>
                  <a:pt x="241" y="524"/>
                </a:lnTo>
                <a:lnTo>
                  <a:pt x="243" y="524"/>
                </a:lnTo>
                <a:lnTo>
                  <a:pt x="244" y="524"/>
                </a:lnTo>
                <a:lnTo>
                  <a:pt x="246" y="524"/>
                </a:lnTo>
                <a:lnTo>
                  <a:pt x="247" y="524"/>
                </a:lnTo>
                <a:lnTo>
                  <a:pt x="248" y="524"/>
                </a:lnTo>
                <a:lnTo>
                  <a:pt x="250" y="524"/>
                </a:lnTo>
                <a:lnTo>
                  <a:pt x="250" y="521"/>
                </a:lnTo>
                <a:lnTo>
                  <a:pt x="250" y="524"/>
                </a:lnTo>
                <a:lnTo>
                  <a:pt x="250" y="521"/>
                </a:lnTo>
                <a:lnTo>
                  <a:pt x="251" y="521"/>
                </a:lnTo>
                <a:lnTo>
                  <a:pt x="253" y="521"/>
                </a:lnTo>
                <a:lnTo>
                  <a:pt x="253" y="524"/>
                </a:lnTo>
                <a:lnTo>
                  <a:pt x="254" y="524"/>
                </a:lnTo>
                <a:lnTo>
                  <a:pt x="256" y="524"/>
                </a:lnTo>
                <a:lnTo>
                  <a:pt x="257" y="524"/>
                </a:lnTo>
                <a:lnTo>
                  <a:pt x="259" y="524"/>
                </a:lnTo>
                <a:lnTo>
                  <a:pt x="260" y="524"/>
                </a:lnTo>
                <a:lnTo>
                  <a:pt x="261" y="524"/>
                </a:lnTo>
                <a:lnTo>
                  <a:pt x="263" y="524"/>
                </a:lnTo>
                <a:lnTo>
                  <a:pt x="264" y="524"/>
                </a:lnTo>
                <a:lnTo>
                  <a:pt x="266" y="524"/>
                </a:lnTo>
                <a:lnTo>
                  <a:pt x="267" y="524"/>
                </a:lnTo>
                <a:lnTo>
                  <a:pt x="269" y="524"/>
                </a:lnTo>
                <a:lnTo>
                  <a:pt x="270" y="524"/>
                </a:lnTo>
                <a:lnTo>
                  <a:pt x="271" y="524"/>
                </a:lnTo>
                <a:lnTo>
                  <a:pt x="273" y="524"/>
                </a:lnTo>
                <a:lnTo>
                  <a:pt x="274" y="524"/>
                </a:lnTo>
                <a:lnTo>
                  <a:pt x="276" y="524"/>
                </a:lnTo>
                <a:lnTo>
                  <a:pt x="277" y="524"/>
                </a:lnTo>
                <a:lnTo>
                  <a:pt x="279" y="524"/>
                </a:lnTo>
                <a:lnTo>
                  <a:pt x="280" y="524"/>
                </a:lnTo>
                <a:lnTo>
                  <a:pt x="281" y="524"/>
                </a:lnTo>
                <a:lnTo>
                  <a:pt x="283" y="524"/>
                </a:lnTo>
                <a:lnTo>
                  <a:pt x="284" y="524"/>
                </a:lnTo>
                <a:lnTo>
                  <a:pt x="286" y="524"/>
                </a:lnTo>
                <a:lnTo>
                  <a:pt x="287" y="524"/>
                </a:lnTo>
                <a:lnTo>
                  <a:pt x="289" y="524"/>
                </a:lnTo>
                <a:lnTo>
                  <a:pt x="290" y="524"/>
                </a:lnTo>
                <a:lnTo>
                  <a:pt x="292" y="524"/>
                </a:lnTo>
                <a:lnTo>
                  <a:pt x="293" y="524"/>
                </a:lnTo>
                <a:lnTo>
                  <a:pt x="294" y="524"/>
                </a:lnTo>
                <a:lnTo>
                  <a:pt x="296" y="524"/>
                </a:lnTo>
                <a:lnTo>
                  <a:pt x="297" y="524"/>
                </a:lnTo>
                <a:lnTo>
                  <a:pt x="299" y="524"/>
                </a:lnTo>
                <a:lnTo>
                  <a:pt x="300" y="524"/>
                </a:lnTo>
                <a:lnTo>
                  <a:pt x="302" y="524"/>
                </a:lnTo>
                <a:lnTo>
                  <a:pt x="303" y="524"/>
                </a:lnTo>
                <a:lnTo>
                  <a:pt x="304" y="524"/>
                </a:lnTo>
                <a:lnTo>
                  <a:pt x="306" y="524"/>
                </a:lnTo>
                <a:lnTo>
                  <a:pt x="307" y="524"/>
                </a:lnTo>
                <a:lnTo>
                  <a:pt x="309" y="524"/>
                </a:lnTo>
                <a:lnTo>
                  <a:pt x="310" y="524"/>
                </a:lnTo>
                <a:lnTo>
                  <a:pt x="312" y="524"/>
                </a:lnTo>
                <a:lnTo>
                  <a:pt x="313" y="524"/>
                </a:lnTo>
                <a:lnTo>
                  <a:pt x="315" y="524"/>
                </a:lnTo>
                <a:lnTo>
                  <a:pt x="316" y="524"/>
                </a:lnTo>
                <a:lnTo>
                  <a:pt x="317" y="524"/>
                </a:lnTo>
                <a:lnTo>
                  <a:pt x="319" y="524"/>
                </a:lnTo>
                <a:lnTo>
                  <a:pt x="320" y="524"/>
                </a:lnTo>
                <a:lnTo>
                  <a:pt x="322" y="524"/>
                </a:lnTo>
                <a:lnTo>
                  <a:pt x="323" y="524"/>
                </a:lnTo>
                <a:lnTo>
                  <a:pt x="325" y="524"/>
                </a:lnTo>
                <a:lnTo>
                  <a:pt x="326" y="524"/>
                </a:lnTo>
                <a:lnTo>
                  <a:pt x="327" y="524"/>
                </a:lnTo>
                <a:lnTo>
                  <a:pt x="329" y="524"/>
                </a:lnTo>
                <a:lnTo>
                  <a:pt x="330" y="524"/>
                </a:lnTo>
                <a:lnTo>
                  <a:pt x="332" y="524"/>
                </a:lnTo>
                <a:lnTo>
                  <a:pt x="333" y="524"/>
                </a:lnTo>
                <a:lnTo>
                  <a:pt x="335" y="524"/>
                </a:lnTo>
                <a:lnTo>
                  <a:pt x="336" y="524"/>
                </a:lnTo>
                <a:lnTo>
                  <a:pt x="337" y="524"/>
                </a:lnTo>
                <a:lnTo>
                  <a:pt x="339" y="524"/>
                </a:lnTo>
                <a:lnTo>
                  <a:pt x="340" y="524"/>
                </a:lnTo>
                <a:lnTo>
                  <a:pt x="342" y="524"/>
                </a:lnTo>
                <a:lnTo>
                  <a:pt x="343" y="524"/>
                </a:lnTo>
                <a:lnTo>
                  <a:pt x="345" y="524"/>
                </a:lnTo>
                <a:lnTo>
                  <a:pt x="346" y="524"/>
                </a:lnTo>
                <a:lnTo>
                  <a:pt x="348" y="524"/>
                </a:lnTo>
                <a:lnTo>
                  <a:pt x="349" y="524"/>
                </a:lnTo>
                <a:lnTo>
                  <a:pt x="350" y="524"/>
                </a:lnTo>
                <a:lnTo>
                  <a:pt x="352" y="524"/>
                </a:lnTo>
                <a:lnTo>
                  <a:pt x="353" y="524"/>
                </a:lnTo>
                <a:lnTo>
                  <a:pt x="355" y="524"/>
                </a:lnTo>
                <a:lnTo>
                  <a:pt x="356" y="524"/>
                </a:lnTo>
                <a:lnTo>
                  <a:pt x="358" y="524"/>
                </a:lnTo>
                <a:lnTo>
                  <a:pt x="359" y="524"/>
                </a:lnTo>
                <a:lnTo>
                  <a:pt x="360" y="524"/>
                </a:lnTo>
                <a:lnTo>
                  <a:pt x="362" y="524"/>
                </a:lnTo>
                <a:lnTo>
                  <a:pt x="363" y="524"/>
                </a:lnTo>
                <a:lnTo>
                  <a:pt x="365" y="524"/>
                </a:lnTo>
                <a:lnTo>
                  <a:pt x="366" y="524"/>
                </a:lnTo>
                <a:lnTo>
                  <a:pt x="368" y="524"/>
                </a:lnTo>
                <a:lnTo>
                  <a:pt x="369" y="524"/>
                </a:lnTo>
                <a:lnTo>
                  <a:pt x="371" y="524"/>
                </a:lnTo>
                <a:lnTo>
                  <a:pt x="372" y="524"/>
                </a:lnTo>
                <a:lnTo>
                  <a:pt x="373" y="524"/>
                </a:lnTo>
                <a:lnTo>
                  <a:pt x="375" y="524"/>
                </a:lnTo>
                <a:lnTo>
                  <a:pt x="376" y="524"/>
                </a:lnTo>
                <a:lnTo>
                  <a:pt x="378" y="524"/>
                </a:lnTo>
                <a:lnTo>
                  <a:pt x="379" y="524"/>
                </a:lnTo>
                <a:lnTo>
                  <a:pt x="381" y="524"/>
                </a:lnTo>
                <a:lnTo>
                  <a:pt x="382" y="524"/>
                </a:lnTo>
                <a:lnTo>
                  <a:pt x="383" y="524"/>
                </a:lnTo>
                <a:lnTo>
                  <a:pt x="385" y="524"/>
                </a:lnTo>
                <a:lnTo>
                  <a:pt x="386" y="524"/>
                </a:lnTo>
                <a:lnTo>
                  <a:pt x="388" y="524"/>
                </a:lnTo>
                <a:lnTo>
                  <a:pt x="389" y="524"/>
                </a:lnTo>
                <a:lnTo>
                  <a:pt x="391" y="524"/>
                </a:lnTo>
                <a:lnTo>
                  <a:pt x="392" y="524"/>
                </a:lnTo>
                <a:lnTo>
                  <a:pt x="394" y="524"/>
                </a:lnTo>
                <a:lnTo>
                  <a:pt x="395" y="524"/>
                </a:lnTo>
                <a:lnTo>
                  <a:pt x="396" y="524"/>
                </a:lnTo>
                <a:lnTo>
                  <a:pt x="398" y="524"/>
                </a:lnTo>
                <a:lnTo>
                  <a:pt x="399" y="524"/>
                </a:lnTo>
                <a:lnTo>
                  <a:pt x="401" y="524"/>
                </a:lnTo>
                <a:lnTo>
                  <a:pt x="402" y="524"/>
                </a:lnTo>
                <a:lnTo>
                  <a:pt x="404" y="524"/>
                </a:lnTo>
                <a:lnTo>
                  <a:pt x="405" y="524"/>
                </a:lnTo>
                <a:lnTo>
                  <a:pt x="406" y="524"/>
                </a:lnTo>
                <a:lnTo>
                  <a:pt x="408" y="524"/>
                </a:lnTo>
                <a:lnTo>
                  <a:pt x="409" y="524"/>
                </a:lnTo>
                <a:lnTo>
                  <a:pt x="411" y="524"/>
                </a:lnTo>
                <a:lnTo>
                  <a:pt x="412" y="524"/>
                </a:lnTo>
                <a:lnTo>
                  <a:pt x="414" y="524"/>
                </a:lnTo>
                <a:lnTo>
                  <a:pt x="415" y="524"/>
                </a:lnTo>
                <a:lnTo>
                  <a:pt x="416" y="524"/>
                </a:lnTo>
                <a:lnTo>
                  <a:pt x="418" y="524"/>
                </a:lnTo>
                <a:lnTo>
                  <a:pt x="419" y="524"/>
                </a:lnTo>
                <a:lnTo>
                  <a:pt x="421" y="524"/>
                </a:lnTo>
                <a:lnTo>
                  <a:pt x="422" y="524"/>
                </a:lnTo>
                <a:lnTo>
                  <a:pt x="424" y="524"/>
                </a:lnTo>
                <a:lnTo>
                  <a:pt x="425" y="524"/>
                </a:lnTo>
                <a:lnTo>
                  <a:pt x="427" y="524"/>
                </a:lnTo>
                <a:lnTo>
                  <a:pt x="428" y="524"/>
                </a:lnTo>
                <a:lnTo>
                  <a:pt x="429" y="524"/>
                </a:lnTo>
                <a:lnTo>
                  <a:pt x="431" y="524"/>
                </a:lnTo>
                <a:lnTo>
                  <a:pt x="432" y="524"/>
                </a:lnTo>
                <a:lnTo>
                  <a:pt x="434" y="524"/>
                </a:lnTo>
                <a:lnTo>
                  <a:pt x="435" y="524"/>
                </a:lnTo>
                <a:lnTo>
                  <a:pt x="437" y="524"/>
                </a:lnTo>
                <a:lnTo>
                  <a:pt x="438" y="524"/>
                </a:lnTo>
                <a:lnTo>
                  <a:pt x="439" y="524"/>
                </a:lnTo>
                <a:lnTo>
                  <a:pt x="441" y="524"/>
                </a:lnTo>
                <a:lnTo>
                  <a:pt x="442" y="524"/>
                </a:lnTo>
                <a:lnTo>
                  <a:pt x="444" y="524"/>
                </a:lnTo>
                <a:lnTo>
                  <a:pt x="445" y="524"/>
                </a:lnTo>
                <a:lnTo>
                  <a:pt x="447" y="524"/>
                </a:lnTo>
                <a:lnTo>
                  <a:pt x="448" y="524"/>
                </a:lnTo>
                <a:lnTo>
                  <a:pt x="450" y="524"/>
                </a:lnTo>
                <a:lnTo>
                  <a:pt x="451" y="524"/>
                </a:lnTo>
                <a:lnTo>
                  <a:pt x="452" y="524"/>
                </a:lnTo>
                <a:lnTo>
                  <a:pt x="454" y="524"/>
                </a:lnTo>
                <a:lnTo>
                  <a:pt x="455" y="524"/>
                </a:lnTo>
                <a:lnTo>
                  <a:pt x="457" y="524"/>
                </a:lnTo>
                <a:lnTo>
                  <a:pt x="458" y="524"/>
                </a:lnTo>
                <a:lnTo>
                  <a:pt x="460" y="524"/>
                </a:lnTo>
                <a:lnTo>
                  <a:pt x="461" y="524"/>
                </a:lnTo>
                <a:lnTo>
                  <a:pt x="462" y="524"/>
                </a:lnTo>
                <a:lnTo>
                  <a:pt x="464" y="524"/>
                </a:lnTo>
                <a:lnTo>
                  <a:pt x="465" y="524"/>
                </a:lnTo>
                <a:lnTo>
                  <a:pt x="467" y="524"/>
                </a:lnTo>
                <a:lnTo>
                  <a:pt x="468" y="524"/>
                </a:lnTo>
                <a:lnTo>
                  <a:pt x="470" y="524"/>
                </a:lnTo>
                <a:lnTo>
                  <a:pt x="471" y="524"/>
                </a:lnTo>
                <a:lnTo>
                  <a:pt x="472" y="524"/>
                </a:lnTo>
                <a:lnTo>
                  <a:pt x="474" y="524"/>
                </a:lnTo>
                <a:lnTo>
                  <a:pt x="475" y="524"/>
                </a:lnTo>
                <a:lnTo>
                  <a:pt x="477" y="524"/>
                </a:lnTo>
                <a:lnTo>
                  <a:pt x="478" y="524"/>
                </a:lnTo>
                <a:lnTo>
                  <a:pt x="480" y="524"/>
                </a:lnTo>
                <a:lnTo>
                  <a:pt x="481" y="524"/>
                </a:lnTo>
                <a:lnTo>
                  <a:pt x="483" y="524"/>
                </a:lnTo>
                <a:lnTo>
                  <a:pt x="484" y="524"/>
                </a:lnTo>
                <a:lnTo>
                  <a:pt x="485" y="524"/>
                </a:lnTo>
                <a:lnTo>
                  <a:pt x="487" y="524"/>
                </a:lnTo>
                <a:lnTo>
                  <a:pt x="488" y="524"/>
                </a:lnTo>
                <a:lnTo>
                  <a:pt x="490" y="524"/>
                </a:lnTo>
                <a:lnTo>
                  <a:pt x="491" y="524"/>
                </a:lnTo>
                <a:lnTo>
                  <a:pt x="493" y="524"/>
                </a:lnTo>
                <a:lnTo>
                  <a:pt x="494" y="524"/>
                </a:lnTo>
                <a:lnTo>
                  <a:pt x="495" y="524"/>
                </a:lnTo>
                <a:lnTo>
                  <a:pt x="497" y="524"/>
                </a:lnTo>
                <a:lnTo>
                  <a:pt x="498" y="524"/>
                </a:lnTo>
                <a:lnTo>
                  <a:pt x="500" y="524"/>
                </a:lnTo>
                <a:lnTo>
                  <a:pt x="501" y="524"/>
                </a:lnTo>
                <a:lnTo>
                  <a:pt x="503" y="524"/>
                </a:lnTo>
                <a:lnTo>
                  <a:pt x="504" y="524"/>
                </a:lnTo>
                <a:lnTo>
                  <a:pt x="506" y="524"/>
                </a:lnTo>
                <a:lnTo>
                  <a:pt x="507" y="524"/>
                </a:lnTo>
                <a:lnTo>
                  <a:pt x="508" y="524"/>
                </a:lnTo>
                <a:lnTo>
                  <a:pt x="510" y="524"/>
                </a:lnTo>
                <a:lnTo>
                  <a:pt x="511" y="524"/>
                </a:lnTo>
                <a:lnTo>
                  <a:pt x="513" y="524"/>
                </a:lnTo>
                <a:lnTo>
                  <a:pt x="514" y="524"/>
                </a:lnTo>
                <a:lnTo>
                  <a:pt x="516" y="524"/>
                </a:lnTo>
                <a:lnTo>
                  <a:pt x="517" y="524"/>
                </a:lnTo>
                <a:lnTo>
                  <a:pt x="518" y="524"/>
                </a:lnTo>
                <a:lnTo>
                  <a:pt x="520" y="524"/>
                </a:lnTo>
                <a:lnTo>
                  <a:pt x="521" y="524"/>
                </a:lnTo>
                <a:lnTo>
                  <a:pt x="523" y="524"/>
                </a:lnTo>
                <a:lnTo>
                  <a:pt x="524" y="524"/>
                </a:lnTo>
                <a:lnTo>
                  <a:pt x="526" y="524"/>
                </a:lnTo>
                <a:lnTo>
                  <a:pt x="527" y="524"/>
                </a:lnTo>
                <a:lnTo>
                  <a:pt x="528" y="524"/>
                </a:lnTo>
                <a:lnTo>
                  <a:pt x="530" y="524"/>
                </a:lnTo>
                <a:lnTo>
                  <a:pt x="531" y="524"/>
                </a:lnTo>
                <a:lnTo>
                  <a:pt x="533" y="524"/>
                </a:lnTo>
                <a:lnTo>
                  <a:pt x="534" y="524"/>
                </a:lnTo>
                <a:lnTo>
                  <a:pt x="536" y="524"/>
                </a:lnTo>
                <a:lnTo>
                  <a:pt x="537" y="524"/>
                </a:lnTo>
                <a:lnTo>
                  <a:pt x="539" y="524"/>
                </a:lnTo>
                <a:lnTo>
                  <a:pt x="540" y="524"/>
                </a:lnTo>
                <a:lnTo>
                  <a:pt x="541" y="524"/>
                </a:lnTo>
                <a:lnTo>
                  <a:pt x="543" y="524"/>
                </a:lnTo>
                <a:lnTo>
                  <a:pt x="544" y="524"/>
                </a:lnTo>
                <a:lnTo>
                  <a:pt x="546" y="524"/>
                </a:lnTo>
                <a:lnTo>
                  <a:pt x="547" y="524"/>
                </a:lnTo>
                <a:lnTo>
                  <a:pt x="549" y="524"/>
                </a:lnTo>
                <a:lnTo>
                  <a:pt x="550" y="524"/>
                </a:lnTo>
                <a:lnTo>
                  <a:pt x="551" y="524"/>
                </a:lnTo>
                <a:lnTo>
                  <a:pt x="553" y="524"/>
                </a:lnTo>
                <a:lnTo>
                  <a:pt x="554" y="524"/>
                </a:lnTo>
                <a:lnTo>
                  <a:pt x="556" y="524"/>
                </a:lnTo>
                <a:lnTo>
                  <a:pt x="557" y="524"/>
                </a:lnTo>
                <a:lnTo>
                  <a:pt x="559" y="524"/>
                </a:lnTo>
                <a:lnTo>
                  <a:pt x="560" y="524"/>
                </a:lnTo>
                <a:lnTo>
                  <a:pt x="562" y="524"/>
                </a:lnTo>
                <a:lnTo>
                  <a:pt x="563" y="524"/>
                </a:lnTo>
                <a:lnTo>
                  <a:pt x="564" y="524"/>
                </a:lnTo>
                <a:lnTo>
                  <a:pt x="566" y="524"/>
                </a:lnTo>
                <a:lnTo>
                  <a:pt x="567" y="524"/>
                </a:lnTo>
                <a:lnTo>
                  <a:pt x="569" y="524"/>
                </a:lnTo>
                <a:lnTo>
                  <a:pt x="570" y="524"/>
                </a:lnTo>
                <a:lnTo>
                  <a:pt x="572" y="524"/>
                </a:lnTo>
                <a:lnTo>
                  <a:pt x="573" y="524"/>
                </a:lnTo>
                <a:lnTo>
                  <a:pt x="574" y="524"/>
                </a:lnTo>
                <a:lnTo>
                  <a:pt x="576" y="524"/>
                </a:lnTo>
                <a:lnTo>
                  <a:pt x="577" y="524"/>
                </a:lnTo>
                <a:lnTo>
                  <a:pt x="579" y="524"/>
                </a:lnTo>
                <a:lnTo>
                  <a:pt x="580" y="524"/>
                </a:lnTo>
                <a:lnTo>
                  <a:pt x="582" y="524"/>
                </a:lnTo>
                <a:lnTo>
                  <a:pt x="583" y="524"/>
                </a:lnTo>
                <a:lnTo>
                  <a:pt x="584" y="524"/>
                </a:lnTo>
                <a:lnTo>
                  <a:pt x="586" y="524"/>
                </a:lnTo>
                <a:lnTo>
                  <a:pt x="587" y="524"/>
                </a:lnTo>
                <a:lnTo>
                  <a:pt x="589" y="524"/>
                </a:lnTo>
                <a:lnTo>
                  <a:pt x="590" y="524"/>
                </a:lnTo>
                <a:lnTo>
                  <a:pt x="592" y="524"/>
                </a:lnTo>
                <a:lnTo>
                  <a:pt x="593" y="524"/>
                </a:lnTo>
                <a:lnTo>
                  <a:pt x="595" y="524"/>
                </a:lnTo>
                <a:lnTo>
                  <a:pt x="596" y="524"/>
                </a:lnTo>
                <a:lnTo>
                  <a:pt x="597" y="524"/>
                </a:lnTo>
                <a:lnTo>
                  <a:pt x="599" y="524"/>
                </a:lnTo>
                <a:lnTo>
                  <a:pt x="600" y="524"/>
                </a:lnTo>
                <a:lnTo>
                  <a:pt x="602" y="524"/>
                </a:lnTo>
                <a:lnTo>
                  <a:pt x="603" y="524"/>
                </a:lnTo>
                <a:lnTo>
                  <a:pt x="605" y="524"/>
                </a:lnTo>
                <a:lnTo>
                  <a:pt x="606" y="524"/>
                </a:lnTo>
                <a:lnTo>
                  <a:pt x="607" y="524"/>
                </a:lnTo>
                <a:lnTo>
                  <a:pt x="609" y="524"/>
                </a:lnTo>
                <a:lnTo>
                  <a:pt x="610" y="524"/>
                </a:lnTo>
                <a:lnTo>
                  <a:pt x="612" y="524"/>
                </a:lnTo>
                <a:lnTo>
                  <a:pt x="613" y="524"/>
                </a:lnTo>
                <a:lnTo>
                  <a:pt x="615" y="524"/>
                </a:lnTo>
                <a:lnTo>
                  <a:pt x="616" y="524"/>
                </a:lnTo>
                <a:lnTo>
                  <a:pt x="618" y="524"/>
                </a:lnTo>
                <a:lnTo>
                  <a:pt x="619" y="524"/>
                </a:lnTo>
                <a:lnTo>
                  <a:pt x="620" y="524"/>
                </a:lnTo>
                <a:lnTo>
                  <a:pt x="622" y="524"/>
                </a:lnTo>
                <a:lnTo>
                  <a:pt x="623" y="524"/>
                </a:lnTo>
                <a:lnTo>
                  <a:pt x="625" y="524"/>
                </a:lnTo>
                <a:lnTo>
                  <a:pt x="626" y="524"/>
                </a:lnTo>
                <a:lnTo>
                  <a:pt x="628" y="524"/>
                </a:lnTo>
                <a:lnTo>
                  <a:pt x="629" y="524"/>
                </a:lnTo>
                <a:lnTo>
                  <a:pt x="630" y="524"/>
                </a:lnTo>
                <a:lnTo>
                  <a:pt x="632" y="524"/>
                </a:lnTo>
                <a:lnTo>
                  <a:pt x="633" y="524"/>
                </a:lnTo>
                <a:lnTo>
                  <a:pt x="635" y="524"/>
                </a:lnTo>
                <a:lnTo>
                  <a:pt x="636" y="524"/>
                </a:lnTo>
                <a:lnTo>
                  <a:pt x="638" y="524"/>
                </a:lnTo>
                <a:lnTo>
                  <a:pt x="639" y="524"/>
                </a:lnTo>
                <a:lnTo>
                  <a:pt x="641" y="524"/>
                </a:lnTo>
                <a:lnTo>
                  <a:pt x="642" y="524"/>
                </a:lnTo>
                <a:lnTo>
                  <a:pt x="643" y="524"/>
                </a:lnTo>
                <a:lnTo>
                  <a:pt x="645" y="524"/>
                </a:lnTo>
                <a:lnTo>
                  <a:pt x="646" y="524"/>
                </a:lnTo>
                <a:lnTo>
                  <a:pt x="648" y="524"/>
                </a:lnTo>
                <a:lnTo>
                  <a:pt x="649" y="524"/>
                </a:lnTo>
                <a:lnTo>
                  <a:pt x="651" y="524"/>
                </a:lnTo>
                <a:lnTo>
                  <a:pt x="652" y="524"/>
                </a:lnTo>
                <a:lnTo>
                  <a:pt x="653" y="524"/>
                </a:lnTo>
                <a:lnTo>
                  <a:pt x="655" y="524"/>
                </a:lnTo>
                <a:lnTo>
                  <a:pt x="656" y="524"/>
                </a:lnTo>
                <a:lnTo>
                  <a:pt x="658" y="524"/>
                </a:lnTo>
                <a:lnTo>
                  <a:pt x="659" y="524"/>
                </a:lnTo>
                <a:lnTo>
                  <a:pt x="661" y="524"/>
                </a:lnTo>
                <a:lnTo>
                  <a:pt x="662" y="524"/>
                </a:lnTo>
                <a:lnTo>
                  <a:pt x="663" y="524"/>
                </a:lnTo>
                <a:lnTo>
                  <a:pt x="665" y="524"/>
                </a:lnTo>
                <a:lnTo>
                  <a:pt x="666" y="524"/>
                </a:lnTo>
                <a:lnTo>
                  <a:pt x="668" y="524"/>
                </a:lnTo>
                <a:lnTo>
                  <a:pt x="669" y="524"/>
                </a:lnTo>
                <a:lnTo>
                  <a:pt x="671" y="524"/>
                </a:lnTo>
                <a:lnTo>
                  <a:pt x="672" y="524"/>
                </a:lnTo>
                <a:lnTo>
                  <a:pt x="674" y="524"/>
                </a:lnTo>
                <a:lnTo>
                  <a:pt x="675" y="524"/>
                </a:lnTo>
                <a:lnTo>
                  <a:pt x="676" y="524"/>
                </a:lnTo>
                <a:lnTo>
                  <a:pt x="678" y="524"/>
                </a:lnTo>
                <a:lnTo>
                  <a:pt x="679" y="524"/>
                </a:lnTo>
                <a:lnTo>
                  <a:pt x="681" y="524"/>
                </a:lnTo>
                <a:lnTo>
                  <a:pt x="682" y="524"/>
                </a:lnTo>
                <a:lnTo>
                  <a:pt x="684" y="524"/>
                </a:lnTo>
                <a:lnTo>
                  <a:pt x="685" y="524"/>
                </a:lnTo>
                <a:lnTo>
                  <a:pt x="686" y="524"/>
                </a:lnTo>
                <a:lnTo>
                  <a:pt x="688" y="524"/>
                </a:lnTo>
                <a:lnTo>
                  <a:pt x="689" y="524"/>
                </a:lnTo>
                <a:lnTo>
                  <a:pt x="691" y="524"/>
                </a:lnTo>
                <a:lnTo>
                  <a:pt x="692" y="524"/>
                </a:lnTo>
                <a:lnTo>
                  <a:pt x="694" y="524"/>
                </a:lnTo>
                <a:lnTo>
                  <a:pt x="695" y="524"/>
                </a:lnTo>
                <a:lnTo>
                  <a:pt x="697" y="524"/>
                </a:lnTo>
                <a:lnTo>
                  <a:pt x="698" y="524"/>
                </a:lnTo>
                <a:lnTo>
                  <a:pt x="699" y="524"/>
                </a:lnTo>
                <a:lnTo>
                  <a:pt x="701" y="524"/>
                </a:lnTo>
                <a:lnTo>
                  <a:pt x="702" y="524"/>
                </a:lnTo>
                <a:lnTo>
                  <a:pt x="704" y="524"/>
                </a:lnTo>
                <a:lnTo>
                  <a:pt x="705" y="524"/>
                </a:lnTo>
                <a:lnTo>
                  <a:pt x="707" y="524"/>
                </a:lnTo>
                <a:lnTo>
                  <a:pt x="708" y="524"/>
                </a:lnTo>
                <a:lnTo>
                  <a:pt x="709" y="524"/>
                </a:lnTo>
                <a:lnTo>
                  <a:pt x="711" y="524"/>
                </a:lnTo>
                <a:lnTo>
                  <a:pt x="712" y="524"/>
                </a:lnTo>
                <a:lnTo>
                  <a:pt x="714" y="524"/>
                </a:lnTo>
                <a:lnTo>
                  <a:pt x="715" y="524"/>
                </a:lnTo>
                <a:lnTo>
                  <a:pt x="717" y="524"/>
                </a:lnTo>
                <a:lnTo>
                  <a:pt x="718" y="524"/>
                </a:lnTo>
                <a:lnTo>
                  <a:pt x="719" y="524"/>
                </a:lnTo>
                <a:lnTo>
                  <a:pt x="721" y="524"/>
                </a:lnTo>
                <a:lnTo>
                  <a:pt x="722" y="524"/>
                </a:lnTo>
                <a:lnTo>
                  <a:pt x="724" y="524"/>
                </a:lnTo>
                <a:lnTo>
                  <a:pt x="725" y="524"/>
                </a:lnTo>
                <a:lnTo>
                  <a:pt x="727" y="524"/>
                </a:lnTo>
                <a:lnTo>
                  <a:pt x="728" y="524"/>
                </a:lnTo>
                <a:lnTo>
                  <a:pt x="730" y="524"/>
                </a:lnTo>
                <a:lnTo>
                  <a:pt x="731" y="524"/>
                </a:lnTo>
                <a:lnTo>
                  <a:pt x="732" y="524"/>
                </a:lnTo>
                <a:lnTo>
                  <a:pt x="734" y="524"/>
                </a:lnTo>
                <a:lnTo>
                  <a:pt x="735" y="524"/>
                </a:lnTo>
                <a:lnTo>
                  <a:pt x="737" y="524"/>
                </a:lnTo>
                <a:lnTo>
                  <a:pt x="738" y="524"/>
                </a:lnTo>
                <a:lnTo>
                  <a:pt x="740" y="524"/>
                </a:lnTo>
                <a:lnTo>
                  <a:pt x="741" y="524"/>
                </a:lnTo>
                <a:lnTo>
                  <a:pt x="742" y="524"/>
                </a:lnTo>
                <a:lnTo>
                  <a:pt x="744" y="524"/>
                </a:lnTo>
                <a:lnTo>
                  <a:pt x="745" y="524"/>
                </a:lnTo>
                <a:lnTo>
                  <a:pt x="747" y="524"/>
                </a:lnTo>
                <a:lnTo>
                  <a:pt x="748" y="524"/>
                </a:lnTo>
                <a:lnTo>
                  <a:pt x="750" y="524"/>
                </a:lnTo>
                <a:lnTo>
                  <a:pt x="751" y="524"/>
                </a:lnTo>
                <a:lnTo>
                  <a:pt x="753" y="524"/>
                </a:lnTo>
                <a:lnTo>
                  <a:pt x="754" y="524"/>
                </a:lnTo>
                <a:lnTo>
                  <a:pt x="755" y="524"/>
                </a:lnTo>
                <a:lnTo>
                  <a:pt x="757" y="524"/>
                </a:lnTo>
                <a:lnTo>
                  <a:pt x="758" y="524"/>
                </a:lnTo>
                <a:lnTo>
                  <a:pt x="760" y="524"/>
                </a:lnTo>
                <a:lnTo>
                  <a:pt x="761" y="524"/>
                </a:lnTo>
                <a:lnTo>
                  <a:pt x="763" y="524"/>
                </a:lnTo>
                <a:lnTo>
                  <a:pt x="764" y="524"/>
                </a:lnTo>
                <a:lnTo>
                  <a:pt x="765" y="524"/>
                </a:lnTo>
                <a:lnTo>
                  <a:pt x="767" y="524"/>
                </a:lnTo>
                <a:lnTo>
                  <a:pt x="768" y="524"/>
                </a:lnTo>
                <a:lnTo>
                  <a:pt x="770" y="524"/>
                </a:lnTo>
                <a:lnTo>
                  <a:pt x="771" y="524"/>
                </a:lnTo>
                <a:lnTo>
                  <a:pt x="773" y="524"/>
                </a:lnTo>
                <a:lnTo>
                  <a:pt x="774" y="524"/>
                </a:lnTo>
                <a:lnTo>
                  <a:pt x="775" y="524"/>
                </a:lnTo>
                <a:lnTo>
                  <a:pt x="777" y="524"/>
                </a:lnTo>
                <a:lnTo>
                  <a:pt x="778" y="524"/>
                </a:lnTo>
                <a:lnTo>
                  <a:pt x="780" y="524"/>
                </a:lnTo>
                <a:lnTo>
                  <a:pt x="781" y="524"/>
                </a:lnTo>
                <a:lnTo>
                  <a:pt x="783" y="524"/>
                </a:lnTo>
                <a:lnTo>
                  <a:pt x="784" y="524"/>
                </a:lnTo>
                <a:lnTo>
                  <a:pt x="786" y="524"/>
                </a:lnTo>
                <a:lnTo>
                  <a:pt x="787" y="524"/>
                </a:lnTo>
                <a:lnTo>
                  <a:pt x="788" y="524"/>
                </a:lnTo>
                <a:lnTo>
                  <a:pt x="790" y="524"/>
                </a:lnTo>
                <a:lnTo>
                  <a:pt x="791" y="524"/>
                </a:lnTo>
                <a:lnTo>
                  <a:pt x="793" y="524"/>
                </a:lnTo>
                <a:lnTo>
                  <a:pt x="794" y="524"/>
                </a:lnTo>
                <a:lnTo>
                  <a:pt x="796" y="524"/>
                </a:lnTo>
                <a:lnTo>
                  <a:pt x="797" y="524"/>
                </a:lnTo>
                <a:lnTo>
                  <a:pt x="798" y="524"/>
                </a:lnTo>
                <a:lnTo>
                  <a:pt x="800" y="524"/>
                </a:lnTo>
                <a:lnTo>
                  <a:pt x="801" y="524"/>
                </a:lnTo>
                <a:lnTo>
                  <a:pt x="803" y="524"/>
                </a:lnTo>
                <a:lnTo>
                  <a:pt x="804" y="524"/>
                </a:lnTo>
                <a:lnTo>
                  <a:pt x="806" y="524"/>
                </a:lnTo>
                <a:lnTo>
                  <a:pt x="807" y="524"/>
                </a:lnTo>
                <a:lnTo>
                  <a:pt x="809" y="524"/>
                </a:lnTo>
                <a:lnTo>
                  <a:pt x="810" y="524"/>
                </a:lnTo>
                <a:lnTo>
                  <a:pt x="811" y="524"/>
                </a:lnTo>
                <a:lnTo>
                  <a:pt x="813" y="524"/>
                </a:lnTo>
                <a:lnTo>
                  <a:pt x="814" y="524"/>
                </a:lnTo>
                <a:lnTo>
                  <a:pt x="816" y="524"/>
                </a:lnTo>
                <a:lnTo>
                  <a:pt x="817" y="524"/>
                </a:lnTo>
                <a:lnTo>
                  <a:pt x="819" y="524"/>
                </a:lnTo>
                <a:lnTo>
                  <a:pt x="820" y="524"/>
                </a:lnTo>
                <a:lnTo>
                  <a:pt x="821" y="524"/>
                </a:lnTo>
                <a:lnTo>
                  <a:pt x="823" y="524"/>
                </a:lnTo>
                <a:lnTo>
                  <a:pt x="824" y="524"/>
                </a:lnTo>
                <a:lnTo>
                  <a:pt x="826" y="524"/>
                </a:lnTo>
                <a:lnTo>
                  <a:pt x="827" y="524"/>
                </a:lnTo>
                <a:lnTo>
                  <a:pt x="829" y="524"/>
                </a:lnTo>
                <a:lnTo>
                  <a:pt x="830" y="524"/>
                </a:lnTo>
                <a:lnTo>
                  <a:pt x="832" y="524"/>
                </a:lnTo>
                <a:lnTo>
                  <a:pt x="833" y="524"/>
                </a:lnTo>
                <a:lnTo>
                  <a:pt x="834" y="524"/>
                </a:lnTo>
                <a:lnTo>
                  <a:pt x="836" y="524"/>
                </a:lnTo>
                <a:lnTo>
                  <a:pt x="837" y="524"/>
                </a:lnTo>
                <a:lnTo>
                  <a:pt x="839" y="524"/>
                </a:lnTo>
                <a:lnTo>
                  <a:pt x="840" y="524"/>
                </a:lnTo>
                <a:lnTo>
                  <a:pt x="842" y="524"/>
                </a:lnTo>
                <a:lnTo>
                  <a:pt x="843" y="524"/>
                </a:lnTo>
                <a:lnTo>
                  <a:pt x="844" y="524"/>
                </a:lnTo>
                <a:lnTo>
                  <a:pt x="846" y="524"/>
                </a:lnTo>
                <a:lnTo>
                  <a:pt x="847" y="524"/>
                </a:lnTo>
                <a:lnTo>
                  <a:pt x="849" y="524"/>
                </a:lnTo>
                <a:lnTo>
                  <a:pt x="850" y="524"/>
                </a:lnTo>
                <a:lnTo>
                  <a:pt x="852" y="524"/>
                </a:lnTo>
                <a:lnTo>
                  <a:pt x="853" y="524"/>
                </a:lnTo>
                <a:lnTo>
                  <a:pt x="854" y="524"/>
                </a:lnTo>
                <a:lnTo>
                  <a:pt x="856" y="524"/>
                </a:lnTo>
                <a:lnTo>
                  <a:pt x="857" y="524"/>
                </a:lnTo>
                <a:lnTo>
                  <a:pt x="859" y="524"/>
                </a:lnTo>
                <a:lnTo>
                  <a:pt x="860" y="524"/>
                </a:lnTo>
                <a:lnTo>
                  <a:pt x="862" y="524"/>
                </a:lnTo>
                <a:lnTo>
                  <a:pt x="863" y="524"/>
                </a:lnTo>
                <a:lnTo>
                  <a:pt x="865" y="524"/>
                </a:lnTo>
                <a:lnTo>
                  <a:pt x="866" y="524"/>
                </a:lnTo>
                <a:lnTo>
                  <a:pt x="867" y="524"/>
                </a:lnTo>
                <a:lnTo>
                  <a:pt x="869" y="524"/>
                </a:lnTo>
                <a:lnTo>
                  <a:pt x="870" y="524"/>
                </a:lnTo>
                <a:lnTo>
                  <a:pt x="872" y="524"/>
                </a:lnTo>
                <a:lnTo>
                  <a:pt x="873" y="524"/>
                </a:lnTo>
                <a:lnTo>
                  <a:pt x="875" y="524"/>
                </a:lnTo>
                <a:lnTo>
                  <a:pt x="876" y="524"/>
                </a:lnTo>
                <a:lnTo>
                  <a:pt x="877" y="524"/>
                </a:lnTo>
                <a:lnTo>
                  <a:pt x="879" y="524"/>
                </a:lnTo>
                <a:lnTo>
                  <a:pt x="880" y="524"/>
                </a:lnTo>
                <a:lnTo>
                  <a:pt x="882" y="524"/>
                </a:lnTo>
                <a:lnTo>
                  <a:pt x="883" y="524"/>
                </a:lnTo>
                <a:lnTo>
                  <a:pt x="885" y="524"/>
                </a:lnTo>
                <a:lnTo>
                  <a:pt x="886" y="524"/>
                </a:lnTo>
                <a:lnTo>
                  <a:pt x="888" y="524"/>
                </a:lnTo>
                <a:lnTo>
                  <a:pt x="889" y="524"/>
                </a:lnTo>
                <a:lnTo>
                  <a:pt x="890" y="524"/>
                </a:lnTo>
                <a:lnTo>
                  <a:pt x="892" y="524"/>
                </a:lnTo>
                <a:lnTo>
                  <a:pt x="893" y="524"/>
                </a:lnTo>
                <a:lnTo>
                  <a:pt x="895" y="524"/>
                </a:lnTo>
                <a:lnTo>
                  <a:pt x="896" y="524"/>
                </a:lnTo>
                <a:lnTo>
                  <a:pt x="898" y="524"/>
                </a:lnTo>
                <a:lnTo>
                  <a:pt x="899" y="524"/>
                </a:lnTo>
                <a:lnTo>
                  <a:pt x="900" y="524"/>
                </a:lnTo>
                <a:lnTo>
                  <a:pt x="902" y="524"/>
                </a:lnTo>
                <a:lnTo>
                  <a:pt x="903" y="524"/>
                </a:lnTo>
                <a:lnTo>
                  <a:pt x="905" y="524"/>
                </a:lnTo>
                <a:lnTo>
                  <a:pt x="906" y="524"/>
                </a:lnTo>
                <a:lnTo>
                  <a:pt x="908" y="524"/>
                </a:lnTo>
                <a:lnTo>
                  <a:pt x="909" y="524"/>
                </a:lnTo>
                <a:lnTo>
                  <a:pt x="910" y="524"/>
                </a:lnTo>
                <a:lnTo>
                  <a:pt x="912" y="524"/>
                </a:lnTo>
                <a:lnTo>
                  <a:pt x="913" y="524"/>
                </a:lnTo>
                <a:lnTo>
                  <a:pt x="915" y="524"/>
                </a:lnTo>
                <a:lnTo>
                  <a:pt x="916" y="524"/>
                </a:lnTo>
                <a:lnTo>
                  <a:pt x="918" y="524"/>
                </a:lnTo>
                <a:lnTo>
                  <a:pt x="919" y="524"/>
                </a:lnTo>
                <a:lnTo>
                  <a:pt x="921" y="524"/>
                </a:lnTo>
                <a:lnTo>
                  <a:pt x="922" y="524"/>
                </a:lnTo>
                <a:lnTo>
                  <a:pt x="923" y="524"/>
                </a:lnTo>
                <a:lnTo>
                  <a:pt x="925" y="524"/>
                </a:lnTo>
                <a:lnTo>
                  <a:pt x="926" y="524"/>
                </a:lnTo>
                <a:lnTo>
                  <a:pt x="928" y="524"/>
                </a:lnTo>
                <a:lnTo>
                  <a:pt x="929" y="524"/>
                </a:lnTo>
                <a:lnTo>
                  <a:pt x="931" y="524"/>
                </a:lnTo>
                <a:lnTo>
                  <a:pt x="932" y="524"/>
                </a:lnTo>
                <a:lnTo>
                  <a:pt x="933" y="524"/>
                </a:lnTo>
                <a:lnTo>
                  <a:pt x="935" y="524"/>
                </a:lnTo>
                <a:lnTo>
                  <a:pt x="936" y="524"/>
                </a:lnTo>
                <a:lnTo>
                  <a:pt x="938" y="524"/>
                </a:lnTo>
                <a:lnTo>
                  <a:pt x="939" y="524"/>
                </a:lnTo>
                <a:lnTo>
                  <a:pt x="941" y="524"/>
                </a:lnTo>
                <a:lnTo>
                  <a:pt x="942" y="524"/>
                </a:lnTo>
                <a:lnTo>
                  <a:pt x="944" y="524"/>
                </a:lnTo>
                <a:lnTo>
                  <a:pt x="945" y="524"/>
                </a:lnTo>
                <a:lnTo>
                  <a:pt x="946" y="524"/>
                </a:lnTo>
                <a:lnTo>
                  <a:pt x="948" y="524"/>
                </a:lnTo>
                <a:lnTo>
                  <a:pt x="949" y="524"/>
                </a:lnTo>
                <a:lnTo>
                  <a:pt x="951" y="524"/>
                </a:lnTo>
                <a:lnTo>
                  <a:pt x="952" y="524"/>
                </a:lnTo>
                <a:lnTo>
                  <a:pt x="954" y="524"/>
                </a:lnTo>
                <a:lnTo>
                  <a:pt x="955" y="524"/>
                </a:lnTo>
                <a:lnTo>
                  <a:pt x="956" y="524"/>
                </a:lnTo>
                <a:lnTo>
                  <a:pt x="958" y="524"/>
                </a:lnTo>
                <a:lnTo>
                  <a:pt x="959" y="524"/>
                </a:lnTo>
                <a:lnTo>
                  <a:pt x="961" y="524"/>
                </a:lnTo>
                <a:lnTo>
                  <a:pt x="962" y="524"/>
                </a:lnTo>
                <a:lnTo>
                  <a:pt x="964" y="524"/>
                </a:lnTo>
                <a:lnTo>
                  <a:pt x="965" y="524"/>
                </a:lnTo>
                <a:lnTo>
                  <a:pt x="966" y="524"/>
                </a:lnTo>
                <a:lnTo>
                  <a:pt x="968" y="524"/>
                </a:lnTo>
                <a:lnTo>
                  <a:pt x="969" y="524"/>
                </a:lnTo>
                <a:lnTo>
                  <a:pt x="969" y="521"/>
                </a:lnTo>
                <a:lnTo>
                  <a:pt x="969" y="524"/>
                </a:lnTo>
                <a:lnTo>
                  <a:pt x="969" y="521"/>
                </a:lnTo>
                <a:lnTo>
                  <a:pt x="971" y="521"/>
                </a:lnTo>
                <a:lnTo>
                  <a:pt x="971" y="524"/>
                </a:lnTo>
                <a:lnTo>
                  <a:pt x="972" y="524"/>
                </a:lnTo>
                <a:lnTo>
                  <a:pt x="974" y="524"/>
                </a:lnTo>
                <a:lnTo>
                  <a:pt x="975" y="524"/>
                </a:lnTo>
                <a:lnTo>
                  <a:pt x="977" y="524"/>
                </a:lnTo>
                <a:lnTo>
                  <a:pt x="978" y="524"/>
                </a:lnTo>
                <a:lnTo>
                  <a:pt x="979" y="524"/>
                </a:lnTo>
                <a:lnTo>
                  <a:pt x="981" y="524"/>
                </a:lnTo>
                <a:lnTo>
                  <a:pt x="982" y="524"/>
                </a:lnTo>
                <a:lnTo>
                  <a:pt x="984" y="524"/>
                </a:lnTo>
                <a:lnTo>
                  <a:pt x="985" y="524"/>
                </a:lnTo>
                <a:lnTo>
                  <a:pt x="987" y="524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sp>
        <p:nvSpPr>
          <p:cNvPr id="84" name="Rectangle 142"/>
          <p:cNvSpPr>
            <a:spLocks noChangeArrowheads="1"/>
          </p:cNvSpPr>
          <p:nvPr/>
        </p:nvSpPr>
        <p:spPr bwMode="auto">
          <a:xfrm>
            <a:off x="2127250" y="4399214"/>
            <a:ext cx="839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315.051201 [M-H]</a:t>
            </a:r>
            <a:r>
              <a:rPr kumimoji="0" lang="en-US" altLang="en-US" sz="8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-</a:t>
            </a:r>
            <a:endParaRPr kumimoji="0" lang="en-US" altLang="en-US" sz="800" b="0" i="0" u="none" strike="noStrike" cap="none" normalizeH="0" baseline="30000" dirty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85" name="Rectangle 143"/>
          <p:cNvSpPr>
            <a:spLocks noChangeArrowheads="1"/>
          </p:cNvSpPr>
          <p:nvPr/>
        </p:nvSpPr>
        <p:spPr bwMode="auto">
          <a:xfrm>
            <a:off x="2232025" y="5181600"/>
            <a:ext cx="52578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316.05399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86" name="Rectangle 144"/>
          <p:cNvSpPr>
            <a:spLocks noChangeArrowheads="1"/>
          </p:cNvSpPr>
          <p:nvPr/>
        </p:nvSpPr>
        <p:spPr bwMode="auto">
          <a:xfrm>
            <a:off x="2336800" y="5310309"/>
            <a:ext cx="52578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</a:rPr>
              <a:t>317.056390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92" name="Rectangle 150"/>
          <p:cNvSpPr>
            <a:spLocks noChangeArrowheads="1"/>
          </p:cNvSpPr>
          <p:nvPr/>
        </p:nvSpPr>
        <p:spPr bwMode="auto">
          <a:xfrm>
            <a:off x="2105025" y="4391758"/>
            <a:ext cx="1568450" cy="1084263"/>
          </a:xfrm>
          <a:prstGeom prst="rect">
            <a:avLst/>
          </a:prstGeom>
          <a:noFill/>
          <a:ln w="1588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>
              <a:latin typeface="Cambria" panose="02040503050406030204" pitchFamily="18" charset="0"/>
            </a:endParaRPr>
          </a:p>
        </p:txBody>
      </p:sp>
      <p:graphicFrame>
        <p:nvGraphicFramePr>
          <p:cNvPr id="93" name="Object 9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4072910"/>
              </p:ext>
            </p:extLst>
          </p:nvPr>
        </p:nvGraphicFramePr>
        <p:xfrm>
          <a:off x="2484120" y="4575666"/>
          <a:ext cx="1111642" cy="7410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49" name="CS ChemDraw Drawing" r:id="rId4" imgW="1536084" imgH="1014984" progId="ChemDraw.Document.6.0">
                  <p:embed/>
                </p:oleObj>
              </mc:Choice>
              <mc:Fallback>
                <p:oleObj name="CS ChemDraw Drawing" r:id="rId4" imgW="1536084" imgH="1014984" progId="ChemDraw.Document.6.0">
                  <p:embed/>
                  <p:pic>
                    <p:nvPicPr>
                      <p:cNvPr id="0" name="Object 19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84120" y="4575666"/>
                        <a:ext cx="1111642" cy="7410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273270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52400" y="5867400"/>
            <a:ext cx="8839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etection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enzodioxan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substructures in lignin from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mr12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sorghum biomas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or each genotype, cellulolytic lignin was isolated and analyzed by 2D 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–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 HSQC NMR spectroscopy. Regions of partial short-range 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–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 HSQC spectra (aliphatic region) displaying the major lignin interunit structure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re shown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 =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the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–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´)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 =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henylcoumara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´), and H =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nzodioxan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0158" y="4454273"/>
            <a:ext cx="1231900" cy="9906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73860" y="4454273"/>
            <a:ext cx="1231900" cy="1016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60443" y="4454273"/>
            <a:ext cx="1231900" cy="10414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0880" y="556047"/>
            <a:ext cx="3684693" cy="3657600"/>
          </a:xfrm>
          <a:prstGeom prst="rect">
            <a:avLst/>
          </a:prstGeom>
        </p:spPr>
      </p:pic>
      <p:sp>
        <p:nvSpPr>
          <p:cNvPr id="9" name="Oval 8"/>
          <p:cNvSpPr/>
          <p:nvPr/>
        </p:nvSpPr>
        <p:spPr>
          <a:xfrm>
            <a:off x="1524000" y="2690937"/>
            <a:ext cx="385548" cy="215465"/>
          </a:xfrm>
          <a:prstGeom prst="ellipse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Oval 9"/>
          <p:cNvSpPr/>
          <p:nvPr/>
        </p:nvSpPr>
        <p:spPr>
          <a:xfrm>
            <a:off x="2296703" y="2877782"/>
            <a:ext cx="332197" cy="215465"/>
          </a:xfrm>
          <a:prstGeom prst="ellipse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48200" y="554771"/>
            <a:ext cx="3671147" cy="36576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762000" y="571774"/>
            <a:ext cx="4999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595085" y="536104"/>
            <a:ext cx="7877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mr12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09344" y="4330700"/>
            <a:ext cx="1092200" cy="1231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72453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 contrast="-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32" t="64733" r="3723" b="3155"/>
          <a:stretch/>
        </p:blipFill>
        <p:spPr>
          <a:xfrm rot="5400000" flipH="1">
            <a:off x="2763503" y="1953277"/>
            <a:ext cx="3853215" cy="101346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91253" y="4498538"/>
            <a:ext cx="88765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DS-PAGE of purified recombinant his-tagged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bCOMT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1 µg) staine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oomassi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Brilliant Blue. </a:t>
            </a:r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pproximate size is 42.3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iz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markers are indicated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</p:txBody>
      </p:sp>
      <p:cxnSp>
        <p:nvCxnSpPr>
          <p:cNvPr id="6" name="Straight Connector 5"/>
          <p:cNvCxnSpPr/>
          <p:nvPr/>
        </p:nvCxnSpPr>
        <p:spPr>
          <a:xfrm>
            <a:off x="3962400" y="642962"/>
            <a:ext cx="2286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962400" y="840451"/>
            <a:ext cx="2286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3962400" y="1073449"/>
            <a:ext cx="2286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3962400" y="1359003"/>
            <a:ext cx="2286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3962400" y="1630885"/>
            <a:ext cx="2286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3977640" y="2296894"/>
            <a:ext cx="2286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985260" y="2741445"/>
            <a:ext cx="2286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3977640" y="3568839"/>
            <a:ext cx="2286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3962400" y="4271650"/>
            <a:ext cx="2286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619500" y="251460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604260" y="49095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604260" y="70061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612664" y="93361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688080" y="121916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688080" y="149372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703320" y="215705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710940" y="259398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703320" y="34290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688080" y="413181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 flipH="1">
            <a:off x="5280660" y="2108656"/>
            <a:ext cx="62484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852160" y="1955661"/>
            <a:ext cx="1824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bCOM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his (42.3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39200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256"/>
          <a:stretch/>
        </p:blipFill>
        <p:spPr bwMode="auto">
          <a:xfrm>
            <a:off x="2057400" y="1526452"/>
            <a:ext cx="5924550" cy="31035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ctangle 4"/>
          <p:cNvSpPr>
            <a:spLocks noChangeAspect="1"/>
          </p:cNvSpPr>
          <p:nvPr/>
        </p:nvSpPr>
        <p:spPr>
          <a:xfrm>
            <a:off x="152406" y="1850943"/>
            <a:ext cx="137160" cy="137160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251460" y="1772951"/>
            <a:ext cx="28661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ambria" panose="02040503050406030204" pitchFamily="18" charset="0"/>
              </a:rPr>
              <a:t>Genetically involved in S lignin synthesis </a:t>
            </a:r>
            <a:endParaRPr lang="en-US" sz="1200" dirty="0">
              <a:latin typeface="Cambria" panose="02040503050406030204" pitchFamily="18" charset="0"/>
            </a:endParaRPr>
          </a:p>
        </p:txBody>
      </p:sp>
      <p:sp>
        <p:nvSpPr>
          <p:cNvPr id="9" name="Rectangle 8"/>
          <p:cNvSpPr>
            <a:spLocks noChangeAspect="1"/>
          </p:cNvSpPr>
          <p:nvPr/>
        </p:nvSpPr>
        <p:spPr>
          <a:xfrm>
            <a:off x="152400" y="2330110"/>
            <a:ext cx="137160" cy="137160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251454" y="2252118"/>
            <a:ext cx="27347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ambria" panose="02040503050406030204" pitchFamily="18" charset="0"/>
              </a:rPr>
              <a:t>Genetically involved in </a:t>
            </a:r>
            <a:r>
              <a:rPr lang="en-US" sz="1200" dirty="0" err="1" smtClean="0">
                <a:latin typeface="Cambria" panose="02040503050406030204" pitchFamily="18" charset="0"/>
              </a:rPr>
              <a:t>tricin</a:t>
            </a:r>
            <a:r>
              <a:rPr lang="en-US" sz="1200" dirty="0" smtClean="0">
                <a:latin typeface="Cambria" panose="02040503050406030204" pitchFamily="18" charset="0"/>
              </a:rPr>
              <a:t> synthesis </a:t>
            </a:r>
            <a:endParaRPr lang="en-US" sz="1200" dirty="0">
              <a:latin typeface="Cambria" panose="02040503050406030204" pitchFamily="18" charset="0"/>
            </a:endParaRPr>
          </a:p>
        </p:txBody>
      </p:sp>
      <p:sp>
        <p:nvSpPr>
          <p:cNvPr id="11" name="Rectangle 10"/>
          <p:cNvSpPr>
            <a:spLocks noChangeAspect="1"/>
          </p:cNvSpPr>
          <p:nvPr/>
        </p:nvSpPr>
        <p:spPr>
          <a:xfrm>
            <a:off x="152400" y="2083649"/>
            <a:ext cx="137160" cy="137160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251454" y="2005657"/>
            <a:ext cx="29270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ambria" panose="02040503050406030204" pitchFamily="18" charset="0"/>
              </a:rPr>
              <a:t>Biochemically involved in </a:t>
            </a:r>
            <a:r>
              <a:rPr lang="en-US" sz="1200" dirty="0" err="1" smtClean="0">
                <a:latin typeface="Cambria" panose="02040503050406030204" pitchFamily="18" charset="0"/>
              </a:rPr>
              <a:t>tricin</a:t>
            </a:r>
            <a:r>
              <a:rPr lang="en-US" sz="1200" dirty="0" smtClean="0">
                <a:latin typeface="Cambria" panose="02040503050406030204" pitchFamily="18" charset="0"/>
              </a:rPr>
              <a:t> synthesis </a:t>
            </a:r>
            <a:endParaRPr lang="en-US" sz="1200" dirty="0">
              <a:latin typeface="Cambria" panose="02040503050406030204" pitchFamily="18" charset="0"/>
            </a:endParaRPr>
          </a:p>
        </p:txBody>
      </p:sp>
      <p:sp>
        <p:nvSpPr>
          <p:cNvPr id="16" name="Rectangle 15"/>
          <p:cNvSpPr>
            <a:spLocks noChangeAspect="1"/>
          </p:cNvSpPr>
          <p:nvPr/>
        </p:nvSpPr>
        <p:spPr>
          <a:xfrm>
            <a:off x="7396370" y="1969071"/>
            <a:ext cx="137160" cy="137160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>
            <a:spLocks noChangeAspect="1"/>
          </p:cNvSpPr>
          <p:nvPr/>
        </p:nvSpPr>
        <p:spPr>
          <a:xfrm>
            <a:off x="6791740" y="2520701"/>
            <a:ext cx="137160" cy="137160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>
            <a:spLocks noChangeAspect="1"/>
          </p:cNvSpPr>
          <p:nvPr/>
        </p:nvSpPr>
        <p:spPr>
          <a:xfrm>
            <a:off x="6452150" y="2797001"/>
            <a:ext cx="137160" cy="137160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>
            <a:spLocks noChangeAspect="1"/>
          </p:cNvSpPr>
          <p:nvPr/>
        </p:nvSpPr>
        <p:spPr>
          <a:xfrm>
            <a:off x="6618294" y="2797001"/>
            <a:ext cx="137160" cy="137160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>
            <a:spLocks noChangeAspect="1"/>
          </p:cNvSpPr>
          <p:nvPr/>
        </p:nvSpPr>
        <p:spPr>
          <a:xfrm>
            <a:off x="5794520" y="3080271"/>
            <a:ext cx="137160" cy="137160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>
            <a:spLocks noChangeAspect="1"/>
          </p:cNvSpPr>
          <p:nvPr/>
        </p:nvSpPr>
        <p:spPr>
          <a:xfrm>
            <a:off x="6725810" y="3350611"/>
            <a:ext cx="137160" cy="137160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>
            <a:spLocks noChangeAspect="1"/>
          </p:cNvSpPr>
          <p:nvPr/>
        </p:nvSpPr>
        <p:spPr>
          <a:xfrm>
            <a:off x="6593620" y="3628581"/>
            <a:ext cx="137160" cy="137160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>
            <a:spLocks noChangeAspect="1"/>
          </p:cNvSpPr>
          <p:nvPr/>
        </p:nvSpPr>
        <p:spPr>
          <a:xfrm>
            <a:off x="6785780" y="3913831"/>
            <a:ext cx="137160" cy="137160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>
            <a:spLocks noChangeAspect="1"/>
          </p:cNvSpPr>
          <p:nvPr/>
        </p:nvSpPr>
        <p:spPr>
          <a:xfrm>
            <a:off x="6637690" y="4178871"/>
            <a:ext cx="137160" cy="137160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>
            <a:spLocks noChangeAspect="1"/>
          </p:cNvSpPr>
          <p:nvPr/>
        </p:nvSpPr>
        <p:spPr>
          <a:xfrm>
            <a:off x="7509340" y="4457171"/>
            <a:ext cx="137160" cy="137160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-4660" y="4623137"/>
            <a:ext cx="912961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ylogenetic analysis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f selected 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methyltransferases from plant species that produce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cin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ccession numbers are: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orghum bicolo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bCOM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ADW65743.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Saccharum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ficinarum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OM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O82054.1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ea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may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mCOM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Q06509.1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nicum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rgatum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vCOM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DX98508.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ryza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sativa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OsCOMT1, XP_015650053.1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achypodium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ystachion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BdCOMT6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XP_003573470.1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olium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enne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LpOMT1, AAD10253.1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ticum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estivum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TaCOMT1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Q84N28.1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ordeum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vulga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vOM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BQ58825.1),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riticum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estivum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TaOMT2, Q38J50.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dicago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sativa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sCOM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28002.1).</a:t>
            </a:r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7345680" y="1929962"/>
            <a:ext cx="2071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Cambria" panose="02040503050406030204" pitchFamily="18" charset="0"/>
              </a:rPr>
              <a:t> </a:t>
            </a:r>
            <a:endParaRPr lang="en-US" sz="800" b="1" dirty="0">
              <a:solidFill>
                <a:schemeClr val="bg1"/>
              </a:solidFill>
              <a:latin typeface="Cambria" panose="020405030504060302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736080" y="2470982"/>
            <a:ext cx="2071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Cambria" panose="02040503050406030204" pitchFamily="18" charset="0"/>
              </a:rPr>
              <a:t> </a:t>
            </a:r>
            <a:endParaRPr lang="en-US" sz="800" b="1" dirty="0">
              <a:solidFill>
                <a:schemeClr val="bg1"/>
              </a:solidFill>
              <a:latin typeface="Cambria" panose="020405030504060302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400800" y="2760542"/>
            <a:ext cx="2071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Cambria" panose="02040503050406030204" pitchFamily="18" charset="0"/>
              </a:rPr>
              <a:t> </a:t>
            </a:r>
            <a:endParaRPr lang="en-US" sz="800" b="1" dirty="0">
              <a:solidFill>
                <a:schemeClr val="bg1"/>
              </a:solidFill>
              <a:latin typeface="Cambria" panose="020405030504060302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566700" y="2760542"/>
            <a:ext cx="2071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Cambria" panose="02040503050406030204" pitchFamily="18" charset="0"/>
              </a:rPr>
              <a:t> </a:t>
            </a:r>
            <a:endParaRPr lang="en-US" sz="800" b="1" dirty="0">
              <a:solidFill>
                <a:schemeClr val="bg1"/>
              </a:solidFill>
              <a:latin typeface="Cambria" panose="020405030504060302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697855" y="3032957"/>
            <a:ext cx="2071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Cambria" panose="02040503050406030204" pitchFamily="18" charset="0"/>
              </a:rPr>
              <a:t> </a:t>
            </a:r>
            <a:endParaRPr lang="en-US" sz="800" b="1" dirty="0">
              <a:solidFill>
                <a:schemeClr val="bg1"/>
              </a:solidFill>
              <a:latin typeface="Cambria" panose="020405030504060302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635280" y="3303646"/>
            <a:ext cx="2071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Cambria" panose="02040503050406030204" pitchFamily="18" charset="0"/>
              </a:rPr>
              <a:t> </a:t>
            </a:r>
            <a:endParaRPr lang="en-US" sz="800" b="1" dirty="0">
              <a:solidFill>
                <a:schemeClr val="bg1"/>
              </a:solidFill>
              <a:latin typeface="Cambria" panose="020405030504060302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504212" y="3585762"/>
            <a:ext cx="2071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Cambria" panose="02040503050406030204" pitchFamily="18" charset="0"/>
              </a:rPr>
              <a:t> </a:t>
            </a:r>
            <a:endParaRPr lang="en-US" sz="800" b="1" dirty="0">
              <a:solidFill>
                <a:schemeClr val="bg1"/>
              </a:solidFill>
              <a:latin typeface="Cambria" panose="020405030504060302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726948" y="3876555"/>
            <a:ext cx="2071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Cambria" panose="02040503050406030204" pitchFamily="18" charset="0"/>
              </a:rPr>
              <a:t> </a:t>
            </a:r>
            <a:endParaRPr lang="en-US" sz="800" b="1" dirty="0">
              <a:solidFill>
                <a:schemeClr val="bg1"/>
              </a:solidFill>
              <a:latin typeface="Cambria" panose="020405030504060302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6543675" y="4132142"/>
            <a:ext cx="2071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Cambria" panose="02040503050406030204" pitchFamily="18" charset="0"/>
              </a:rPr>
              <a:t> </a:t>
            </a:r>
            <a:endParaRPr lang="en-US" sz="800" b="1" dirty="0">
              <a:solidFill>
                <a:schemeClr val="bg1"/>
              </a:solidFill>
              <a:latin typeface="Cambria" panose="020405030504060302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7421581" y="4414547"/>
            <a:ext cx="2071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Cambria" panose="02040503050406030204" pitchFamily="18" charset="0"/>
              </a:rPr>
              <a:t> </a:t>
            </a:r>
            <a:endParaRPr lang="en-US" sz="800" b="1" dirty="0">
              <a:solidFill>
                <a:schemeClr val="bg1"/>
              </a:solidFill>
              <a:latin typeface="Cambria" panose="02040503050406030204" pitchFamily="18" charset="0"/>
            </a:endParaRPr>
          </a:p>
        </p:txBody>
      </p:sp>
      <p:sp>
        <p:nvSpPr>
          <p:cNvPr id="43" name="Rectangle 42"/>
          <p:cNvSpPr>
            <a:spLocks noChangeAspect="1"/>
          </p:cNvSpPr>
          <p:nvPr/>
        </p:nvSpPr>
        <p:spPr>
          <a:xfrm>
            <a:off x="6785940" y="2795029"/>
            <a:ext cx="137160" cy="137160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45"/>
          <p:cNvSpPr txBox="1"/>
          <p:nvPr/>
        </p:nvSpPr>
        <p:spPr>
          <a:xfrm>
            <a:off x="6699505" y="2760047"/>
            <a:ext cx="2071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Cambria" panose="02040503050406030204" pitchFamily="18" charset="0"/>
              </a:rPr>
              <a:t> </a:t>
            </a:r>
            <a:endParaRPr lang="en-US" sz="800" b="1" dirty="0">
              <a:solidFill>
                <a:schemeClr val="bg1"/>
              </a:solidFill>
              <a:latin typeface="Cambria" panose="02040503050406030204" pitchFamily="18" charset="0"/>
            </a:endParaRPr>
          </a:p>
        </p:txBody>
      </p:sp>
      <p:sp>
        <p:nvSpPr>
          <p:cNvPr id="47" name="Rectangle 46"/>
          <p:cNvSpPr>
            <a:spLocks noChangeAspect="1"/>
          </p:cNvSpPr>
          <p:nvPr/>
        </p:nvSpPr>
        <p:spPr>
          <a:xfrm>
            <a:off x="152400" y="2584198"/>
            <a:ext cx="137160" cy="13716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TextBox 47"/>
          <p:cNvSpPr txBox="1"/>
          <p:nvPr/>
        </p:nvSpPr>
        <p:spPr>
          <a:xfrm>
            <a:off x="251454" y="2506206"/>
            <a:ext cx="31290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ambria" panose="02040503050406030204" pitchFamily="18" charset="0"/>
              </a:rPr>
              <a:t>Genetically involved in </a:t>
            </a:r>
            <a:r>
              <a:rPr lang="en-US" sz="1200" dirty="0" err="1" smtClean="0">
                <a:latin typeface="Cambria" panose="02040503050406030204" pitchFamily="18" charset="0"/>
              </a:rPr>
              <a:t>tricin</a:t>
            </a:r>
            <a:r>
              <a:rPr lang="en-US" sz="1200" dirty="0" smtClean="0">
                <a:latin typeface="Cambria" panose="02040503050406030204" pitchFamily="18" charset="0"/>
              </a:rPr>
              <a:t>-lignin synthesis</a:t>
            </a:r>
          </a:p>
        </p:txBody>
      </p:sp>
      <p:sp>
        <p:nvSpPr>
          <p:cNvPr id="2" name="Rectangle 1"/>
          <p:cNvSpPr/>
          <p:nvPr/>
        </p:nvSpPr>
        <p:spPr>
          <a:xfrm>
            <a:off x="7436820" y="1687342"/>
            <a:ext cx="442260" cy="1580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" name="Group 2"/>
          <p:cNvGrpSpPr/>
          <p:nvPr/>
        </p:nvGrpSpPr>
        <p:grpSpPr>
          <a:xfrm>
            <a:off x="7421880" y="1662767"/>
            <a:ext cx="702944" cy="219338"/>
            <a:chOff x="7391400" y="-7620"/>
            <a:chExt cx="702944" cy="219338"/>
          </a:xfrm>
        </p:grpSpPr>
        <p:sp>
          <p:nvSpPr>
            <p:cNvPr id="13" name="Rectangle 12"/>
            <p:cNvSpPr>
              <a:spLocks noChangeAspect="1"/>
            </p:cNvSpPr>
            <p:nvPr/>
          </p:nvSpPr>
          <p:spPr>
            <a:xfrm>
              <a:off x="7443212" y="37847"/>
              <a:ext cx="137160" cy="137160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/>
            <p:cNvSpPr>
              <a:spLocks noChangeAspect="1"/>
            </p:cNvSpPr>
            <p:nvPr/>
          </p:nvSpPr>
          <p:spPr>
            <a:xfrm>
              <a:off x="7776666" y="37847"/>
              <a:ext cx="137160" cy="137160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/>
            <p:cNvSpPr>
              <a:spLocks noChangeAspect="1"/>
            </p:cNvSpPr>
            <p:nvPr/>
          </p:nvSpPr>
          <p:spPr>
            <a:xfrm>
              <a:off x="7609356" y="37847"/>
              <a:ext cx="137160" cy="137160"/>
            </a:xfrm>
            <a:prstGeom prst="rect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391400" y="-3726"/>
              <a:ext cx="2071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Cambria" panose="02040503050406030204" pitchFamily="18" charset="0"/>
                </a:rPr>
                <a:t> </a:t>
              </a:r>
              <a:endParaRPr lang="en-US" sz="800" b="1" dirty="0">
                <a:solidFill>
                  <a:schemeClr val="bg1"/>
                </a:solidFill>
                <a:latin typeface="Cambria" panose="020405030504060302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7555226" y="-5041"/>
              <a:ext cx="2071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Cambria" panose="02040503050406030204" pitchFamily="18" charset="0"/>
                </a:rPr>
                <a:t> </a:t>
              </a:r>
              <a:endParaRPr lang="en-US" sz="800" b="1" dirty="0">
                <a:solidFill>
                  <a:schemeClr val="bg1"/>
                </a:solidFill>
                <a:latin typeface="Cambria" panose="020405030504060302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7724594" y="-5905"/>
              <a:ext cx="2071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Cambria" panose="02040503050406030204" pitchFamily="18" charset="0"/>
                </a:rPr>
                <a:t> </a:t>
              </a:r>
              <a:endParaRPr lang="en-US" sz="800" b="1" dirty="0">
                <a:solidFill>
                  <a:schemeClr val="bg1"/>
                </a:solidFill>
                <a:latin typeface="Cambria" panose="02040503050406030204" pitchFamily="18" charset="0"/>
              </a:endParaRPr>
            </a:p>
          </p:txBody>
        </p:sp>
        <p:sp>
          <p:nvSpPr>
            <p:cNvPr id="49" name="Rectangle 48"/>
            <p:cNvSpPr>
              <a:spLocks noChangeAspect="1"/>
            </p:cNvSpPr>
            <p:nvPr/>
          </p:nvSpPr>
          <p:spPr>
            <a:xfrm>
              <a:off x="7939308" y="36132"/>
              <a:ext cx="137160" cy="137160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7887236" y="-7620"/>
              <a:ext cx="2071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Cambria" panose="02040503050406030204" pitchFamily="18" charset="0"/>
                </a:rPr>
                <a:t> </a:t>
              </a:r>
              <a:endParaRPr lang="en-US" sz="800" b="1" dirty="0">
                <a:solidFill>
                  <a:schemeClr val="bg1"/>
                </a:solidFill>
                <a:latin typeface="Cambria" panose="02040503050406030204" pitchFamily="18" charset="0"/>
              </a:endParaRPr>
            </a:p>
          </p:txBody>
        </p:sp>
      </p:grpSp>
      <p:sp>
        <p:nvSpPr>
          <p:cNvPr id="4" name="Rectangle 3"/>
          <p:cNvSpPr/>
          <p:nvPr/>
        </p:nvSpPr>
        <p:spPr>
          <a:xfrm>
            <a:off x="7157904" y="2245553"/>
            <a:ext cx="286536" cy="1742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52" name="Group 51"/>
          <p:cNvGrpSpPr/>
          <p:nvPr/>
        </p:nvGrpSpPr>
        <p:grpSpPr>
          <a:xfrm>
            <a:off x="7134225" y="2213312"/>
            <a:ext cx="702944" cy="219338"/>
            <a:chOff x="7391400" y="-7620"/>
            <a:chExt cx="702944" cy="219338"/>
          </a:xfrm>
        </p:grpSpPr>
        <p:sp>
          <p:nvSpPr>
            <p:cNvPr id="53" name="Rectangle 52"/>
            <p:cNvSpPr>
              <a:spLocks noChangeAspect="1"/>
            </p:cNvSpPr>
            <p:nvPr/>
          </p:nvSpPr>
          <p:spPr>
            <a:xfrm>
              <a:off x="7443212" y="37847"/>
              <a:ext cx="137160" cy="137160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Rectangle 53"/>
            <p:cNvSpPr>
              <a:spLocks noChangeAspect="1"/>
            </p:cNvSpPr>
            <p:nvPr/>
          </p:nvSpPr>
          <p:spPr>
            <a:xfrm>
              <a:off x="7776666" y="37847"/>
              <a:ext cx="137160" cy="137160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Rectangle 54"/>
            <p:cNvSpPr>
              <a:spLocks noChangeAspect="1"/>
            </p:cNvSpPr>
            <p:nvPr/>
          </p:nvSpPr>
          <p:spPr>
            <a:xfrm>
              <a:off x="7609356" y="37847"/>
              <a:ext cx="137160" cy="137160"/>
            </a:xfrm>
            <a:prstGeom prst="rect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7391400" y="-3726"/>
              <a:ext cx="2071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Cambria" panose="02040503050406030204" pitchFamily="18" charset="0"/>
                </a:rPr>
                <a:t> </a:t>
              </a:r>
              <a:endParaRPr lang="en-US" sz="800" b="1" dirty="0">
                <a:solidFill>
                  <a:schemeClr val="bg1"/>
                </a:solidFill>
                <a:latin typeface="Cambria" panose="02040503050406030204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7555226" y="-5041"/>
              <a:ext cx="2071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Cambria" panose="02040503050406030204" pitchFamily="18" charset="0"/>
                </a:rPr>
                <a:t> </a:t>
              </a:r>
              <a:endParaRPr lang="en-US" sz="800" b="1" dirty="0">
                <a:solidFill>
                  <a:schemeClr val="bg1"/>
                </a:solidFill>
                <a:latin typeface="Cambria" panose="02040503050406030204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7724594" y="-5905"/>
              <a:ext cx="2071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Cambria" panose="02040503050406030204" pitchFamily="18" charset="0"/>
                </a:rPr>
                <a:t> </a:t>
              </a:r>
              <a:endParaRPr lang="en-US" sz="800" b="1" dirty="0">
                <a:solidFill>
                  <a:schemeClr val="bg1"/>
                </a:solidFill>
                <a:latin typeface="Cambria" panose="02040503050406030204" pitchFamily="18" charset="0"/>
              </a:endParaRPr>
            </a:p>
          </p:txBody>
        </p:sp>
        <p:sp>
          <p:nvSpPr>
            <p:cNvPr id="59" name="Rectangle 58"/>
            <p:cNvSpPr>
              <a:spLocks noChangeAspect="1"/>
            </p:cNvSpPr>
            <p:nvPr/>
          </p:nvSpPr>
          <p:spPr>
            <a:xfrm>
              <a:off x="7939308" y="36132"/>
              <a:ext cx="137160" cy="137160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7887236" y="-7620"/>
              <a:ext cx="2071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Cambria" panose="02040503050406030204" pitchFamily="18" charset="0"/>
                </a:rPr>
                <a:t> </a:t>
              </a:r>
              <a:endParaRPr lang="en-US" sz="800" b="1" dirty="0">
                <a:solidFill>
                  <a:schemeClr val="bg1"/>
                </a:solidFill>
                <a:latin typeface="Cambria" panose="02040503050406030204" pitchFamily="18" charset="0"/>
              </a:endParaRPr>
            </a:p>
          </p:txBody>
        </p:sp>
      </p:grpSp>
      <p:cxnSp>
        <p:nvCxnSpPr>
          <p:cNvPr id="61" name="Straight Connector 60"/>
          <p:cNvCxnSpPr/>
          <p:nvPr/>
        </p:nvCxnSpPr>
        <p:spPr>
          <a:xfrm>
            <a:off x="685800" y="4193064"/>
            <a:ext cx="6858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761839" y="3876036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.05</a:t>
            </a:r>
            <a:endParaRPr lang="en-US" dirty="0"/>
          </a:p>
        </p:txBody>
      </p:sp>
      <p:sp>
        <p:nvSpPr>
          <p:cNvPr id="17" name="Rectangle 16"/>
          <p:cNvSpPr/>
          <p:nvPr/>
        </p:nvSpPr>
        <p:spPr>
          <a:xfrm>
            <a:off x="8011990" y="1569023"/>
            <a:ext cx="105670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16, </a:t>
            </a:r>
            <a:r>
              <a:rPr lang="en-US" sz="1000" smtClean="0">
                <a:latin typeface="Arial" panose="020B0604020202020204" pitchFamily="34" charset="0"/>
                <a:cs typeface="Arial" panose="020B0604020202020204" pitchFamily="34" charset="0"/>
              </a:rPr>
              <a:t>this study) </a:t>
            </a:r>
            <a:endParaRPr lang="fr-FR" sz="1000" dirty="0"/>
          </a:p>
        </p:txBody>
      </p:sp>
      <p:sp>
        <p:nvSpPr>
          <p:cNvPr id="63" name="Rectangle 62"/>
          <p:cNvSpPr/>
          <p:nvPr/>
        </p:nvSpPr>
        <p:spPr>
          <a:xfrm>
            <a:off x="7450390" y="1850835"/>
            <a:ext cx="4475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latin typeface="Arial" panose="020B0604020202020204" pitchFamily="34" charset="0"/>
                <a:cs typeface="Arial" panose="020B0604020202020204" pitchFamily="34" charset="0"/>
              </a:rPr>
              <a:t>(35) </a:t>
            </a:r>
            <a:endParaRPr lang="fr-FR" sz="1000" dirty="0"/>
          </a:p>
        </p:txBody>
      </p:sp>
      <p:sp>
        <p:nvSpPr>
          <p:cNvPr id="64" name="Rectangle 63"/>
          <p:cNvSpPr/>
          <p:nvPr/>
        </p:nvSpPr>
        <p:spPr>
          <a:xfrm>
            <a:off x="7733168" y="2125244"/>
            <a:ext cx="8707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11, 13, 15) </a:t>
            </a:r>
            <a:endParaRPr lang="fr-FR" sz="1000" dirty="0"/>
          </a:p>
        </p:txBody>
      </p:sp>
      <p:sp>
        <p:nvSpPr>
          <p:cNvPr id="65" name="Rectangle 64"/>
          <p:cNvSpPr/>
          <p:nvPr/>
        </p:nvSpPr>
        <p:spPr>
          <a:xfrm>
            <a:off x="6837572" y="2384123"/>
            <a:ext cx="4475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>
                <a:latin typeface="Arial" panose="020B0604020202020204" pitchFamily="34" charset="0"/>
                <a:cs typeface="Arial" panose="020B0604020202020204" pitchFamily="34" charset="0"/>
              </a:rPr>
              <a:t>(3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fr-FR" sz="1000" dirty="0"/>
          </a:p>
        </p:txBody>
      </p:sp>
      <p:sp>
        <p:nvSpPr>
          <p:cNvPr id="66" name="Rectangle 65"/>
          <p:cNvSpPr/>
          <p:nvPr/>
        </p:nvSpPr>
        <p:spPr>
          <a:xfrm>
            <a:off x="6829468" y="2651078"/>
            <a:ext cx="115288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8, 9, 10, 12, 14) </a:t>
            </a:r>
            <a:endParaRPr lang="fr-FR" sz="1000" dirty="0"/>
          </a:p>
        </p:txBody>
      </p:sp>
      <p:sp>
        <p:nvSpPr>
          <p:cNvPr id="67" name="Rectangle 66"/>
          <p:cNvSpPr/>
          <p:nvPr/>
        </p:nvSpPr>
        <p:spPr>
          <a:xfrm>
            <a:off x="5838610" y="2955509"/>
            <a:ext cx="4475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34) </a:t>
            </a:r>
            <a:endParaRPr lang="fr-FR" sz="1000" dirty="0"/>
          </a:p>
        </p:txBody>
      </p:sp>
      <p:sp>
        <p:nvSpPr>
          <p:cNvPr id="68" name="Rectangle 67"/>
          <p:cNvSpPr/>
          <p:nvPr/>
        </p:nvSpPr>
        <p:spPr>
          <a:xfrm>
            <a:off x="6778815" y="3213869"/>
            <a:ext cx="4475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36) </a:t>
            </a:r>
            <a:endParaRPr lang="fr-FR" sz="1000" dirty="0"/>
          </a:p>
        </p:txBody>
      </p:sp>
      <p:sp>
        <p:nvSpPr>
          <p:cNvPr id="69" name="Rectangle 68"/>
          <p:cNvSpPr/>
          <p:nvPr/>
        </p:nvSpPr>
        <p:spPr>
          <a:xfrm>
            <a:off x="6646633" y="3492759"/>
            <a:ext cx="4475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37) </a:t>
            </a:r>
            <a:endParaRPr lang="fr-FR" sz="1000" dirty="0"/>
          </a:p>
        </p:txBody>
      </p:sp>
      <p:sp>
        <p:nvSpPr>
          <p:cNvPr id="70" name="Rectangle 69"/>
          <p:cNvSpPr/>
          <p:nvPr/>
        </p:nvSpPr>
        <p:spPr>
          <a:xfrm>
            <a:off x="6832787" y="3789462"/>
            <a:ext cx="4475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11) </a:t>
            </a:r>
            <a:endParaRPr lang="fr-FR" sz="1000" dirty="0"/>
          </a:p>
        </p:txBody>
      </p:sp>
      <p:sp>
        <p:nvSpPr>
          <p:cNvPr id="71" name="Rectangle 70"/>
          <p:cNvSpPr/>
          <p:nvPr/>
        </p:nvSpPr>
        <p:spPr>
          <a:xfrm>
            <a:off x="6689548" y="4047566"/>
            <a:ext cx="4475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38) </a:t>
            </a:r>
            <a:endParaRPr lang="fr-FR" sz="1000" dirty="0"/>
          </a:p>
        </p:txBody>
      </p:sp>
      <p:sp>
        <p:nvSpPr>
          <p:cNvPr id="72" name="Rectangle 71"/>
          <p:cNvSpPr/>
          <p:nvPr/>
        </p:nvSpPr>
        <p:spPr>
          <a:xfrm>
            <a:off x="7564432" y="4327167"/>
            <a:ext cx="4475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33) 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16309183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1</TotalTime>
  <Words>361</Words>
  <Application>Microsoft Macintosh PowerPoint</Application>
  <PresentationFormat>On-screen Show (4:3)</PresentationFormat>
  <Paragraphs>88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mbria</vt:lpstr>
      <vt:lpstr>Office Theme</vt:lpstr>
      <vt:lpstr>CS ChemDraw Drawing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merick G. Eudes</dc:creator>
  <cp:lastModifiedBy>Dominique Loque</cp:lastModifiedBy>
  <cp:revision>105</cp:revision>
  <cp:lastPrinted>2016-11-28T17:49:29Z</cp:lastPrinted>
  <dcterms:created xsi:type="dcterms:W3CDTF">2016-10-09T23:05:34Z</dcterms:created>
  <dcterms:modified xsi:type="dcterms:W3CDTF">2017-05-22T07:00:12Z</dcterms:modified>
</cp:coreProperties>
</file>